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8.png" ContentType="image/png"/>
  <Override PartName="/ppt/media/image46.jpeg" ContentType="image/jpeg"/>
  <Override PartName="/ppt/media/image57.png" ContentType="image/png"/>
  <Override PartName="/ppt/media/image56.png" ContentType="image/png"/>
  <Override PartName="/ppt/media/image53.png" ContentType="image/png"/>
  <Override PartName="/ppt/media/image51.png" ContentType="image/png"/>
  <Override PartName="/ppt/media/image52.png" ContentType="image/png"/>
  <Override PartName="/ppt/media/image50.jpeg" ContentType="image/jpeg"/>
  <Override PartName="/ppt/media/image49.jpeg" ContentType="image/jpeg"/>
  <Override PartName="/ppt/media/image44.png" ContentType="image/png"/>
  <Override PartName="/ppt/media/image42.png" ContentType="image/png"/>
  <Override PartName="/ppt/media/image54.png" ContentType="image/png"/>
  <Override PartName="/ppt/media/image41.jpeg" ContentType="image/jpe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55.png" ContentType="image/png"/>
  <Override PartName="/ppt/media/image20.jpeg" ContentType="image/jpeg"/>
  <Override PartName="/ppt/media/image45.jpeg" ContentType="image/jpeg"/>
  <Override PartName="/ppt/media/image48.png" ContentType="image/png"/>
  <Override PartName="/ppt/media/image70.wmf" ContentType="image/x-wmf"/>
  <Override PartName="/ppt/media/image16.wmf" ContentType="image/x-wmf"/>
  <Override PartName="/ppt/media/image5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84.png" ContentType="image/png"/>
  <Override PartName="/ppt/media/image11.png" ContentType="image/png"/>
  <Override PartName="/ppt/media/image36.png" ContentType="image/png"/>
  <Override PartName="/ppt/media/image31.png" ContentType="image/png"/>
  <Override PartName="/ppt/media/image68.png" ContentType="image/png"/>
  <Override PartName="/ppt/media/image18.jpeg" ContentType="image/jpeg"/>
  <Override PartName="/ppt/media/image60.png" ContentType="image/png"/>
  <Override PartName="/ppt/media/image21.wmf" ContentType="image/x-wmf"/>
  <Override PartName="/ppt/media/image64.png" ContentType="image/png"/>
  <Override PartName="/ppt/media/image22.png" ContentType="image/png"/>
  <Override PartName="/ppt/media/image62.png" ContentType="image/png"/>
  <Override PartName="/ppt/media/image63.png" ContentType="image/png"/>
  <Override PartName="/ppt/media/image65.png" ContentType="image/png"/>
  <Override PartName="/ppt/media/image66.wmf" ContentType="image/x-wmf"/>
  <Override PartName="/ppt/media/image67.wmf" ContentType="image/x-wmf"/>
  <Override PartName="/ppt/media/image73.jpeg" ContentType="image/jpeg"/>
  <Override PartName="/ppt/media/image24.png" ContentType="image/png"/>
  <Override PartName="/ppt/media/image61.png" ContentType="image/png"/>
  <Override PartName="/ppt/media/image96.png" ContentType="image/png"/>
  <Override PartName="/ppt/media/image23.png" ContentType="image/png"/>
  <Override PartName="/ppt/media/image95.png" ContentType="image/png"/>
  <Override PartName="/ppt/media/image71.png" ContentType="image/png"/>
  <Override PartName="/ppt/media/image69.wmf" ContentType="image/x-wmf"/>
  <Override PartName="/ppt/media/image94.png" ContentType="image/png"/>
  <Override PartName="/ppt/media/image29.png" ContentType="image/png"/>
  <Override PartName="/ppt/media/image89.png" ContentType="image/png"/>
  <Override PartName="/ppt/media/image88.wmf" ContentType="image/x-wmf"/>
  <Override PartName="/ppt/media/image77.png" ContentType="image/png"/>
  <Override PartName="/ppt/media/image87.wmf" ContentType="image/x-wmf"/>
  <Override PartName="/ppt/media/image10.png" ContentType="image/png"/>
  <Override PartName="/ppt/media/image47.png" ContentType="image/png"/>
  <Override PartName="/ppt/media/image76.png" ContentType="image/png"/>
  <Override PartName="/ppt/media/image79.png" ContentType="image/png"/>
  <Override PartName="/ppt/media/image78.png" ContentType="image/png"/>
  <Override PartName="/ppt/media/image75.png" ContentType="image/png"/>
  <Override PartName="/ppt/media/image74.png" ContentType="image/png"/>
  <Override PartName="/ppt/media/image90.png" ContentType="image/png"/>
  <Override PartName="/ppt/media/image25.png" ContentType="image/png"/>
  <Override PartName="/ppt/media/image19.jpeg" ContentType="image/jpeg"/>
  <Override PartName="/ppt/media/image72.jpeg" ContentType="image/jpeg"/>
  <Override PartName="/ppt/media/image14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91.png" ContentType="image/png"/>
  <Override PartName="/ppt/media/image15.png" ContentType="image/png"/>
  <Override PartName="/ppt/media/image80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92.png" ContentType="image/png"/>
  <Override PartName="/ppt/media/image81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82.png" ContentType="image/png"/>
  <Override PartName="/ppt/media/image5.png" ContentType="image/png"/>
  <Override PartName="/ppt/media/image35.png" ContentType="image/png"/>
  <Override PartName="/ppt/media/image93.png" ContentType="image/png"/>
  <Override PartName="/ppt/media/image43.jpeg" ContentType="image/jpeg"/>
  <Override PartName="/ppt/media/image28.png" ContentType="image/png"/>
  <Override PartName="/ppt/media/image6.png" ContentType="image/png"/>
  <Override PartName="/ppt/media/image83.png" ContentType="image/png"/>
  <Override PartName="/ppt/embeddings/oleObject1.bin" ContentType="application/vnd.openxmlformats-officedocument.oleObject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6858000" cy="9144000"/>
  <p:notesSz cx="7077075" cy="9363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0A6B0-FB78-4393-8C35-A310E90B00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D95D3-9DAF-40BA-AA3F-07646B2D60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4D032-09CC-417A-938D-894592FB1A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89392-5890-4407-925D-6F6CA7DF04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2D552-B5C0-4FC5-99D8-17AE4D4729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8D44F-B150-42C6-9662-D853806EBC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FDE06E-C50D-4FE2-9D54-3CB1531B20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E3905-090F-4B78-8F5D-64D45B11DD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84FEC-E909-4110-8592-B1E5DF9C15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397D5-C91E-4004-8B13-D5D5D6DA3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1358E-386E-4FE6-97A3-66B9A46D9C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6DEC7-FADA-4206-BFD8-38B72CD64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9A0399-339B-4527-92BC-2B859C52FCB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9.png"/><Relationship Id="rId2" Type="http://schemas.openxmlformats.org/officeDocument/2006/relationships/image" Target="../media/image90.png"/><Relationship Id="rId3" Type="http://schemas.openxmlformats.org/officeDocument/2006/relationships/image" Target="../media/image91.png"/><Relationship Id="rId4" Type="http://schemas.openxmlformats.org/officeDocument/2006/relationships/image" Target="../media/image92.png"/><Relationship Id="rId5" Type="http://schemas.openxmlformats.org/officeDocument/2006/relationships/image" Target="../media/image93.png"/><Relationship Id="rId6" Type="http://schemas.openxmlformats.org/officeDocument/2006/relationships/image" Target="../media/image90.png"/><Relationship Id="rId7" Type="http://schemas.openxmlformats.org/officeDocument/2006/relationships/image" Target="../media/image94.png"/><Relationship Id="rId8" Type="http://schemas.openxmlformats.org/officeDocument/2006/relationships/image" Target="../media/image92.png"/><Relationship Id="rId9" Type="http://schemas.openxmlformats.org/officeDocument/2006/relationships/image" Target="../media/image95.png"/><Relationship Id="rId10" Type="http://schemas.openxmlformats.org/officeDocument/2006/relationships/image" Target="../media/image90.png"/><Relationship Id="rId11" Type="http://schemas.openxmlformats.org/officeDocument/2006/relationships/image" Target="../media/image91.png"/><Relationship Id="rId12" Type="http://schemas.openxmlformats.org/officeDocument/2006/relationships/image" Target="../media/image91.png"/><Relationship Id="rId1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6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image" Target="../media/image14.png"/><Relationship Id="rId12" Type="http://schemas.openxmlformats.org/officeDocument/2006/relationships/image" Target="../media/image15.png"/><Relationship Id="rId13" Type="http://schemas.openxmlformats.org/officeDocument/2006/relationships/oleObject" Target="../embeddings/oleObject1.bin"/><Relationship Id="rId14" Type="http://schemas.openxmlformats.org/officeDocument/2006/relationships/image" Target="../media/image16.wmf"/><Relationship Id="rId15" Type="http://schemas.openxmlformats.org/officeDocument/2006/relationships/image" Target="../media/image17.png"/><Relationship Id="rId16" Type="http://schemas.openxmlformats.org/officeDocument/2006/relationships/image" Target="../media/image18.jpeg"/><Relationship Id="rId17" Type="http://schemas.openxmlformats.org/officeDocument/2006/relationships/image" Target="../media/image19.jpeg"/><Relationship Id="rId18" Type="http://schemas.openxmlformats.org/officeDocument/2006/relationships/image" Target="../media/image20.jpeg"/><Relationship Id="rId19" Type="http://schemas.openxmlformats.org/officeDocument/2006/relationships/image" Target="../media/image21.wmf"/><Relationship Id="rId20" Type="http://schemas.openxmlformats.org/officeDocument/2006/relationships/image" Target="../media/image21.wmf"/><Relationship Id="rId2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png"/><Relationship Id="rId7" Type="http://schemas.openxmlformats.org/officeDocument/2006/relationships/image" Target="../media/image28.png"/><Relationship Id="rId8" Type="http://schemas.openxmlformats.org/officeDocument/2006/relationships/image" Target="../media/image29.png"/><Relationship Id="rId9" Type="http://schemas.openxmlformats.org/officeDocument/2006/relationships/image" Target="../media/image30.png"/><Relationship Id="rId10" Type="http://schemas.openxmlformats.org/officeDocument/2006/relationships/image" Target="../media/image31.png"/><Relationship Id="rId11" Type="http://schemas.openxmlformats.org/officeDocument/2006/relationships/image" Target="../media/image32.png"/><Relationship Id="rId12" Type="http://schemas.openxmlformats.org/officeDocument/2006/relationships/image" Target="../media/image33.png"/><Relationship Id="rId13" Type="http://schemas.openxmlformats.org/officeDocument/2006/relationships/image" Target="../media/image34.png"/><Relationship Id="rId14" Type="http://schemas.openxmlformats.org/officeDocument/2006/relationships/image" Target="../media/image34.png"/><Relationship Id="rId15" Type="http://schemas.openxmlformats.org/officeDocument/2006/relationships/image" Target="../media/image34.png"/><Relationship Id="rId16" Type="http://schemas.openxmlformats.org/officeDocument/2006/relationships/image" Target="../media/image34.png"/><Relationship Id="rId17" Type="http://schemas.openxmlformats.org/officeDocument/2006/relationships/image" Target="../media/image34.png"/><Relationship Id="rId18" Type="http://schemas.openxmlformats.org/officeDocument/2006/relationships/image" Target="../media/image34.png"/><Relationship Id="rId19" Type="http://schemas.openxmlformats.org/officeDocument/2006/relationships/image" Target="../media/image35.png"/><Relationship Id="rId20" Type="http://schemas.openxmlformats.org/officeDocument/2006/relationships/image" Target="../media/image35.png"/><Relationship Id="rId21" Type="http://schemas.openxmlformats.org/officeDocument/2006/relationships/image" Target="../media/image35.png"/><Relationship Id="rId22" Type="http://schemas.openxmlformats.org/officeDocument/2006/relationships/image" Target="../media/image36.png"/><Relationship Id="rId23" Type="http://schemas.openxmlformats.org/officeDocument/2006/relationships/image" Target="../media/image37.png"/><Relationship Id="rId24" Type="http://schemas.openxmlformats.org/officeDocument/2006/relationships/image" Target="../media/image38.png"/><Relationship Id="rId25" Type="http://schemas.openxmlformats.org/officeDocument/2006/relationships/image" Target="../media/image38.png"/><Relationship Id="rId26" Type="http://schemas.openxmlformats.org/officeDocument/2006/relationships/image" Target="../media/image39.png"/><Relationship Id="rId27" Type="http://schemas.openxmlformats.org/officeDocument/2006/relationships/image" Target="../media/image36.png"/><Relationship Id="rId2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jpeg"/><Relationship Id="rId3" Type="http://schemas.openxmlformats.org/officeDocument/2006/relationships/image" Target="../media/image42.png"/><Relationship Id="rId4" Type="http://schemas.openxmlformats.org/officeDocument/2006/relationships/image" Target="../media/image43.jpeg"/><Relationship Id="rId5" Type="http://schemas.openxmlformats.org/officeDocument/2006/relationships/image" Target="../media/image44.png"/><Relationship Id="rId6" Type="http://schemas.openxmlformats.org/officeDocument/2006/relationships/image" Target="../media/image45.jpeg"/><Relationship Id="rId7" Type="http://schemas.openxmlformats.org/officeDocument/2006/relationships/image" Target="../media/image46.jpeg"/><Relationship Id="rId8" Type="http://schemas.openxmlformats.org/officeDocument/2006/relationships/image" Target="../media/image47.png"/><Relationship Id="rId9" Type="http://schemas.openxmlformats.org/officeDocument/2006/relationships/image" Target="../media/image48.png"/><Relationship Id="rId10" Type="http://schemas.openxmlformats.org/officeDocument/2006/relationships/image" Target="../media/image49.jpeg"/><Relationship Id="rId11" Type="http://schemas.openxmlformats.org/officeDocument/2006/relationships/image" Target="../media/image50.jpeg"/><Relationship Id="rId12" Type="http://schemas.openxmlformats.org/officeDocument/2006/relationships/image" Target="../media/image51.png"/><Relationship Id="rId13" Type="http://schemas.openxmlformats.org/officeDocument/2006/relationships/image" Target="../media/image52.png"/><Relationship Id="rId14" Type="http://schemas.openxmlformats.org/officeDocument/2006/relationships/package" Target="../embeddings/oleObject1.xlsx"/><Relationship Id="rId15" Type="http://schemas.openxmlformats.org/officeDocument/2006/relationships/image" Target="../media/image53.png"/><Relationship Id="rId16" Type="http://schemas.openxmlformats.org/officeDocument/2006/relationships/image" Target="../media/image54.png"/><Relationship Id="rId17" Type="http://schemas.openxmlformats.org/officeDocument/2006/relationships/image" Target="../media/image55.png"/><Relationship Id="rId18" Type="http://schemas.openxmlformats.org/officeDocument/2006/relationships/image" Target="../media/image56.png"/><Relationship Id="rId19" Type="http://schemas.openxmlformats.org/officeDocument/2006/relationships/image" Target="../media/image57.png"/><Relationship Id="rId20" Type="http://schemas.openxmlformats.org/officeDocument/2006/relationships/image" Target="../media/image58.png"/><Relationship Id="rId21" Type="http://schemas.openxmlformats.org/officeDocument/2006/relationships/image" Target="../media/image59.png"/><Relationship Id="rId22" Type="http://schemas.openxmlformats.org/officeDocument/2006/relationships/image" Target="../media/image60.png"/><Relationship Id="rId23" Type="http://schemas.openxmlformats.org/officeDocument/2006/relationships/image" Target="../media/image61.png"/><Relationship Id="rId24" Type="http://schemas.openxmlformats.org/officeDocument/2006/relationships/package" Target="../embeddings/oleObject2.xlsx"/><Relationship Id="rId25" Type="http://schemas.openxmlformats.org/officeDocument/2006/relationships/image" Target="../media/image62.png"/><Relationship Id="rId26" Type="http://schemas.openxmlformats.org/officeDocument/2006/relationships/image" Target="../media/image63.png"/><Relationship Id="rId27" Type="http://schemas.openxmlformats.org/officeDocument/2006/relationships/image" Target="../media/image64.png"/><Relationship Id="rId2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66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67.wmf"/><Relationship Id="rId6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8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69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70.wmf"/><Relationship Id="rId6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2.jpeg"/><Relationship Id="rId2" Type="http://schemas.openxmlformats.org/officeDocument/2006/relationships/image" Target="../media/image73.jpe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4.png"/><Relationship Id="rId2" Type="http://schemas.openxmlformats.org/officeDocument/2006/relationships/image" Target="../media/image75.png"/><Relationship Id="rId3" Type="http://schemas.openxmlformats.org/officeDocument/2006/relationships/image" Target="../media/image76.png"/><Relationship Id="rId4" Type="http://schemas.openxmlformats.org/officeDocument/2006/relationships/image" Target="../media/image77.png"/><Relationship Id="rId5" Type="http://schemas.openxmlformats.org/officeDocument/2006/relationships/image" Target="../media/image78.png"/><Relationship Id="rId6" Type="http://schemas.openxmlformats.org/officeDocument/2006/relationships/image" Target="../media/image79.png"/><Relationship Id="rId7" Type="http://schemas.openxmlformats.org/officeDocument/2006/relationships/image" Target="../media/image80.png"/><Relationship Id="rId8" Type="http://schemas.openxmlformats.org/officeDocument/2006/relationships/image" Target="../media/image81.png"/><Relationship Id="rId9" Type="http://schemas.openxmlformats.org/officeDocument/2006/relationships/image" Target="../media/image82.png"/><Relationship Id="rId10" Type="http://schemas.openxmlformats.org/officeDocument/2006/relationships/image" Target="../media/image83.png"/><Relationship Id="rId11" Type="http://schemas.openxmlformats.org/officeDocument/2006/relationships/image" Target="../media/image84.png"/><Relationship Id="rId12" Type="http://schemas.openxmlformats.org/officeDocument/2006/relationships/image" Target="../media/image85.png"/><Relationship Id="rId13" Type="http://schemas.openxmlformats.org/officeDocument/2006/relationships/image" Target="../media/image86.png"/><Relationship Id="rId14" Type="http://schemas.openxmlformats.org/officeDocument/2006/relationships/oleObject" Target="../embeddings/oleObject1.bin"/><Relationship Id="rId15" Type="http://schemas.openxmlformats.org/officeDocument/2006/relationships/image" Target="../media/image87.wmf"/><Relationship Id="rId16" Type="http://schemas.openxmlformats.org/officeDocument/2006/relationships/oleObject" Target="../embeddings/oleObject2.bin"/><Relationship Id="rId17" Type="http://schemas.openxmlformats.org/officeDocument/2006/relationships/image" Target="../media/image88.wmf"/><Relationship Id="rId18" Type="http://schemas.openxmlformats.org/officeDocument/2006/relationships/image" Target="../media/image85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oup 9" descr=""/>
          <p:cNvPicPr/>
          <p:nvPr/>
        </p:nvPicPr>
        <p:blipFill>
          <a:blip r:embed="rId1"/>
          <a:stretch/>
        </p:blipFill>
        <p:spPr>
          <a:xfrm>
            <a:off x="1773360" y="4979880"/>
            <a:ext cx="3921120" cy="2524320"/>
          </a:xfrm>
          <a:prstGeom prst="rect">
            <a:avLst/>
          </a:prstGeom>
          <a:ln w="0">
            <a:noFill/>
          </a:ln>
        </p:spPr>
      </p:pic>
      <p:sp>
        <p:nvSpPr>
          <p:cNvPr id="42" name="TextBox 57"/>
          <p:cNvSpPr/>
          <p:nvPr/>
        </p:nvSpPr>
        <p:spPr>
          <a:xfrm>
            <a:off x="163440" y="352440"/>
            <a:ext cx="212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0"/>
          <p:cNvSpPr/>
          <p:nvPr/>
        </p:nvSpPr>
        <p:spPr>
          <a:xfrm>
            <a:off x="1550880" y="67644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0"/>
          <p:cNvSpPr/>
          <p:nvPr/>
        </p:nvSpPr>
        <p:spPr>
          <a:xfrm>
            <a:off x="1662120" y="482616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2"/>
          <p:cNvGrpSpPr/>
          <p:nvPr/>
        </p:nvGrpSpPr>
        <p:grpSpPr>
          <a:xfrm>
            <a:off x="1866960" y="757080"/>
            <a:ext cx="3806640" cy="1984680"/>
            <a:chOff x="1866960" y="757080"/>
            <a:chExt cx="3806640" cy="1984680"/>
          </a:xfrm>
        </p:grpSpPr>
        <p:pic>
          <p:nvPicPr>
            <p:cNvPr id="46" name="Picture 3" descr=""/>
            <p:cNvPicPr/>
            <p:nvPr/>
          </p:nvPicPr>
          <p:blipFill>
            <a:blip r:embed="rId2"/>
            <a:srcRect l="72489" t="4963" r="3196" b="62610"/>
            <a:stretch/>
          </p:blipFill>
          <p:spPr>
            <a:xfrm>
              <a:off x="1866960" y="757080"/>
              <a:ext cx="3460680" cy="198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1"/>
            <p:cNvSpPr/>
            <p:nvPr/>
          </p:nvSpPr>
          <p:spPr>
            <a:xfrm>
              <a:off x="4736880" y="1322280"/>
              <a:ext cx="93672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 W – 600 se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5"/>
            <p:cNvSpPr/>
            <p:nvPr/>
          </p:nvSpPr>
          <p:spPr>
            <a:xfrm>
              <a:off x="4736880" y="1467720"/>
              <a:ext cx="93672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 W – 300 se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6"/>
            <p:cNvSpPr/>
            <p:nvPr/>
          </p:nvSpPr>
          <p:spPr>
            <a:xfrm>
              <a:off x="4736880" y="1623240"/>
              <a:ext cx="87012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7 W – 86 se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9"/>
            <p:cNvSpPr/>
            <p:nvPr/>
          </p:nvSpPr>
          <p:spPr>
            <a:xfrm>
              <a:off x="4736880" y="1763640"/>
              <a:ext cx="87012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7 W – 43 se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0"/>
            <p:cNvSpPr/>
            <p:nvPr/>
          </p:nvSpPr>
          <p:spPr>
            <a:xfrm>
              <a:off x="4736880" y="1908720"/>
              <a:ext cx="93672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 W – 300 se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Box 50"/>
          <p:cNvSpPr/>
          <p:nvPr/>
        </p:nvSpPr>
        <p:spPr>
          <a:xfrm>
            <a:off x="1585800" y="266688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Group 9"/>
          <p:cNvGrpSpPr/>
          <p:nvPr/>
        </p:nvGrpSpPr>
        <p:grpSpPr>
          <a:xfrm>
            <a:off x="1757880" y="2747880"/>
            <a:ext cx="3277800" cy="2281320"/>
            <a:chOff x="1757880" y="2747880"/>
            <a:chExt cx="3277800" cy="2281320"/>
          </a:xfrm>
        </p:grpSpPr>
        <p:grpSp>
          <p:nvGrpSpPr>
            <p:cNvPr id="54" name="Group 3"/>
            <p:cNvGrpSpPr/>
            <p:nvPr/>
          </p:nvGrpSpPr>
          <p:grpSpPr>
            <a:xfrm>
              <a:off x="1757880" y="2747880"/>
              <a:ext cx="3277800" cy="2281320"/>
              <a:chOff x="1757880" y="2747880"/>
              <a:chExt cx="3277800" cy="2281320"/>
            </a:xfrm>
          </p:grpSpPr>
          <p:pic>
            <p:nvPicPr>
              <p:cNvPr id="55" name="Picture 1" descr=""/>
              <p:cNvPicPr/>
              <p:nvPr/>
            </p:nvPicPr>
            <p:blipFill>
              <a:blip r:embed="rId3"/>
              <a:srcRect l="78766" t="17408" r="12161" b="68000"/>
              <a:stretch/>
            </p:blipFill>
            <p:spPr>
              <a:xfrm>
                <a:off x="1757880" y="2747880"/>
                <a:ext cx="3277800" cy="2165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TextBox 22"/>
              <p:cNvSpPr/>
              <p:nvPr/>
            </p:nvSpPr>
            <p:spPr>
              <a:xfrm rot="18969000">
                <a:off x="2172960" y="453024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 W – 300 se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23"/>
              <p:cNvSpPr/>
              <p:nvPr/>
            </p:nvSpPr>
            <p:spPr>
              <a:xfrm rot="18969000">
                <a:off x="2642400" y="453024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 W – 300 se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Box 24"/>
              <p:cNvSpPr/>
              <p:nvPr/>
            </p:nvSpPr>
            <p:spPr>
              <a:xfrm rot="18969000">
                <a:off x="3097800" y="454248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 W – 600 se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Box 25"/>
              <p:cNvSpPr/>
              <p:nvPr/>
            </p:nvSpPr>
            <p:spPr>
              <a:xfrm rot="18969000">
                <a:off x="3553560" y="454248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 W – 86 se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Box 26"/>
              <p:cNvSpPr/>
              <p:nvPr/>
            </p:nvSpPr>
            <p:spPr>
              <a:xfrm rot="18969000">
                <a:off x="3970080" y="454896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7 W – 43 se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27"/>
              <p:cNvSpPr/>
              <p:nvPr/>
            </p:nvSpPr>
            <p:spPr>
              <a:xfrm rot="18969000">
                <a:off x="1717920" y="4533120"/>
                <a:ext cx="887400" cy="200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Untreated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Rectangle 5"/>
            <p:cNvSpPr/>
            <p:nvPr/>
          </p:nvSpPr>
          <p:spPr>
            <a:xfrm>
              <a:off x="2314440" y="3368520"/>
              <a:ext cx="304560" cy="855720"/>
            </a:xfrm>
            <a:prstGeom prst="rect">
              <a:avLst/>
            </a:prstGeom>
            <a:solidFill>
              <a:srgbClr val="d9d9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7"/>
            <p:cNvSpPr/>
            <p:nvPr/>
          </p:nvSpPr>
          <p:spPr>
            <a:xfrm>
              <a:off x="2215800" y="3803760"/>
              <a:ext cx="2679840" cy="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TextBox 57"/>
          <p:cNvSpPr/>
          <p:nvPr/>
        </p:nvSpPr>
        <p:spPr>
          <a:xfrm>
            <a:off x="165960" y="225360"/>
            <a:ext cx="28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continued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TextBox 2"/>
          <p:cNvSpPr/>
          <p:nvPr/>
        </p:nvSpPr>
        <p:spPr>
          <a:xfrm>
            <a:off x="641520" y="1103400"/>
            <a:ext cx="290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6B Complete Western blo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0" name="Picture 4" descr="EGT_PSMAD2 Blot 2 Grayscale700 inverted.tif"/>
          <p:cNvPicPr/>
          <p:nvPr/>
        </p:nvPicPr>
        <p:blipFill>
          <a:blip r:embed="rId1"/>
          <a:srcRect l="5985" t="12873" r="9444" b="7806"/>
          <a:stretch/>
        </p:blipFill>
        <p:spPr>
          <a:xfrm>
            <a:off x="544680" y="3168720"/>
            <a:ext cx="3093840" cy="2511360"/>
          </a:xfrm>
          <a:prstGeom prst="rect">
            <a:avLst/>
          </a:prstGeom>
          <a:ln w="0">
            <a:noFill/>
          </a:ln>
        </p:spPr>
      </p:pic>
      <p:pic>
        <p:nvPicPr>
          <p:cNvPr id="481" name="Picture 9" descr="EGT_Actin Blot 2 Grayscale700 inverted.tif"/>
          <p:cNvPicPr/>
          <p:nvPr/>
        </p:nvPicPr>
        <p:blipFill>
          <a:blip r:embed="rId2"/>
          <a:srcRect l="5822" t="19325" r="11043" b="10063"/>
          <a:stretch/>
        </p:blipFill>
        <p:spPr>
          <a:xfrm>
            <a:off x="549360" y="6386400"/>
            <a:ext cx="2781360" cy="2138400"/>
          </a:xfrm>
          <a:prstGeom prst="rect">
            <a:avLst/>
          </a:prstGeom>
          <a:ln w="0">
            <a:noFill/>
          </a:ln>
        </p:spPr>
      </p:pic>
      <p:pic>
        <p:nvPicPr>
          <p:cNvPr id="482" name="Picture 36" descr="2013-11-13_EGT MEFs Blot 3.TIF"/>
          <p:cNvPicPr/>
          <p:nvPr/>
        </p:nvPicPr>
        <p:blipFill>
          <a:blip r:embed="rId3"/>
          <a:srcRect l="10323" t="1226" r="-4475" b="129"/>
          <a:stretch/>
        </p:blipFill>
        <p:spPr>
          <a:xfrm>
            <a:off x="3786120" y="3171960"/>
            <a:ext cx="2943360" cy="2311200"/>
          </a:xfrm>
          <a:prstGeom prst="rect">
            <a:avLst/>
          </a:prstGeom>
          <a:ln w="0">
            <a:noFill/>
          </a:ln>
        </p:spPr>
      </p:pic>
      <p:pic>
        <p:nvPicPr>
          <p:cNvPr id="483" name="Picture 37" descr="EGT MEFS BLOT 3 Actin Grayscale700.TIF"/>
          <p:cNvPicPr/>
          <p:nvPr/>
        </p:nvPicPr>
        <p:blipFill>
          <a:blip r:embed="rId4"/>
          <a:srcRect l="18522" t="24296" r="4789" b="8401"/>
          <a:stretch/>
        </p:blipFill>
        <p:spPr>
          <a:xfrm>
            <a:off x="3678120" y="6384960"/>
            <a:ext cx="2781360" cy="2139840"/>
          </a:xfrm>
          <a:prstGeom prst="rect">
            <a:avLst/>
          </a:prstGeom>
          <a:ln w="0">
            <a:noFill/>
          </a:ln>
        </p:spPr>
      </p:pic>
      <p:sp>
        <p:nvSpPr>
          <p:cNvPr id="484" name="TextBox 26"/>
          <p:cNvSpPr/>
          <p:nvPr/>
        </p:nvSpPr>
        <p:spPr>
          <a:xfrm>
            <a:off x="2565360" y="1604880"/>
            <a:ext cx="600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F-β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TextBox 34"/>
          <p:cNvSpPr/>
          <p:nvPr/>
        </p:nvSpPr>
        <p:spPr>
          <a:xfrm rot="16200000">
            <a:off x="1184400" y="1846440"/>
            <a:ext cx="558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-Smad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TextBox 35"/>
          <p:cNvSpPr/>
          <p:nvPr/>
        </p:nvSpPr>
        <p:spPr>
          <a:xfrm rot="16200000">
            <a:off x="1217880" y="2256120"/>
            <a:ext cx="482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β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7" name="Picture 4" descr="EGT_PSMAD2 Blot 2 Grayscale700 inverted.tif"/>
          <p:cNvPicPr/>
          <p:nvPr/>
        </p:nvPicPr>
        <p:blipFill>
          <a:blip r:embed="rId5"/>
          <a:srcRect l="14339" t="36094" r="70093" b="56446"/>
          <a:stretch/>
        </p:blipFill>
        <p:spPr>
          <a:xfrm>
            <a:off x="1533600" y="1801800"/>
            <a:ext cx="1028520" cy="326880"/>
          </a:xfrm>
          <a:prstGeom prst="rect">
            <a:avLst/>
          </a:prstGeom>
          <a:ln w="9360">
            <a:solidFill>
              <a:srgbClr val="ff0000"/>
            </a:solidFill>
            <a:miter/>
          </a:ln>
        </p:spPr>
      </p:pic>
      <p:pic>
        <p:nvPicPr>
          <p:cNvPr id="488" name="Picture 9" descr="EGT_Actin Blot 2 Grayscale700 inverted.tif"/>
          <p:cNvPicPr/>
          <p:nvPr/>
        </p:nvPicPr>
        <p:blipFill>
          <a:blip r:embed="rId6"/>
          <a:srcRect l="11317" t="51724" r="73451" b="42425"/>
          <a:stretch/>
        </p:blipFill>
        <p:spPr>
          <a:xfrm>
            <a:off x="1533600" y="2190600"/>
            <a:ext cx="1033560" cy="327240"/>
          </a:xfrm>
          <a:prstGeom prst="rect">
            <a:avLst/>
          </a:prstGeom>
          <a:ln w="9360">
            <a:solidFill>
              <a:srgbClr val="ff0000"/>
            </a:solidFill>
            <a:miter/>
          </a:ln>
        </p:spPr>
      </p:pic>
      <p:pic>
        <p:nvPicPr>
          <p:cNvPr id="489" name="Picture 22" descr="EGT_PSMAD2 Blot 2 Grayscale700 inverted.tif"/>
          <p:cNvPicPr/>
          <p:nvPr/>
        </p:nvPicPr>
        <p:blipFill>
          <a:blip r:embed="rId7"/>
          <a:srcRect l="36440" t="36199" r="55995" b="57522"/>
          <a:stretch/>
        </p:blipFill>
        <p:spPr>
          <a:xfrm>
            <a:off x="2622600" y="1801800"/>
            <a:ext cx="468360" cy="326880"/>
          </a:xfrm>
          <a:prstGeom prst="rect">
            <a:avLst/>
          </a:prstGeom>
          <a:ln w="9360">
            <a:solidFill>
              <a:srgbClr val="ff0000"/>
            </a:solidFill>
            <a:miter/>
          </a:ln>
        </p:spPr>
      </p:pic>
      <p:sp>
        <p:nvSpPr>
          <p:cNvPr id="490" name="TextBox 17"/>
          <p:cNvSpPr/>
          <p:nvPr/>
        </p:nvSpPr>
        <p:spPr>
          <a:xfrm>
            <a:off x="1855800" y="1433520"/>
            <a:ext cx="117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EF WT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 L1</a:t>
            </a:r>
            <a:r>
              <a:rPr b="1" lang="el-GR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β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1/L1</a:t>
            </a:r>
            <a:r>
              <a:rPr b="1" lang="el-GR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β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Straight Connector 18"/>
          <p:cNvSpPr/>
          <p:nvPr/>
        </p:nvSpPr>
        <p:spPr>
          <a:xfrm flipV="1">
            <a:off x="1550880" y="1626840"/>
            <a:ext cx="1538280" cy="324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TextBox 31"/>
          <p:cNvSpPr/>
          <p:nvPr/>
        </p:nvSpPr>
        <p:spPr>
          <a:xfrm>
            <a:off x="1550880" y="1604880"/>
            <a:ext cx="544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TextBox 32"/>
          <p:cNvSpPr/>
          <p:nvPr/>
        </p:nvSpPr>
        <p:spPr>
          <a:xfrm>
            <a:off x="2017800" y="1604880"/>
            <a:ext cx="598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B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TextBox 17"/>
          <p:cNvSpPr/>
          <p:nvPr/>
        </p:nvSpPr>
        <p:spPr>
          <a:xfrm>
            <a:off x="3602160" y="1433520"/>
            <a:ext cx="108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EF KI 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L1</a:t>
            </a:r>
            <a:r>
              <a:rPr b="1" lang="el-GR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β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3/L1</a:t>
            </a:r>
            <a:r>
              <a:rPr b="1" lang="el-GR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β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5" name="Picture 37" descr="EGT MEFS BLOT 3 Actin Grayscale700.TIF"/>
          <p:cNvPicPr/>
          <p:nvPr/>
        </p:nvPicPr>
        <p:blipFill>
          <a:blip r:embed="rId8"/>
          <a:srcRect l="25901" t="56278" r="59208" b="38385"/>
          <a:stretch/>
        </p:blipFill>
        <p:spPr>
          <a:xfrm>
            <a:off x="3222720" y="2187720"/>
            <a:ext cx="1033200" cy="330120"/>
          </a:xfrm>
          <a:prstGeom prst="rect">
            <a:avLst/>
          </a:prstGeom>
          <a:ln w="9360">
            <a:solidFill>
              <a:srgbClr val="00b050"/>
            </a:solidFill>
            <a:miter/>
          </a:ln>
        </p:spPr>
      </p:pic>
      <p:pic>
        <p:nvPicPr>
          <p:cNvPr id="496" name="Picture 39" descr="EGT MEFS BLOT 3 Actin Grayscale700.TIF"/>
          <p:cNvPicPr/>
          <p:nvPr/>
        </p:nvPicPr>
        <p:blipFill>
          <a:blip r:embed="rId9"/>
          <a:srcRect l="54453" t="55673" r="38193" b="37607"/>
          <a:stretch/>
        </p:blipFill>
        <p:spPr>
          <a:xfrm>
            <a:off x="4313160" y="2187720"/>
            <a:ext cx="466920" cy="330120"/>
          </a:xfrm>
          <a:prstGeom prst="rect">
            <a:avLst/>
          </a:prstGeom>
          <a:ln w="9360">
            <a:solidFill>
              <a:srgbClr val="00b050"/>
            </a:solidFill>
            <a:miter/>
          </a:ln>
        </p:spPr>
      </p:pic>
      <p:pic>
        <p:nvPicPr>
          <p:cNvPr id="497" name="Picture 23" descr="EGT_Actin Blot 2 Grayscale700 inverted.tif"/>
          <p:cNvPicPr/>
          <p:nvPr/>
        </p:nvPicPr>
        <p:blipFill>
          <a:blip r:embed="rId10"/>
          <a:srcRect l="33543" t="51052" r="58891" b="42252"/>
          <a:stretch/>
        </p:blipFill>
        <p:spPr>
          <a:xfrm>
            <a:off x="2619360" y="2187720"/>
            <a:ext cx="469800" cy="330120"/>
          </a:xfrm>
          <a:prstGeom prst="rect">
            <a:avLst/>
          </a:prstGeom>
          <a:ln w="9360">
            <a:solidFill>
              <a:srgbClr val="ff0000"/>
            </a:solidFill>
            <a:miter/>
          </a:ln>
        </p:spPr>
      </p:pic>
      <p:sp>
        <p:nvSpPr>
          <p:cNvPr id="498" name="Straight Connector 27"/>
          <p:cNvSpPr/>
          <p:nvPr/>
        </p:nvSpPr>
        <p:spPr>
          <a:xfrm>
            <a:off x="2590920" y="1571760"/>
            <a:ext cx="0" cy="107784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TextBox 31"/>
          <p:cNvSpPr/>
          <p:nvPr/>
        </p:nvSpPr>
        <p:spPr>
          <a:xfrm>
            <a:off x="3232080" y="1604880"/>
            <a:ext cx="585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TextBox 32"/>
          <p:cNvSpPr/>
          <p:nvPr/>
        </p:nvSpPr>
        <p:spPr>
          <a:xfrm>
            <a:off x="3683160" y="1604880"/>
            <a:ext cx="598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B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TextBox 26"/>
          <p:cNvSpPr/>
          <p:nvPr/>
        </p:nvSpPr>
        <p:spPr>
          <a:xfrm>
            <a:off x="4273560" y="1604880"/>
            <a:ext cx="600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F-β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Rectangle 31"/>
          <p:cNvSpPr/>
          <p:nvPr/>
        </p:nvSpPr>
        <p:spPr>
          <a:xfrm>
            <a:off x="863640" y="3905280"/>
            <a:ext cx="533520" cy="3078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Rectangle 32"/>
          <p:cNvSpPr/>
          <p:nvPr/>
        </p:nvSpPr>
        <p:spPr>
          <a:xfrm>
            <a:off x="716040" y="7315200"/>
            <a:ext cx="533160" cy="3096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Rectangle 33"/>
          <p:cNvSpPr/>
          <p:nvPr/>
        </p:nvSpPr>
        <p:spPr>
          <a:xfrm>
            <a:off x="1638360" y="3905280"/>
            <a:ext cx="304920" cy="3078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Rectangle 34"/>
          <p:cNvSpPr/>
          <p:nvPr/>
        </p:nvSpPr>
        <p:spPr>
          <a:xfrm>
            <a:off x="1459080" y="7332840"/>
            <a:ext cx="304560" cy="3078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Rectangle 35"/>
          <p:cNvSpPr/>
          <p:nvPr/>
        </p:nvSpPr>
        <p:spPr>
          <a:xfrm>
            <a:off x="4127400" y="4303800"/>
            <a:ext cx="533520" cy="307800"/>
          </a:xfrm>
          <a:prstGeom prst="rect">
            <a:avLst/>
          </a:prstGeom>
          <a:noFill/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Rectangle 36"/>
          <p:cNvSpPr/>
          <p:nvPr/>
        </p:nvSpPr>
        <p:spPr>
          <a:xfrm>
            <a:off x="3944880" y="7308720"/>
            <a:ext cx="533520" cy="308160"/>
          </a:xfrm>
          <a:prstGeom prst="rect">
            <a:avLst/>
          </a:prstGeom>
          <a:noFill/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Rectangle 37"/>
          <p:cNvSpPr/>
          <p:nvPr/>
        </p:nvSpPr>
        <p:spPr>
          <a:xfrm>
            <a:off x="5175360" y="4303800"/>
            <a:ext cx="304560" cy="307800"/>
          </a:xfrm>
          <a:prstGeom prst="rect">
            <a:avLst/>
          </a:prstGeom>
          <a:noFill/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Rectangle 38"/>
          <p:cNvSpPr/>
          <p:nvPr/>
        </p:nvSpPr>
        <p:spPr>
          <a:xfrm>
            <a:off x="4952880" y="7332840"/>
            <a:ext cx="304920" cy="307800"/>
          </a:xfrm>
          <a:prstGeom prst="rect">
            <a:avLst/>
          </a:prstGeom>
          <a:noFill/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0" name="Picture 36" descr="2013-11-13_EGT MEFs Blot 3.TIF"/>
          <p:cNvPicPr/>
          <p:nvPr/>
        </p:nvPicPr>
        <p:blipFill>
          <a:blip r:embed="rId11"/>
          <a:srcRect l="22220" t="51112" r="60552" b="40121"/>
          <a:stretch/>
        </p:blipFill>
        <p:spPr>
          <a:xfrm>
            <a:off x="3220920" y="1801800"/>
            <a:ext cx="1033560" cy="330120"/>
          </a:xfrm>
          <a:prstGeom prst="rect">
            <a:avLst/>
          </a:prstGeom>
          <a:ln w="9360">
            <a:solidFill>
              <a:srgbClr val="00b050"/>
            </a:solidFill>
            <a:miter/>
          </a:ln>
        </p:spPr>
      </p:pic>
      <p:pic>
        <p:nvPicPr>
          <p:cNvPr id="511" name="Picture 36" descr="2013-11-13_EGT MEFs Blot 3.TIF"/>
          <p:cNvPicPr/>
          <p:nvPr/>
        </p:nvPicPr>
        <p:blipFill>
          <a:blip r:embed="rId12"/>
          <a:srcRect l="54840" t="51112" r="35508" b="39246"/>
          <a:stretch/>
        </p:blipFill>
        <p:spPr>
          <a:xfrm>
            <a:off x="4314960" y="1801800"/>
            <a:ext cx="466560" cy="328680"/>
          </a:xfrm>
          <a:prstGeom prst="rect">
            <a:avLst/>
          </a:prstGeom>
          <a:ln w="9360">
            <a:solidFill>
              <a:srgbClr val="00b050"/>
            </a:solidFill>
            <a:miter/>
          </a:ln>
        </p:spPr>
      </p:pic>
      <p:sp>
        <p:nvSpPr>
          <p:cNvPr id="512" name="Straight Connector 45"/>
          <p:cNvSpPr/>
          <p:nvPr/>
        </p:nvSpPr>
        <p:spPr>
          <a:xfrm flipV="1">
            <a:off x="3236760" y="1626840"/>
            <a:ext cx="1538280" cy="468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Straight Connector 46"/>
          <p:cNvSpPr/>
          <p:nvPr/>
        </p:nvSpPr>
        <p:spPr>
          <a:xfrm>
            <a:off x="4282920" y="1571760"/>
            <a:ext cx="0" cy="107928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TextBox 17"/>
          <p:cNvSpPr/>
          <p:nvPr/>
        </p:nvSpPr>
        <p:spPr>
          <a:xfrm>
            <a:off x="402840" y="10936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TextBox 48"/>
          <p:cNvSpPr/>
          <p:nvPr/>
        </p:nvSpPr>
        <p:spPr>
          <a:xfrm>
            <a:off x="3089160" y="8478720"/>
            <a:ext cx="138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TextBox 49"/>
          <p:cNvSpPr/>
          <p:nvPr/>
        </p:nvSpPr>
        <p:spPr>
          <a:xfrm>
            <a:off x="2577960" y="5411880"/>
            <a:ext cx="204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hospho Smad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TextBox 57"/>
          <p:cNvSpPr/>
          <p:nvPr/>
        </p:nvSpPr>
        <p:spPr>
          <a:xfrm>
            <a:off x="128520" y="225360"/>
            <a:ext cx="200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Rectangle: Rounded Corners 3"/>
          <p:cNvSpPr/>
          <p:nvPr/>
        </p:nvSpPr>
        <p:spPr>
          <a:xfrm>
            <a:off x="1665360" y="2563920"/>
            <a:ext cx="1049400" cy="1951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Epitheliu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Oval 4"/>
          <p:cNvSpPr/>
          <p:nvPr/>
        </p:nvSpPr>
        <p:spPr>
          <a:xfrm>
            <a:off x="2097000" y="1544760"/>
            <a:ext cx="865440" cy="284040"/>
          </a:xfrm>
          <a:prstGeom prst="ellipse">
            <a:avLst/>
          </a:prstGeom>
          <a:solidFill>
            <a:srgbClr val="c6d9f1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F-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Oval 5"/>
          <p:cNvSpPr/>
          <p:nvPr/>
        </p:nvSpPr>
        <p:spPr>
          <a:xfrm>
            <a:off x="4537080" y="1501920"/>
            <a:ext cx="1417680" cy="282600"/>
          </a:xfrm>
          <a:prstGeom prst="ellipse">
            <a:avLst/>
          </a:prstGeom>
          <a:solidFill>
            <a:srgbClr val="ebf1de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on-TGF-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: Rounded Corners 6"/>
          <p:cNvSpPr/>
          <p:nvPr/>
        </p:nvSpPr>
        <p:spPr>
          <a:xfrm>
            <a:off x="3371760" y="2563920"/>
            <a:ext cx="1049400" cy="1951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broblas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Rectangle: Rounded Corners 7"/>
          <p:cNvSpPr/>
          <p:nvPr/>
        </p:nvSpPr>
        <p:spPr>
          <a:xfrm>
            <a:off x="5045040" y="2560680"/>
            <a:ext cx="1166760" cy="1951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acropha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TextBox 8"/>
          <p:cNvSpPr/>
          <p:nvPr/>
        </p:nvSpPr>
        <p:spPr>
          <a:xfrm>
            <a:off x="2614680" y="615960"/>
            <a:ext cx="2430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hotobiomodulation Therap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4" name="Straight Arrow Connector 11"/>
          <p:cNvCxnSpPr>
            <a:stCxn id="523" idx="2"/>
          </p:cNvCxnSpPr>
          <p:nvPr/>
        </p:nvCxnSpPr>
        <p:spPr>
          <a:xfrm flipH="1">
            <a:off x="2540880" y="1139400"/>
            <a:ext cx="1289880" cy="36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5" name="Straight Arrow Connector 15"/>
          <p:cNvCxnSpPr>
            <a:stCxn id="523" idx="2"/>
          </p:cNvCxnSpPr>
          <p:nvPr/>
        </p:nvCxnSpPr>
        <p:spPr>
          <a:xfrm>
            <a:off x="3830400" y="1139400"/>
            <a:ext cx="1462680" cy="322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6" name="Straight Arrow Connector 20"/>
          <p:cNvCxnSpPr/>
          <p:nvPr/>
        </p:nvCxnSpPr>
        <p:spPr>
          <a:xfrm flipH="1">
            <a:off x="2434680" y="1828440"/>
            <a:ext cx="92520" cy="726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27" name="Rectangle: Rounded Corners 18"/>
          <p:cNvSpPr/>
          <p:nvPr/>
        </p:nvSpPr>
        <p:spPr>
          <a:xfrm>
            <a:off x="3316320" y="1951200"/>
            <a:ext cx="1198440" cy="195120"/>
          </a:xfrm>
          <a:prstGeom prst="roundRect">
            <a:avLst>
              <a:gd name="adj" fmla="val 16667"/>
            </a:avLst>
          </a:prstGeom>
          <a:solidFill>
            <a:srgbClr val="f2dcdb"/>
          </a:solidFill>
          <a:ln w="2556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nflamm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8" name="Straight Arrow Connector 23"/>
          <p:cNvCxnSpPr/>
          <p:nvPr/>
        </p:nvCxnSpPr>
        <p:spPr>
          <a:xfrm>
            <a:off x="2525400" y="1838160"/>
            <a:ext cx="1305720" cy="705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9" name="Straight Arrow Connector 24"/>
          <p:cNvCxnSpPr>
            <a:stCxn id="520" idx="4"/>
          </p:cNvCxnSpPr>
          <p:nvPr/>
        </p:nvCxnSpPr>
        <p:spPr>
          <a:xfrm>
            <a:off x="5246640" y="1784160"/>
            <a:ext cx="451440" cy="7513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0" name="Straight Arrow Connector 27"/>
          <p:cNvCxnSpPr/>
          <p:nvPr/>
        </p:nvCxnSpPr>
        <p:spPr>
          <a:xfrm>
            <a:off x="2974680" y="1671480"/>
            <a:ext cx="911880" cy="224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1" name="Straight Arrow Connector 32"/>
          <p:cNvCxnSpPr>
            <a:stCxn id="520" idx="2"/>
          </p:cNvCxnSpPr>
          <p:nvPr/>
        </p:nvCxnSpPr>
        <p:spPr>
          <a:xfrm flipH="1">
            <a:off x="3908160" y="1642680"/>
            <a:ext cx="629280" cy="253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532" name="Table 94" descr=""/>
          <p:cNvPicPr/>
          <p:nvPr/>
        </p:nvPicPr>
        <p:blipFill>
          <a:blip r:embed="rId1"/>
          <a:stretch/>
        </p:blipFill>
        <p:spPr>
          <a:xfrm>
            <a:off x="676440" y="2840040"/>
            <a:ext cx="5906880" cy="1933560"/>
          </a:xfrm>
          <a:prstGeom prst="rect">
            <a:avLst/>
          </a:prstGeom>
          <a:ln w="0">
            <a:noFill/>
          </a:ln>
        </p:spPr>
      </p:pic>
      <p:sp>
        <p:nvSpPr>
          <p:cNvPr id="533" name="TextBox 12319"/>
          <p:cNvSpPr/>
          <p:nvPr/>
        </p:nvSpPr>
        <p:spPr>
          <a:xfrm>
            <a:off x="3284640" y="1252440"/>
            <a:ext cx="1218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Reactive Oxygen Specie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4" name="Straight Arrow Connector 12321"/>
          <p:cNvCxnSpPr/>
          <p:nvPr/>
        </p:nvCxnSpPr>
        <p:spPr>
          <a:xfrm flipH="1">
            <a:off x="3893400" y="1436760"/>
            <a:ext cx="1080" cy="450000"/>
          </a:xfrm>
          <a:prstGeom prst="straightConnector1">
            <a:avLst/>
          </a:prstGeom>
          <a:ln w="9360">
            <a:solidFill>
              <a:srgbClr val="000000"/>
            </a:solidFill>
            <a:prstDash val="sysDash"/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50"/>
          <p:cNvSpPr/>
          <p:nvPr/>
        </p:nvSpPr>
        <p:spPr>
          <a:xfrm>
            <a:off x="584280" y="86832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51"/>
          <p:cNvSpPr/>
          <p:nvPr/>
        </p:nvSpPr>
        <p:spPr>
          <a:xfrm>
            <a:off x="571320" y="219240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8"/>
          <p:cNvSpPr/>
          <p:nvPr/>
        </p:nvSpPr>
        <p:spPr>
          <a:xfrm>
            <a:off x="2800800" y="4030560"/>
            <a:ext cx="122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ral Keratinocy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1"/>
          <p:cNvSpPr/>
          <p:nvPr/>
        </p:nvSpPr>
        <p:spPr>
          <a:xfrm rot="16200000">
            <a:off x="577800" y="289224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h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73"/>
          <p:cNvGrpSpPr/>
          <p:nvPr/>
        </p:nvGrpSpPr>
        <p:grpSpPr>
          <a:xfrm>
            <a:off x="839880" y="2639880"/>
            <a:ext cx="5626080" cy="690840"/>
            <a:chOff x="839880" y="2639880"/>
            <a:chExt cx="5626080" cy="690840"/>
          </a:xfrm>
        </p:grpSpPr>
        <p:pic>
          <p:nvPicPr>
            <p:cNvPr id="69" name="Picture 2" descr=""/>
            <p:cNvPicPr/>
            <p:nvPr/>
          </p:nvPicPr>
          <p:blipFill>
            <a:blip r:embed="rId1"/>
            <a:stretch/>
          </p:blipFill>
          <p:spPr>
            <a:xfrm>
              <a:off x="3675240" y="2644560"/>
              <a:ext cx="904680" cy="68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" descr=""/>
            <p:cNvPicPr/>
            <p:nvPr/>
          </p:nvPicPr>
          <p:blipFill>
            <a:blip r:embed="rId2"/>
            <a:stretch/>
          </p:blipFill>
          <p:spPr>
            <a:xfrm>
              <a:off x="4623120" y="2644560"/>
              <a:ext cx="904680" cy="68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" descr=""/>
            <p:cNvPicPr/>
            <p:nvPr/>
          </p:nvPicPr>
          <p:blipFill>
            <a:blip r:embed="rId3">
              <a:lum contrast="40000"/>
            </a:blip>
            <a:srcRect l="0" t="12334" r="0" b="0"/>
            <a:stretch/>
          </p:blipFill>
          <p:spPr>
            <a:xfrm>
              <a:off x="1787400" y="2639880"/>
              <a:ext cx="906480" cy="69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5" descr=""/>
            <p:cNvPicPr/>
            <p:nvPr/>
          </p:nvPicPr>
          <p:blipFill>
            <a:blip r:embed="rId4"/>
            <a:stretch/>
          </p:blipFill>
          <p:spPr>
            <a:xfrm>
              <a:off x="5561280" y="2644560"/>
              <a:ext cx="904680" cy="68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6" descr=""/>
            <p:cNvPicPr/>
            <p:nvPr/>
          </p:nvPicPr>
          <p:blipFill>
            <a:blip r:embed="rId5"/>
            <a:stretch/>
          </p:blipFill>
          <p:spPr>
            <a:xfrm>
              <a:off x="2736720" y="2644560"/>
              <a:ext cx="904680" cy="68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7" descr=""/>
            <p:cNvPicPr/>
            <p:nvPr/>
          </p:nvPicPr>
          <p:blipFill>
            <a:blip r:embed="rId6">
              <a:lum contrast="40000"/>
            </a:blip>
            <a:stretch/>
          </p:blipFill>
          <p:spPr>
            <a:xfrm>
              <a:off x="839880" y="2644560"/>
              <a:ext cx="906480" cy="68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Straight Connector 106"/>
            <p:cNvSpPr/>
            <p:nvPr/>
          </p:nvSpPr>
          <p:spPr>
            <a:xfrm>
              <a:off x="1182600" y="2657520"/>
              <a:ext cx="2232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107"/>
            <p:cNvSpPr/>
            <p:nvPr/>
          </p:nvSpPr>
          <p:spPr>
            <a:xfrm>
              <a:off x="1333440" y="2667240"/>
              <a:ext cx="2232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110"/>
            <p:cNvSpPr/>
            <p:nvPr/>
          </p:nvSpPr>
          <p:spPr>
            <a:xfrm flipH="1">
              <a:off x="2161080" y="2657160"/>
              <a:ext cx="11520" cy="64008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111"/>
            <p:cNvSpPr/>
            <p:nvPr/>
          </p:nvSpPr>
          <p:spPr>
            <a:xfrm flipH="1">
              <a:off x="2311920" y="2660400"/>
              <a:ext cx="11520" cy="64188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120"/>
            <p:cNvSpPr/>
            <p:nvPr/>
          </p:nvSpPr>
          <p:spPr>
            <a:xfrm flipH="1">
              <a:off x="3107520" y="2660400"/>
              <a:ext cx="11520" cy="64008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121"/>
            <p:cNvSpPr/>
            <p:nvPr/>
          </p:nvSpPr>
          <p:spPr>
            <a:xfrm flipH="1">
              <a:off x="3242160" y="2663640"/>
              <a:ext cx="11520" cy="64188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130"/>
            <p:cNvSpPr/>
            <p:nvPr/>
          </p:nvSpPr>
          <p:spPr>
            <a:xfrm>
              <a:off x="4041720" y="2665440"/>
              <a:ext cx="22320" cy="6411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Straight Connector 131"/>
            <p:cNvSpPr/>
            <p:nvPr/>
          </p:nvSpPr>
          <p:spPr>
            <a:xfrm>
              <a:off x="4183200" y="2670120"/>
              <a:ext cx="2232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Straight Connector 138"/>
            <p:cNvSpPr/>
            <p:nvPr/>
          </p:nvSpPr>
          <p:spPr>
            <a:xfrm flipH="1">
              <a:off x="5014080" y="2660760"/>
              <a:ext cx="3384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139"/>
            <p:cNvSpPr/>
            <p:nvPr/>
          </p:nvSpPr>
          <p:spPr>
            <a:xfrm flipH="1">
              <a:off x="5164920" y="2664000"/>
              <a:ext cx="33840" cy="6411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Straight Connector 148"/>
            <p:cNvSpPr/>
            <p:nvPr/>
          </p:nvSpPr>
          <p:spPr>
            <a:xfrm flipH="1">
              <a:off x="5956920" y="2678040"/>
              <a:ext cx="3384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Straight Connector 149"/>
            <p:cNvSpPr/>
            <p:nvPr/>
          </p:nvSpPr>
          <p:spPr>
            <a:xfrm flipH="1">
              <a:off x="6107760" y="2681280"/>
              <a:ext cx="33840" cy="639360"/>
            </a:xfrm>
            <a:prstGeom prst="line">
              <a:avLst/>
            </a:prstGeom>
            <a:ln w="19080">
              <a:solidFill>
                <a:srgbClr val="c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Group 72"/>
          <p:cNvGrpSpPr/>
          <p:nvPr/>
        </p:nvGrpSpPr>
        <p:grpSpPr>
          <a:xfrm>
            <a:off x="839880" y="3365640"/>
            <a:ext cx="5632200" cy="687240"/>
            <a:chOff x="839880" y="3365640"/>
            <a:chExt cx="5632200" cy="687240"/>
          </a:xfrm>
        </p:grpSpPr>
        <p:pic>
          <p:nvPicPr>
            <p:cNvPr id="88" name="Picture 21" descr=""/>
            <p:cNvPicPr/>
            <p:nvPr/>
          </p:nvPicPr>
          <p:blipFill>
            <a:blip r:embed="rId7">
              <a:lum contrast="40000"/>
            </a:blip>
            <a:srcRect l="0" t="9867" r="0" b="0"/>
            <a:stretch/>
          </p:blipFill>
          <p:spPr>
            <a:xfrm>
              <a:off x="839880" y="3366360"/>
              <a:ext cx="906120" cy="68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22" descr=""/>
            <p:cNvPicPr/>
            <p:nvPr/>
          </p:nvPicPr>
          <p:blipFill>
            <a:blip r:embed="rId8">
              <a:lum contrast="40000"/>
            </a:blip>
            <a:stretch/>
          </p:blipFill>
          <p:spPr>
            <a:xfrm>
              <a:off x="2738520" y="3366360"/>
              <a:ext cx="906120" cy="68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24" descr=""/>
            <p:cNvPicPr/>
            <p:nvPr/>
          </p:nvPicPr>
          <p:blipFill>
            <a:blip r:embed="rId9">
              <a:lum contrast="40000"/>
            </a:blip>
            <a:stretch/>
          </p:blipFill>
          <p:spPr>
            <a:xfrm>
              <a:off x="5567400" y="3366360"/>
              <a:ext cx="904680" cy="68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25" descr=""/>
            <p:cNvPicPr/>
            <p:nvPr/>
          </p:nvPicPr>
          <p:blipFill>
            <a:blip r:embed="rId10">
              <a:lum contrast="40000"/>
            </a:blip>
            <a:stretch/>
          </p:blipFill>
          <p:spPr>
            <a:xfrm>
              <a:off x="1789200" y="3366360"/>
              <a:ext cx="906120" cy="68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26" descr=""/>
            <p:cNvPicPr/>
            <p:nvPr/>
          </p:nvPicPr>
          <p:blipFill>
            <a:blip r:embed="rId11">
              <a:lum contrast="40000"/>
            </a:blip>
            <a:stretch/>
          </p:blipFill>
          <p:spPr>
            <a:xfrm>
              <a:off x="4627440" y="3366360"/>
              <a:ext cx="906120" cy="686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28" descr=""/>
            <p:cNvPicPr/>
            <p:nvPr/>
          </p:nvPicPr>
          <p:blipFill>
            <a:blip r:embed="rId12">
              <a:lum contrast="40000"/>
            </a:blip>
            <a:stretch/>
          </p:blipFill>
          <p:spPr>
            <a:xfrm>
              <a:off x="3678120" y="3366360"/>
              <a:ext cx="906120" cy="686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Freeform: Shape 64"/>
            <p:cNvSpPr/>
            <p:nvPr/>
          </p:nvSpPr>
          <p:spPr>
            <a:xfrm>
              <a:off x="1208160" y="3368520"/>
              <a:ext cx="129960" cy="673200"/>
            </a:xfrm>
            <a:custGeom>
              <a:avLst/>
              <a:gdLst/>
              <a:ahLst/>
              <a:rect l="l" t="t" r="r" b="b"/>
              <a:pathLst>
                <a:path w="130629" h="672992">
                  <a:moveTo>
                    <a:pt x="68580" y="6785"/>
                  </a:moveTo>
                  <a:cubicBezTo>
                    <a:pt x="64770" y="13861"/>
                    <a:pt x="67015" y="30805"/>
                    <a:pt x="65315" y="42708"/>
                  </a:cubicBezTo>
                  <a:cubicBezTo>
                    <a:pt x="64828" y="46116"/>
                    <a:pt x="62049" y="49063"/>
                    <a:pt x="62049" y="52505"/>
                  </a:cubicBezTo>
                  <a:cubicBezTo>
                    <a:pt x="62049" y="94437"/>
                    <a:pt x="60877" y="88171"/>
                    <a:pt x="68580" y="111288"/>
                  </a:cubicBezTo>
                  <a:cubicBezTo>
                    <a:pt x="67492" y="119996"/>
                    <a:pt x="65862" y="128654"/>
                    <a:pt x="65315" y="137413"/>
                  </a:cubicBezTo>
                  <a:cubicBezTo>
                    <a:pt x="63684" y="163510"/>
                    <a:pt x="63981" y="189713"/>
                    <a:pt x="62049" y="215790"/>
                  </a:cubicBezTo>
                  <a:cubicBezTo>
                    <a:pt x="61795" y="219223"/>
                    <a:pt x="59729" y="222278"/>
                    <a:pt x="58783" y="225588"/>
                  </a:cubicBezTo>
                  <a:cubicBezTo>
                    <a:pt x="57550" y="229903"/>
                    <a:pt x="56808" y="234351"/>
                    <a:pt x="55518" y="238650"/>
                  </a:cubicBezTo>
                  <a:cubicBezTo>
                    <a:pt x="55510" y="238677"/>
                    <a:pt x="47357" y="263130"/>
                    <a:pt x="45720" y="268042"/>
                  </a:cubicBezTo>
                  <a:cubicBezTo>
                    <a:pt x="44632" y="271308"/>
                    <a:pt x="43995" y="274760"/>
                    <a:pt x="42455" y="277839"/>
                  </a:cubicBezTo>
                  <a:cubicBezTo>
                    <a:pt x="40278" y="282193"/>
                    <a:pt x="37841" y="286427"/>
                    <a:pt x="35923" y="290902"/>
                  </a:cubicBezTo>
                  <a:cubicBezTo>
                    <a:pt x="33115" y="297455"/>
                    <a:pt x="31047" y="307141"/>
                    <a:pt x="29392" y="313762"/>
                  </a:cubicBezTo>
                  <a:cubicBezTo>
                    <a:pt x="30481" y="347508"/>
                    <a:pt x="29690" y="381366"/>
                    <a:pt x="32658" y="414999"/>
                  </a:cubicBezTo>
                  <a:cubicBezTo>
                    <a:pt x="33003" y="418909"/>
                    <a:pt x="38944" y="420879"/>
                    <a:pt x="39189" y="424796"/>
                  </a:cubicBezTo>
                  <a:cubicBezTo>
                    <a:pt x="39797" y="434521"/>
                    <a:pt x="37024" y="468297"/>
                    <a:pt x="32658" y="483579"/>
                  </a:cubicBezTo>
                  <a:cubicBezTo>
                    <a:pt x="29821" y="493509"/>
                    <a:pt x="22860" y="512970"/>
                    <a:pt x="22860" y="512970"/>
                  </a:cubicBezTo>
                  <a:cubicBezTo>
                    <a:pt x="21772" y="533653"/>
                    <a:pt x="21470" y="554392"/>
                    <a:pt x="19595" y="575019"/>
                  </a:cubicBezTo>
                  <a:cubicBezTo>
                    <a:pt x="19283" y="578447"/>
                    <a:pt x="16709" y="581395"/>
                    <a:pt x="16329" y="584816"/>
                  </a:cubicBezTo>
                  <a:cubicBezTo>
                    <a:pt x="14522" y="601081"/>
                    <a:pt x="15377" y="617602"/>
                    <a:pt x="13063" y="633802"/>
                  </a:cubicBezTo>
                  <a:cubicBezTo>
                    <a:pt x="10943" y="648642"/>
                    <a:pt x="7129" y="652501"/>
                    <a:pt x="0" y="663193"/>
                  </a:cubicBezTo>
                  <a:cubicBezTo>
                    <a:pt x="3266" y="665370"/>
                    <a:pt x="6074" y="668484"/>
                    <a:pt x="9798" y="669725"/>
                  </a:cubicBezTo>
                  <a:cubicBezTo>
                    <a:pt x="28494" y="675957"/>
                    <a:pt x="42116" y="671718"/>
                    <a:pt x="62049" y="669725"/>
                  </a:cubicBezTo>
                  <a:cubicBezTo>
                    <a:pt x="64162" y="663385"/>
                    <a:pt x="67834" y="653208"/>
                    <a:pt x="68580" y="646865"/>
                  </a:cubicBezTo>
                  <a:cubicBezTo>
                    <a:pt x="74439" y="597059"/>
                    <a:pt x="63339" y="617170"/>
                    <a:pt x="78378" y="594613"/>
                  </a:cubicBezTo>
                  <a:cubicBezTo>
                    <a:pt x="77289" y="573930"/>
                    <a:pt x="75112" y="553276"/>
                    <a:pt x="75112" y="532565"/>
                  </a:cubicBezTo>
                  <a:cubicBezTo>
                    <a:pt x="75112" y="403059"/>
                    <a:pt x="54521" y="437723"/>
                    <a:pt x="84909" y="392139"/>
                  </a:cubicBezTo>
                  <a:cubicBezTo>
                    <a:pt x="94286" y="354635"/>
                    <a:pt x="81174" y="400853"/>
                    <a:pt x="94706" y="369279"/>
                  </a:cubicBezTo>
                  <a:cubicBezTo>
                    <a:pt x="96474" y="365154"/>
                    <a:pt x="96883" y="360570"/>
                    <a:pt x="97972" y="356216"/>
                  </a:cubicBezTo>
                  <a:cubicBezTo>
                    <a:pt x="96055" y="346632"/>
                    <a:pt x="95206" y="338877"/>
                    <a:pt x="91440" y="330090"/>
                  </a:cubicBezTo>
                  <a:cubicBezTo>
                    <a:pt x="89522" y="325616"/>
                    <a:pt x="87086" y="321382"/>
                    <a:pt x="84909" y="317028"/>
                  </a:cubicBezTo>
                  <a:cubicBezTo>
                    <a:pt x="85998" y="309408"/>
                    <a:pt x="84990" y="301175"/>
                    <a:pt x="88175" y="294168"/>
                  </a:cubicBezTo>
                  <a:cubicBezTo>
                    <a:pt x="90723" y="288562"/>
                    <a:pt x="96884" y="285459"/>
                    <a:pt x="101238" y="281105"/>
                  </a:cubicBezTo>
                  <a:lnTo>
                    <a:pt x="107769" y="274573"/>
                  </a:lnTo>
                  <a:cubicBezTo>
                    <a:pt x="108458" y="269752"/>
                    <a:pt x="112792" y="238149"/>
                    <a:pt x="114300" y="232119"/>
                  </a:cubicBezTo>
                  <a:cubicBezTo>
                    <a:pt x="118334" y="215982"/>
                    <a:pt x="120608" y="212973"/>
                    <a:pt x="127363" y="199462"/>
                  </a:cubicBezTo>
                  <a:cubicBezTo>
                    <a:pt x="128452" y="171159"/>
                    <a:pt x="130629" y="142877"/>
                    <a:pt x="130629" y="114553"/>
                  </a:cubicBezTo>
                  <a:cubicBezTo>
                    <a:pt x="130629" y="86229"/>
                    <a:pt x="130277" y="57818"/>
                    <a:pt x="127363" y="29645"/>
                  </a:cubicBezTo>
                  <a:cubicBezTo>
                    <a:pt x="126959" y="25741"/>
                    <a:pt x="123284" y="22913"/>
                    <a:pt x="120832" y="19848"/>
                  </a:cubicBezTo>
                  <a:cubicBezTo>
                    <a:pt x="118908" y="17444"/>
                    <a:pt x="116665" y="15287"/>
                    <a:pt x="114300" y="13316"/>
                  </a:cubicBezTo>
                  <a:cubicBezTo>
                    <a:pt x="104089" y="4807"/>
                    <a:pt x="101205" y="1556"/>
                    <a:pt x="88175" y="253"/>
                  </a:cubicBezTo>
                  <a:cubicBezTo>
                    <a:pt x="81676" y="-397"/>
                    <a:pt x="72390" y="-291"/>
                    <a:pt x="68580" y="6785"/>
                  </a:cubicBez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: Shape 65"/>
            <p:cNvSpPr/>
            <p:nvPr/>
          </p:nvSpPr>
          <p:spPr>
            <a:xfrm>
              <a:off x="2214360" y="3371760"/>
              <a:ext cx="52200" cy="676440"/>
            </a:xfrm>
            <a:custGeom>
              <a:avLst/>
              <a:gdLst/>
              <a:ahLst/>
              <a:rect l="l" t="t" r="r" b="b"/>
              <a:pathLst>
                <a:path w="52390" h="675650">
                  <a:moveTo>
                    <a:pt x="13063" y="12710"/>
                  </a:moveTo>
                  <a:cubicBezTo>
                    <a:pt x="12519" y="18153"/>
                    <a:pt x="3615" y="36226"/>
                    <a:pt x="3266" y="48633"/>
                  </a:cubicBezTo>
                  <a:cubicBezTo>
                    <a:pt x="-966" y="198891"/>
                    <a:pt x="-1808" y="186199"/>
                    <a:pt x="9798" y="267436"/>
                  </a:cubicBezTo>
                  <a:cubicBezTo>
                    <a:pt x="8709" y="285942"/>
                    <a:pt x="8318" y="304502"/>
                    <a:pt x="6532" y="322953"/>
                  </a:cubicBezTo>
                  <a:cubicBezTo>
                    <a:pt x="5049" y="338276"/>
                    <a:pt x="0" y="368673"/>
                    <a:pt x="0" y="368673"/>
                  </a:cubicBezTo>
                  <a:cubicBezTo>
                    <a:pt x="1089" y="401330"/>
                    <a:pt x="1347" y="434025"/>
                    <a:pt x="3266" y="466644"/>
                  </a:cubicBezTo>
                  <a:cubicBezTo>
                    <a:pt x="3530" y="471125"/>
                    <a:pt x="5849" y="475271"/>
                    <a:pt x="6532" y="479707"/>
                  </a:cubicBezTo>
                  <a:cubicBezTo>
                    <a:pt x="8031" y="489450"/>
                    <a:pt x="8299" y="499355"/>
                    <a:pt x="9798" y="509098"/>
                  </a:cubicBezTo>
                  <a:cubicBezTo>
                    <a:pt x="10480" y="513534"/>
                    <a:pt x="12236" y="517750"/>
                    <a:pt x="13063" y="522161"/>
                  </a:cubicBezTo>
                  <a:cubicBezTo>
                    <a:pt x="15504" y="535177"/>
                    <a:pt x="16528" y="548467"/>
                    <a:pt x="19595" y="561350"/>
                  </a:cubicBezTo>
                  <a:cubicBezTo>
                    <a:pt x="21987" y="571396"/>
                    <a:pt x="26126" y="580944"/>
                    <a:pt x="29392" y="590741"/>
                  </a:cubicBezTo>
                  <a:lnTo>
                    <a:pt x="32658" y="600538"/>
                  </a:lnTo>
                  <a:cubicBezTo>
                    <a:pt x="34835" y="616867"/>
                    <a:pt x="36859" y="633216"/>
                    <a:pt x="39189" y="649524"/>
                  </a:cubicBezTo>
                  <a:cubicBezTo>
                    <a:pt x="40125" y="656079"/>
                    <a:pt x="40130" y="662918"/>
                    <a:pt x="42455" y="669118"/>
                  </a:cubicBezTo>
                  <a:cubicBezTo>
                    <a:pt x="43536" y="672001"/>
                    <a:pt x="46809" y="673473"/>
                    <a:pt x="48986" y="675650"/>
                  </a:cubicBezTo>
                  <a:cubicBezTo>
                    <a:pt x="33176" y="628226"/>
                    <a:pt x="50785" y="685071"/>
                    <a:pt x="52252" y="551553"/>
                  </a:cubicBezTo>
                  <a:cubicBezTo>
                    <a:pt x="52922" y="490587"/>
                    <a:pt x="51052" y="429608"/>
                    <a:pt x="48986" y="368673"/>
                  </a:cubicBezTo>
                  <a:cubicBezTo>
                    <a:pt x="48869" y="365233"/>
                    <a:pt x="46666" y="362186"/>
                    <a:pt x="45720" y="358876"/>
                  </a:cubicBezTo>
                  <a:cubicBezTo>
                    <a:pt x="35843" y="324304"/>
                    <a:pt x="51456" y="372820"/>
                    <a:pt x="35923" y="326218"/>
                  </a:cubicBezTo>
                  <a:lnTo>
                    <a:pt x="32658" y="316421"/>
                  </a:lnTo>
                  <a:cubicBezTo>
                    <a:pt x="30481" y="296827"/>
                    <a:pt x="32360" y="276341"/>
                    <a:pt x="26126" y="257638"/>
                  </a:cubicBezTo>
                  <a:lnTo>
                    <a:pt x="19595" y="238044"/>
                  </a:lnTo>
                  <a:lnTo>
                    <a:pt x="16329" y="228247"/>
                  </a:lnTo>
                  <a:cubicBezTo>
                    <a:pt x="15255" y="199250"/>
                    <a:pt x="11478" y="93616"/>
                    <a:pt x="9798" y="61696"/>
                  </a:cubicBezTo>
                  <a:cubicBezTo>
                    <a:pt x="8995" y="46438"/>
                    <a:pt x="8317" y="31150"/>
                    <a:pt x="6532" y="15976"/>
                  </a:cubicBezTo>
                  <a:cubicBezTo>
                    <a:pt x="2922" y="-14708"/>
                    <a:pt x="13607" y="7267"/>
                    <a:pt x="13063" y="12710"/>
                  </a:cubicBez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: Shape 66"/>
            <p:cNvSpPr/>
            <p:nvPr/>
          </p:nvSpPr>
          <p:spPr>
            <a:xfrm>
              <a:off x="3154320" y="3365640"/>
              <a:ext cx="55440" cy="673200"/>
            </a:xfrm>
            <a:custGeom>
              <a:avLst/>
              <a:gdLst/>
              <a:ahLst/>
              <a:rect l="l" t="t" r="r" b="b"/>
              <a:pathLst>
                <a:path w="56019" h="672989">
                  <a:moveTo>
                    <a:pt x="13063" y="10049"/>
                  </a:moveTo>
                  <a:cubicBezTo>
                    <a:pt x="11974" y="22023"/>
                    <a:pt x="9797" y="33948"/>
                    <a:pt x="9797" y="45972"/>
                  </a:cubicBezTo>
                  <a:cubicBezTo>
                    <a:pt x="9797" y="57008"/>
                    <a:pt x="15666" y="68807"/>
                    <a:pt x="19594" y="78629"/>
                  </a:cubicBezTo>
                  <a:cubicBezTo>
                    <a:pt x="20683" y="88426"/>
                    <a:pt x="21239" y="98297"/>
                    <a:pt x="22860" y="108020"/>
                  </a:cubicBezTo>
                  <a:cubicBezTo>
                    <a:pt x="23426" y="111416"/>
                    <a:pt x="25379" y="114457"/>
                    <a:pt x="26126" y="117817"/>
                  </a:cubicBezTo>
                  <a:cubicBezTo>
                    <a:pt x="33792" y="152313"/>
                    <a:pt x="25305" y="125149"/>
                    <a:pt x="32657" y="147209"/>
                  </a:cubicBezTo>
                  <a:cubicBezTo>
                    <a:pt x="31569" y="170069"/>
                    <a:pt x="31022" y="192961"/>
                    <a:pt x="29392" y="215789"/>
                  </a:cubicBezTo>
                  <a:cubicBezTo>
                    <a:pt x="28844" y="223467"/>
                    <a:pt x="26765" y="230978"/>
                    <a:pt x="26126" y="238649"/>
                  </a:cubicBezTo>
                  <a:cubicBezTo>
                    <a:pt x="23498" y="270183"/>
                    <a:pt x="21699" y="301781"/>
                    <a:pt x="19594" y="333354"/>
                  </a:cubicBezTo>
                  <a:cubicBezTo>
                    <a:pt x="18433" y="350767"/>
                    <a:pt x="18156" y="368251"/>
                    <a:pt x="16329" y="385606"/>
                  </a:cubicBezTo>
                  <a:cubicBezTo>
                    <a:pt x="15969" y="389029"/>
                    <a:pt x="14009" y="392093"/>
                    <a:pt x="13063" y="395403"/>
                  </a:cubicBezTo>
                  <a:cubicBezTo>
                    <a:pt x="11830" y="399719"/>
                    <a:pt x="11373" y="404263"/>
                    <a:pt x="9797" y="408466"/>
                  </a:cubicBezTo>
                  <a:cubicBezTo>
                    <a:pt x="-14430" y="473073"/>
                    <a:pt x="16230" y="382640"/>
                    <a:pt x="0" y="431326"/>
                  </a:cubicBezTo>
                  <a:cubicBezTo>
                    <a:pt x="1089" y="469426"/>
                    <a:pt x="1263" y="507563"/>
                    <a:pt x="3266" y="545626"/>
                  </a:cubicBezTo>
                  <a:cubicBezTo>
                    <a:pt x="3447" y="549064"/>
                    <a:pt x="6356" y="551985"/>
                    <a:pt x="6532" y="555423"/>
                  </a:cubicBezTo>
                  <a:cubicBezTo>
                    <a:pt x="8540" y="594575"/>
                    <a:pt x="8709" y="633800"/>
                    <a:pt x="9797" y="672989"/>
                  </a:cubicBezTo>
                  <a:cubicBezTo>
                    <a:pt x="13063" y="671900"/>
                    <a:pt x="18759" y="673063"/>
                    <a:pt x="19594" y="669723"/>
                  </a:cubicBezTo>
                  <a:cubicBezTo>
                    <a:pt x="20546" y="665915"/>
                    <a:pt x="14818" y="663436"/>
                    <a:pt x="13063" y="659926"/>
                  </a:cubicBezTo>
                  <a:cubicBezTo>
                    <a:pt x="4584" y="642968"/>
                    <a:pt x="16023" y="656355"/>
                    <a:pt x="3266" y="643597"/>
                  </a:cubicBezTo>
                  <a:cubicBezTo>
                    <a:pt x="4355" y="632711"/>
                    <a:pt x="4386" y="621668"/>
                    <a:pt x="6532" y="610940"/>
                  </a:cubicBezTo>
                  <a:cubicBezTo>
                    <a:pt x="7682" y="605192"/>
                    <a:pt x="12234" y="600415"/>
                    <a:pt x="13063" y="594612"/>
                  </a:cubicBezTo>
                  <a:cubicBezTo>
                    <a:pt x="24375" y="515425"/>
                    <a:pt x="9267" y="563551"/>
                    <a:pt x="19594" y="532563"/>
                  </a:cubicBezTo>
                  <a:cubicBezTo>
                    <a:pt x="20683" y="524943"/>
                    <a:pt x="21689" y="517311"/>
                    <a:pt x="22860" y="509703"/>
                  </a:cubicBezTo>
                  <a:cubicBezTo>
                    <a:pt x="23867" y="503159"/>
                    <a:pt x="25498" y="496701"/>
                    <a:pt x="26126" y="490109"/>
                  </a:cubicBezTo>
                  <a:cubicBezTo>
                    <a:pt x="27678" y="473818"/>
                    <a:pt x="27585" y="457388"/>
                    <a:pt x="29392" y="441123"/>
                  </a:cubicBezTo>
                  <a:cubicBezTo>
                    <a:pt x="29772" y="437702"/>
                    <a:pt x="30886" y="434278"/>
                    <a:pt x="32657" y="431326"/>
                  </a:cubicBezTo>
                  <a:cubicBezTo>
                    <a:pt x="34241" y="428686"/>
                    <a:pt x="37012" y="426971"/>
                    <a:pt x="39189" y="424794"/>
                  </a:cubicBezTo>
                  <a:cubicBezTo>
                    <a:pt x="54638" y="378436"/>
                    <a:pt x="33820" y="443716"/>
                    <a:pt x="48986" y="307229"/>
                  </a:cubicBezTo>
                  <a:cubicBezTo>
                    <a:pt x="52748" y="273376"/>
                    <a:pt x="49862" y="287400"/>
                    <a:pt x="55517" y="264774"/>
                  </a:cubicBezTo>
                  <a:cubicBezTo>
                    <a:pt x="54429" y="248446"/>
                    <a:pt x="54369" y="232016"/>
                    <a:pt x="52252" y="215789"/>
                  </a:cubicBezTo>
                  <a:cubicBezTo>
                    <a:pt x="51091" y="206888"/>
                    <a:pt x="45720" y="189663"/>
                    <a:pt x="45720" y="189663"/>
                  </a:cubicBezTo>
                  <a:cubicBezTo>
                    <a:pt x="46299" y="167077"/>
                    <a:pt x="42449" y="86822"/>
                    <a:pt x="52252" y="42706"/>
                  </a:cubicBezTo>
                  <a:cubicBezTo>
                    <a:pt x="52999" y="39346"/>
                    <a:pt x="54429" y="36175"/>
                    <a:pt x="55517" y="32909"/>
                  </a:cubicBezTo>
                  <a:cubicBezTo>
                    <a:pt x="54429" y="22023"/>
                    <a:pt x="58968" y="8888"/>
                    <a:pt x="52252" y="252"/>
                  </a:cubicBezTo>
                  <a:cubicBezTo>
                    <a:pt x="50948" y="-1425"/>
                    <a:pt x="23682" y="5761"/>
                    <a:pt x="19594" y="6783"/>
                  </a:cubicBezTo>
                  <a:lnTo>
                    <a:pt x="13063" y="10049"/>
                  </a:ln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: Shape 67"/>
            <p:cNvSpPr/>
            <p:nvPr/>
          </p:nvSpPr>
          <p:spPr>
            <a:xfrm>
              <a:off x="4062240" y="3371760"/>
              <a:ext cx="74520" cy="668520"/>
            </a:xfrm>
            <a:custGeom>
              <a:avLst/>
              <a:gdLst/>
              <a:ahLst/>
              <a:rect l="l" t="t" r="r" b="b"/>
              <a:pathLst>
                <a:path w="75122" h="667816">
                  <a:moveTo>
                    <a:pt x="16328" y="0"/>
                  </a:moveTo>
                  <a:cubicBezTo>
                    <a:pt x="13062" y="14151"/>
                    <a:pt x="9249" y="28187"/>
                    <a:pt x="6531" y="42454"/>
                  </a:cubicBezTo>
                  <a:cubicBezTo>
                    <a:pt x="-1676" y="85541"/>
                    <a:pt x="7810" y="54941"/>
                    <a:pt x="0" y="78377"/>
                  </a:cubicBezTo>
                  <a:cubicBezTo>
                    <a:pt x="1088" y="97971"/>
                    <a:pt x="1405" y="117624"/>
                    <a:pt x="3265" y="137160"/>
                  </a:cubicBezTo>
                  <a:cubicBezTo>
                    <a:pt x="3591" y="140587"/>
                    <a:pt x="4760" y="144005"/>
                    <a:pt x="6531" y="146957"/>
                  </a:cubicBezTo>
                  <a:cubicBezTo>
                    <a:pt x="8115" y="149597"/>
                    <a:pt x="10886" y="151312"/>
                    <a:pt x="13063" y="153489"/>
                  </a:cubicBezTo>
                  <a:cubicBezTo>
                    <a:pt x="24892" y="188976"/>
                    <a:pt x="20583" y="167890"/>
                    <a:pt x="16328" y="225334"/>
                  </a:cubicBezTo>
                  <a:cubicBezTo>
                    <a:pt x="15440" y="237325"/>
                    <a:pt x="14259" y="249293"/>
                    <a:pt x="13063" y="261257"/>
                  </a:cubicBezTo>
                  <a:cubicBezTo>
                    <a:pt x="9938" y="292506"/>
                    <a:pt x="12732" y="281844"/>
                    <a:pt x="6531" y="300446"/>
                  </a:cubicBezTo>
                  <a:cubicBezTo>
                    <a:pt x="7620" y="313509"/>
                    <a:pt x="8064" y="326641"/>
                    <a:pt x="9797" y="339634"/>
                  </a:cubicBezTo>
                  <a:cubicBezTo>
                    <a:pt x="10252" y="343046"/>
                    <a:pt x="12117" y="346121"/>
                    <a:pt x="13063" y="349431"/>
                  </a:cubicBezTo>
                  <a:cubicBezTo>
                    <a:pt x="21264" y="378135"/>
                    <a:pt x="11763" y="348801"/>
                    <a:pt x="19594" y="372291"/>
                  </a:cubicBezTo>
                  <a:cubicBezTo>
                    <a:pt x="18505" y="394063"/>
                    <a:pt x="18138" y="415882"/>
                    <a:pt x="16328" y="437606"/>
                  </a:cubicBezTo>
                  <a:cubicBezTo>
                    <a:pt x="15727" y="444819"/>
                    <a:pt x="11799" y="453459"/>
                    <a:pt x="9797" y="460466"/>
                  </a:cubicBezTo>
                  <a:cubicBezTo>
                    <a:pt x="1595" y="489170"/>
                    <a:pt x="11096" y="459836"/>
                    <a:pt x="3265" y="483326"/>
                  </a:cubicBezTo>
                  <a:cubicBezTo>
                    <a:pt x="4354" y="499654"/>
                    <a:pt x="4103" y="516127"/>
                    <a:pt x="6531" y="532311"/>
                  </a:cubicBezTo>
                  <a:cubicBezTo>
                    <a:pt x="7401" y="538108"/>
                    <a:pt x="12589" y="542797"/>
                    <a:pt x="13063" y="548640"/>
                  </a:cubicBezTo>
                  <a:cubicBezTo>
                    <a:pt x="15879" y="583377"/>
                    <a:pt x="13265" y="618427"/>
                    <a:pt x="16328" y="653143"/>
                  </a:cubicBezTo>
                  <a:cubicBezTo>
                    <a:pt x="16599" y="656210"/>
                    <a:pt x="20106" y="658297"/>
                    <a:pt x="22860" y="659674"/>
                  </a:cubicBezTo>
                  <a:cubicBezTo>
                    <a:pt x="29018" y="662753"/>
                    <a:pt x="42454" y="666206"/>
                    <a:pt x="42454" y="666206"/>
                  </a:cubicBezTo>
                  <a:cubicBezTo>
                    <a:pt x="52251" y="665117"/>
                    <a:pt x="68728" y="672291"/>
                    <a:pt x="71845" y="662940"/>
                  </a:cubicBezTo>
                  <a:cubicBezTo>
                    <a:pt x="79770" y="639165"/>
                    <a:pt x="71159" y="612757"/>
                    <a:pt x="68580" y="587829"/>
                  </a:cubicBezTo>
                  <a:cubicBezTo>
                    <a:pt x="67995" y="582176"/>
                    <a:pt x="57963" y="558022"/>
                    <a:pt x="55517" y="551906"/>
                  </a:cubicBezTo>
                  <a:cubicBezTo>
                    <a:pt x="56606" y="510540"/>
                    <a:pt x="57810" y="469178"/>
                    <a:pt x="58783" y="427809"/>
                  </a:cubicBezTo>
                  <a:cubicBezTo>
                    <a:pt x="59987" y="376649"/>
                    <a:pt x="59261" y="325419"/>
                    <a:pt x="62048" y="274320"/>
                  </a:cubicBezTo>
                  <a:cubicBezTo>
                    <a:pt x="62537" y="265357"/>
                    <a:pt x="68580" y="248194"/>
                    <a:pt x="68580" y="248194"/>
                  </a:cubicBezTo>
                  <a:cubicBezTo>
                    <a:pt x="67491" y="225334"/>
                    <a:pt x="67841" y="202360"/>
                    <a:pt x="65314" y="179614"/>
                  </a:cubicBezTo>
                  <a:cubicBezTo>
                    <a:pt x="64554" y="172772"/>
                    <a:pt x="58783" y="160020"/>
                    <a:pt x="58783" y="160020"/>
                  </a:cubicBezTo>
                  <a:cubicBezTo>
                    <a:pt x="57694" y="151311"/>
                    <a:pt x="55955" y="142659"/>
                    <a:pt x="55517" y="133894"/>
                  </a:cubicBezTo>
                  <a:cubicBezTo>
                    <a:pt x="53776" y="99086"/>
                    <a:pt x="55227" y="64115"/>
                    <a:pt x="52251" y="29391"/>
                  </a:cubicBezTo>
                  <a:cubicBezTo>
                    <a:pt x="51916" y="25481"/>
                    <a:pt x="49048" y="21674"/>
                    <a:pt x="45720" y="19594"/>
                  </a:cubicBezTo>
                  <a:cubicBezTo>
                    <a:pt x="39882" y="15945"/>
                    <a:pt x="32283" y="16142"/>
                    <a:pt x="26125" y="13063"/>
                  </a:cubicBezTo>
                  <a:lnTo>
                    <a:pt x="16328" y="0"/>
                  </a:ln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: Shape 68"/>
            <p:cNvSpPr/>
            <p:nvPr/>
          </p:nvSpPr>
          <p:spPr>
            <a:xfrm>
              <a:off x="5037120" y="3376440"/>
              <a:ext cx="109440" cy="663480"/>
            </a:xfrm>
            <a:custGeom>
              <a:avLst/>
              <a:gdLst/>
              <a:ahLst/>
              <a:rect l="l" t="t" r="r" b="b"/>
              <a:pathLst>
                <a:path w="109458" h="663316">
                  <a:moveTo>
                    <a:pt x="57206" y="1762"/>
                  </a:moveTo>
                  <a:cubicBezTo>
                    <a:pt x="53940" y="4484"/>
                    <a:pt x="60472" y="12540"/>
                    <a:pt x="60472" y="18091"/>
                  </a:cubicBezTo>
                  <a:cubicBezTo>
                    <a:pt x="60472" y="34188"/>
                    <a:pt x="60028" y="46765"/>
                    <a:pt x="47409" y="57280"/>
                  </a:cubicBezTo>
                  <a:cubicBezTo>
                    <a:pt x="44765" y="59484"/>
                    <a:pt x="40878" y="59457"/>
                    <a:pt x="37612" y="60545"/>
                  </a:cubicBezTo>
                  <a:cubicBezTo>
                    <a:pt x="35435" y="62722"/>
                    <a:pt x="31199" y="64000"/>
                    <a:pt x="31081" y="67077"/>
                  </a:cubicBezTo>
                  <a:cubicBezTo>
                    <a:pt x="30076" y="93206"/>
                    <a:pt x="32414" y="119377"/>
                    <a:pt x="34346" y="145454"/>
                  </a:cubicBezTo>
                  <a:cubicBezTo>
                    <a:pt x="34600" y="148887"/>
                    <a:pt x="36072" y="152172"/>
                    <a:pt x="37612" y="155251"/>
                  </a:cubicBezTo>
                  <a:cubicBezTo>
                    <a:pt x="39367" y="158762"/>
                    <a:pt x="41967" y="161782"/>
                    <a:pt x="44144" y="165048"/>
                  </a:cubicBezTo>
                  <a:cubicBezTo>
                    <a:pt x="51649" y="187563"/>
                    <a:pt x="45807" y="179773"/>
                    <a:pt x="57206" y="191174"/>
                  </a:cubicBezTo>
                  <a:cubicBezTo>
                    <a:pt x="58295" y="194440"/>
                    <a:pt x="58701" y="198019"/>
                    <a:pt x="60472" y="200971"/>
                  </a:cubicBezTo>
                  <a:cubicBezTo>
                    <a:pt x="62056" y="203611"/>
                    <a:pt x="66622" y="204447"/>
                    <a:pt x="67004" y="207502"/>
                  </a:cubicBezTo>
                  <a:cubicBezTo>
                    <a:pt x="68049" y="215863"/>
                    <a:pt x="63297" y="228420"/>
                    <a:pt x="60472" y="236894"/>
                  </a:cubicBezTo>
                  <a:cubicBezTo>
                    <a:pt x="58441" y="255169"/>
                    <a:pt x="58098" y="265985"/>
                    <a:pt x="53941" y="282614"/>
                  </a:cubicBezTo>
                  <a:cubicBezTo>
                    <a:pt x="53106" y="285954"/>
                    <a:pt x="52347" y="289402"/>
                    <a:pt x="50675" y="292411"/>
                  </a:cubicBezTo>
                  <a:cubicBezTo>
                    <a:pt x="46863" y="299273"/>
                    <a:pt x="37612" y="312005"/>
                    <a:pt x="37612" y="312005"/>
                  </a:cubicBezTo>
                  <a:cubicBezTo>
                    <a:pt x="38701" y="325068"/>
                    <a:pt x="38307" y="338340"/>
                    <a:pt x="40878" y="351194"/>
                  </a:cubicBezTo>
                  <a:cubicBezTo>
                    <a:pt x="41648" y="355043"/>
                    <a:pt x="45654" y="357481"/>
                    <a:pt x="47409" y="360991"/>
                  </a:cubicBezTo>
                  <a:cubicBezTo>
                    <a:pt x="48948" y="364070"/>
                    <a:pt x="49586" y="367522"/>
                    <a:pt x="50675" y="370788"/>
                  </a:cubicBezTo>
                  <a:cubicBezTo>
                    <a:pt x="51764" y="378408"/>
                    <a:pt x="52924" y="386018"/>
                    <a:pt x="53941" y="393648"/>
                  </a:cubicBezTo>
                  <a:cubicBezTo>
                    <a:pt x="55594" y="406046"/>
                    <a:pt x="60781" y="418172"/>
                    <a:pt x="53941" y="429571"/>
                  </a:cubicBezTo>
                  <a:cubicBezTo>
                    <a:pt x="52357" y="432211"/>
                    <a:pt x="49256" y="433639"/>
                    <a:pt x="47409" y="436102"/>
                  </a:cubicBezTo>
                  <a:cubicBezTo>
                    <a:pt x="42699" y="442382"/>
                    <a:pt x="34346" y="455697"/>
                    <a:pt x="34346" y="455697"/>
                  </a:cubicBezTo>
                  <a:cubicBezTo>
                    <a:pt x="26511" y="479207"/>
                    <a:pt x="36024" y="449827"/>
                    <a:pt x="27815" y="478557"/>
                  </a:cubicBezTo>
                  <a:cubicBezTo>
                    <a:pt x="26869" y="481867"/>
                    <a:pt x="25638" y="485088"/>
                    <a:pt x="24549" y="488354"/>
                  </a:cubicBezTo>
                  <a:cubicBezTo>
                    <a:pt x="22592" y="500100"/>
                    <a:pt x="22404" y="507512"/>
                    <a:pt x="18018" y="517745"/>
                  </a:cubicBezTo>
                  <a:cubicBezTo>
                    <a:pt x="16100" y="522220"/>
                    <a:pt x="13294" y="526288"/>
                    <a:pt x="11486" y="530808"/>
                  </a:cubicBezTo>
                  <a:cubicBezTo>
                    <a:pt x="8929" y="537200"/>
                    <a:pt x="4955" y="550402"/>
                    <a:pt x="4955" y="550402"/>
                  </a:cubicBezTo>
                  <a:cubicBezTo>
                    <a:pt x="6044" y="555845"/>
                    <a:pt x="8221" y="561180"/>
                    <a:pt x="8221" y="566731"/>
                  </a:cubicBezTo>
                  <a:cubicBezTo>
                    <a:pt x="8221" y="611976"/>
                    <a:pt x="9787" y="604487"/>
                    <a:pt x="1689" y="628780"/>
                  </a:cubicBezTo>
                  <a:cubicBezTo>
                    <a:pt x="2778" y="639666"/>
                    <a:pt x="-4580" y="656074"/>
                    <a:pt x="4955" y="661437"/>
                  </a:cubicBezTo>
                  <a:cubicBezTo>
                    <a:pt x="14323" y="666706"/>
                    <a:pt x="50159" y="659718"/>
                    <a:pt x="67004" y="654905"/>
                  </a:cubicBezTo>
                  <a:cubicBezTo>
                    <a:pt x="70314" y="653959"/>
                    <a:pt x="73535" y="652728"/>
                    <a:pt x="76801" y="651640"/>
                  </a:cubicBezTo>
                  <a:cubicBezTo>
                    <a:pt x="78978" y="648374"/>
                    <a:pt x="83102" y="645760"/>
                    <a:pt x="83332" y="641842"/>
                  </a:cubicBezTo>
                  <a:cubicBezTo>
                    <a:pt x="85354" y="607463"/>
                    <a:pt x="80997" y="604973"/>
                    <a:pt x="76801" y="579794"/>
                  </a:cubicBezTo>
                  <a:cubicBezTo>
                    <a:pt x="71799" y="549778"/>
                    <a:pt x="76528" y="565913"/>
                    <a:pt x="70269" y="547137"/>
                  </a:cubicBezTo>
                  <a:cubicBezTo>
                    <a:pt x="71358" y="519923"/>
                    <a:pt x="71594" y="492661"/>
                    <a:pt x="73535" y="465494"/>
                  </a:cubicBezTo>
                  <a:cubicBezTo>
                    <a:pt x="74219" y="455919"/>
                    <a:pt x="79251" y="454063"/>
                    <a:pt x="83332" y="445900"/>
                  </a:cubicBezTo>
                  <a:cubicBezTo>
                    <a:pt x="84872" y="442821"/>
                    <a:pt x="85763" y="439442"/>
                    <a:pt x="86598" y="436102"/>
                  </a:cubicBezTo>
                  <a:cubicBezTo>
                    <a:pt x="93650" y="407895"/>
                    <a:pt x="94583" y="397988"/>
                    <a:pt x="99661" y="367522"/>
                  </a:cubicBezTo>
                  <a:cubicBezTo>
                    <a:pt x="100749" y="345751"/>
                    <a:pt x="101038" y="323925"/>
                    <a:pt x="102926" y="302208"/>
                  </a:cubicBezTo>
                  <a:cubicBezTo>
                    <a:pt x="103224" y="298779"/>
                    <a:pt x="105669" y="295813"/>
                    <a:pt x="106192" y="292411"/>
                  </a:cubicBezTo>
                  <a:cubicBezTo>
                    <a:pt x="107856" y="281598"/>
                    <a:pt x="108369" y="270640"/>
                    <a:pt x="109458" y="259754"/>
                  </a:cubicBezTo>
                  <a:cubicBezTo>
                    <a:pt x="108369" y="203148"/>
                    <a:pt x="108177" y="146518"/>
                    <a:pt x="106192" y="89937"/>
                  </a:cubicBezTo>
                  <a:cubicBezTo>
                    <a:pt x="105701" y="75943"/>
                    <a:pt x="102542" y="75333"/>
                    <a:pt x="99661" y="63811"/>
                  </a:cubicBezTo>
                  <a:cubicBezTo>
                    <a:pt x="96505" y="51187"/>
                    <a:pt x="91863" y="24722"/>
                    <a:pt x="86598" y="11560"/>
                  </a:cubicBezTo>
                  <a:cubicBezTo>
                    <a:pt x="85140" y="7915"/>
                    <a:pt x="83577" y="3518"/>
                    <a:pt x="80066" y="1762"/>
                  </a:cubicBezTo>
                  <a:cubicBezTo>
                    <a:pt x="76172" y="-185"/>
                    <a:pt x="60472" y="-960"/>
                    <a:pt x="57206" y="1762"/>
                  </a:cubicBez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: Shape 70"/>
            <p:cNvSpPr/>
            <p:nvPr/>
          </p:nvSpPr>
          <p:spPr>
            <a:xfrm>
              <a:off x="5985000" y="3367080"/>
              <a:ext cx="129960" cy="671400"/>
            </a:xfrm>
            <a:custGeom>
              <a:avLst/>
              <a:gdLst/>
              <a:ahLst/>
              <a:rect l="l" t="t" r="r" b="b"/>
              <a:pathLst>
                <a:path w="128850" h="671639">
                  <a:moveTo>
                    <a:pt x="55601" y="5433"/>
                  </a:moveTo>
                  <a:cubicBezTo>
                    <a:pt x="49069" y="19040"/>
                    <a:pt x="55016" y="51687"/>
                    <a:pt x="49069" y="90342"/>
                  </a:cubicBezTo>
                  <a:cubicBezTo>
                    <a:pt x="48062" y="96886"/>
                    <a:pt x="47409" y="103512"/>
                    <a:pt x="45803" y="109936"/>
                  </a:cubicBezTo>
                  <a:cubicBezTo>
                    <a:pt x="44133" y="116615"/>
                    <a:pt x="39272" y="129530"/>
                    <a:pt x="39272" y="129530"/>
                  </a:cubicBezTo>
                  <a:cubicBezTo>
                    <a:pt x="44695" y="243407"/>
                    <a:pt x="35002" y="170102"/>
                    <a:pt x="45803" y="207907"/>
                  </a:cubicBezTo>
                  <a:cubicBezTo>
                    <a:pt x="46580" y="210625"/>
                    <a:pt x="50199" y="227207"/>
                    <a:pt x="52335" y="230767"/>
                  </a:cubicBezTo>
                  <a:cubicBezTo>
                    <a:pt x="53919" y="233407"/>
                    <a:pt x="56689" y="235122"/>
                    <a:pt x="58866" y="237299"/>
                  </a:cubicBezTo>
                  <a:cubicBezTo>
                    <a:pt x="57778" y="244919"/>
                    <a:pt x="57110" y="252611"/>
                    <a:pt x="55601" y="260159"/>
                  </a:cubicBezTo>
                  <a:cubicBezTo>
                    <a:pt x="54926" y="263535"/>
                    <a:pt x="53082" y="266596"/>
                    <a:pt x="52335" y="269956"/>
                  </a:cubicBezTo>
                  <a:cubicBezTo>
                    <a:pt x="50898" y="276420"/>
                    <a:pt x="51163" y="283268"/>
                    <a:pt x="49069" y="289550"/>
                  </a:cubicBezTo>
                  <a:cubicBezTo>
                    <a:pt x="47828" y="293273"/>
                    <a:pt x="44293" y="295837"/>
                    <a:pt x="42538" y="299347"/>
                  </a:cubicBezTo>
                  <a:cubicBezTo>
                    <a:pt x="40999" y="302426"/>
                    <a:pt x="41043" y="306192"/>
                    <a:pt x="39272" y="309144"/>
                  </a:cubicBezTo>
                  <a:cubicBezTo>
                    <a:pt x="21044" y="339526"/>
                    <a:pt x="45823" y="286249"/>
                    <a:pt x="26209" y="325473"/>
                  </a:cubicBezTo>
                  <a:cubicBezTo>
                    <a:pt x="23865" y="330161"/>
                    <a:pt x="20725" y="344143"/>
                    <a:pt x="19678" y="348333"/>
                  </a:cubicBezTo>
                  <a:cubicBezTo>
                    <a:pt x="17645" y="366629"/>
                    <a:pt x="17306" y="377412"/>
                    <a:pt x="13146" y="394053"/>
                  </a:cubicBezTo>
                  <a:cubicBezTo>
                    <a:pt x="12311" y="397392"/>
                    <a:pt x="10969" y="400584"/>
                    <a:pt x="9881" y="403850"/>
                  </a:cubicBezTo>
                  <a:cubicBezTo>
                    <a:pt x="8792" y="411470"/>
                    <a:pt x="8125" y="419162"/>
                    <a:pt x="6615" y="426710"/>
                  </a:cubicBezTo>
                  <a:cubicBezTo>
                    <a:pt x="5940" y="430085"/>
                    <a:pt x="3349" y="433065"/>
                    <a:pt x="3349" y="436507"/>
                  </a:cubicBezTo>
                  <a:cubicBezTo>
                    <a:pt x="3349" y="449615"/>
                    <a:pt x="4989" y="462689"/>
                    <a:pt x="6615" y="475696"/>
                  </a:cubicBezTo>
                  <a:cubicBezTo>
                    <a:pt x="7748" y="484763"/>
                    <a:pt x="10738" y="490126"/>
                    <a:pt x="13146" y="498556"/>
                  </a:cubicBezTo>
                  <a:cubicBezTo>
                    <a:pt x="21339" y="527234"/>
                    <a:pt x="11854" y="497946"/>
                    <a:pt x="19678" y="521416"/>
                  </a:cubicBezTo>
                  <a:cubicBezTo>
                    <a:pt x="18589" y="529036"/>
                    <a:pt x="17678" y="536683"/>
                    <a:pt x="16412" y="544276"/>
                  </a:cubicBezTo>
                  <a:cubicBezTo>
                    <a:pt x="15067" y="552344"/>
                    <a:pt x="12227" y="565457"/>
                    <a:pt x="9881" y="573667"/>
                  </a:cubicBezTo>
                  <a:cubicBezTo>
                    <a:pt x="8935" y="576977"/>
                    <a:pt x="7704" y="580198"/>
                    <a:pt x="6615" y="583464"/>
                  </a:cubicBezTo>
                  <a:cubicBezTo>
                    <a:pt x="5526" y="606324"/>
                    <a:pt x="5250" y="629237"/>
                    <a:pt x="3349" y="652044"/>
                  </a:cubicBezTo>
                  <a:cubicBezTo>
                    <a:pt x="3063" y="655475"/>
                    <a:pt x="-592" y="658466"/>
                    <a:pt x="83" y="661842"/>
                  </a:cubicBezTo>
                  <a:cubicBezTo>
                    <a:pt x="1364" y="668245"/>
                    <a:pt x="12287" y="670264"/>
                    <a:pt x="16412" y="671639"/>
                  </a:cubicBezTo>
                  <a:cubicBezTo>
                    <a:pt x="26604" y="670365"/>
                    <a:pt x="44103" y="672133"/>
                    <a:pt x="52335" y="661842"/>
                  </a:cubicBezTo>
                  <a:cubicBezTo>
                    <a:pt x="54014" y="659743"/>
                    <a:pt x="58685" y="639797"/>
                    <a:pt x="58866" y="638982"/>
                  </a:cubicBezTo>
                  <a:cubicBezTo>
                    <a:pt x="60070" y="633563"/>
                    <a:pt x="60786" y="628038"/>
                    <a:pt x="62132" y="622653"/>
                  </a:cubicBezTo>
                  <a:cubicBezTo>
                    <a:pt x="62967" y="619313"/>
                    <a:pt x="64452" y="616166"/>
                    <a:pt x="65398" y="612856"/>
                  </a:cubicBezTo>
                  <a:cubicBezTo>
                    <a:pt x="73599" y="584152"/>
                    <a:pt x="64098" y="613486"/>
                    <a:pt x="71929" y="589996"/>
                  </a:cubicBezTo>
                  <a:cubicBezTo>
                    <a:pt x="73018" y="571490"/>
                    <a:pt x="73655" y="552953"/>
                    <a:pt x="75195" y="534479"/>
                  </a:cubicBezTo>
                  <a:cubicBezTo>
                    <a:pt x="75834" y="526808"/>
                    <a:pt x="78056" y="519306"/>
                    <a:pt x="78461" y="511619"/>
                  </a:cubicBezTo>
                  <a:cubicBezTo>
                    <a:pt x="80235" y="477902"/>
                    <a:pt x="79262" y="444055"/>
                    <a:pt x="81726" y="410382"/>
                  </a:cubicBezTo>
                  <a:cubicBezTo>
                    <a:pt x="82536" y="399310"/>
                    <a:pt x="88258" y="377724"/>
                    <a:pt x="88258" y="377724"/>
                  </a:cubicBezTo>
                  <a:cubicBezTo>
                    <a:pt x="89346" y="353776"/>
                    <a:pt x="89611" y="329776"/>
                    <a:pt x="91523" y="305879"/>
                  </a:cubicBezTo>
                  <a:cubicBezTo>
                    <a:pt x="91797" y="302448"/>
                    <a:pt x="93843" y="299392"/>
                    <a:pt x="94789" y="296082"/>
                  </a:cubicBezTo>
                  <a:cubicBezTo>
                    <a:pt x="96022" y="291766"/>
                    <a:pt x="96966" y="287373"/>
                    <a:pt x="98055" y="283019"/>
                  </a:cubicBezTo>
                  <a:cubicBezTo>
                    <a:pt x="95127" y="250813"/>
                    <a:pt x="91745" y="235031"/>
                    <a:pt x="98055" y="201376"/>
                  </a:cubicBezTo>
                  <a:cubicBezTo>
                    <a:pt x="98622" y="198350"/>
                    <a:pt x="102409" y="197021"/>
                    <a:pt x="104586" y="194844"/>
                  </a:cubicBezTo>
                  <a:cubicBezTo>
                    <a:pt x="105675" y="191578"/>
                    <a:pt x="106313" y="188126"/>
                    <a:pt x="107852" y="185047"/>
                  </a:cubicBezTo>
                  <a:cubicBezTo>
                    <a:pt x="111973" y="176806"/>
                    <a:pt x="114838" y="174795"/>
                    <a:pt x="120915" y="168719"/>
                  </a:cubicBezTo>
                  <a:cubicBezTo>
                    <a:pt x="122004" y="165453"/>
                    <a:pt x="123235" y="162232"/>
                    <a:pt x="124181" y="158922"/>
                  </a:cubicBezTo>
                  <a:cubicBezTo>
                    <a:pt x="129909" y="138873"/>
                    <a:pt x="130885" y="128881"/>
                    <a:pt x="124181" y="103404"/>
                  </a:cubicBezTo>
                  <a:cubicBezTo>
                    <a:pt x="122183" y="95813"/>
                    <a:pt x="115472" y="90341"/>
                    <a:pt x="111118" y="83810"/>
                  </a:cubicBezTo>
                  <a:cubicBezTo>
                    <a:pt x="101884" y="69960"/>
                    <a:pt x="106343" y="77527"/>
                    <a:pt x="98055" y="60950"/>
                  </a:cubicBezTo>
                  <a:cubicBezTo>
                    <a:pt x="99144" y="44621"/>
                    <a:pt x="104337" y="28049"/>
                    <a:pt x="101321" y="11964"/>
                  </a:cubicBezTo>
                  <a:cubicBezTo>
                    <a:pt x="100494" y="7553"/>
                    <a:pt x="92731" y="9072"/>
                    <a:pt x="88258" y="8699"/>
                  </a:cubicBezTo>
                  <a:cubicBezTo>
                    <a:pt x="79579" y="7976"/>
                    <a:pt x="62133" y="-8174"/>
                    <a:pt x="55601" y="5433"/>
                  </a:cubicBezTo>
                  <a:close/>
                </a:path>
              </a:pathLst>
            </a:custGeom>
            <a:noFill/>
            <a:ln w="190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TextBox 11"/>
          <p:cNvSpPr/>
          <p:nvPr/>
        </p:nvSpPr>
        <p:spPr>
          <a:xfrm rot="16200000">
            <a:off x="529200" y="359172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2 h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1" name="Object 76"/>
          <p:cNvGraphicFramePr/>
          <p:nvPr/>
        </p:nvGraphicFramePr>
        <p:xfrm>
          <a:off x="3876840" y="971640"/>
          <a:ext cx="1322280" cy="111600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02" name="Object 76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876840" y="971640"/>
                    <a:ext cx="1322280" cy="111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3" name="Rectangle 78"/>
          <p:cNvSpPr/>
          <p:nvPr/>
        </p:nvSpPr>
        <p:spPr>
          <a:xfrm rot="16200000">
            <a:off x="3575160" y="1366560"/>
            <a:ext cx="48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81"/>
          <p:cNvSpPr/>
          <p:nvPr/>
        </p:nvSpPr>
        <p:spPr>
          <a:xfrm>
            <a:off x="4511520" y="871560"/>
            <a:ext cx="282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5"/>
          <p:cNvSpPr/>
          <p:nvPr/>
        </p:nvSpPr>
        <p:spPr>
          <a:xfrm>
            <a:off x="4165560" y="1998720"/>
            <a:ext cx="53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76"/>
          <p:cNvSpPr/>
          <p:nvPr/>
        </p:nvSpPr>
        <p:spPr>
          <a:xfrm>
            <a:off x="4697280" y="2001960"/>
            <a:ext cx="425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B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133"/>
          <p:cNvSpPr/>
          <p:nvPr/>
        </p:nvSpPr>
        <p:spPr>
          <a:xfrm>
            <a:off x="4405320" y="1025640"/>
            <a:ext cx="47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136"/>
          <p:cNvSpPr/>
          <p:nvPr/>
        </p:nvSpPr>
        <p:spPr>
          <a:xfrm flipV="1">
            <a:off x="4405320" y="1026720"/>
            <a:ext cx="0" cy="282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137"/>
          <p:cNvSpPr/>
          <p:nvPr/>
        </p:nvSpPr>
        <p:spPr>
          <a:xfrm>
            <a:off x="4886280" y="1027080"/>
            <a:ext cx="0" cy="63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Picture 2" descr=""/>
          <p:cNvPicPr/>
          <p:nvPr/>
        </p:nvPicPr>
        <p:blipFill>
          <a:blip r:embed="rId15"/>
          <a:srcRect l="6727" t="2435" r="13469" b="5335"/>
          <a:stretch/>
        </p:blipFill>
        <p:spPr>
          <a:xfrm>
            <a:off x="2247840" y="1035000"/>
            <a:ext cx="1284480" cy="95904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3" descr=""/>
          <p:cNvPicPr/>
          <p:nvPr/>
        </p:nvPicPr>
        <p:blipFill>
          <a:blip r:embed="rId16"/>
          <a:srcRect l="0" t="41692" r="56004" b="2786"/>
          <a:stretch/>
        </p:blipFill>
        <p:spPr>
          <a:xfrm>
            <a:off x="3102120" y="1039680"/>
            <a:ext cx="415800" cy="3319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12" name="Picture 4" descr=""/>
          <p:cNvPicPr/>
          <p:nvPr/>
        </p:nvPicPr>
        <p:blipFill>
          <a:blip r:embed="rId17"/>
          <a:srcRect l="4814" t="0" r="15393" b="7770"/>
          <a:stretch/>
        </p:blipFill>
        <p:spPr>
          <a:xfrm>
            <a:off x="879480" y="1036800"/>
            <a:ext cx="1306440" cy="95724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5" descr=""/>
          <p:cNvPicPr/>
          <p:nvPr/>
        </p:nvPicPr>
        <p:blipFill>
          <a:blip r:embed="rId18">
            <a:lum contrast="40000"/>
          </a:blip>
          <a:srcRect l="3725" t="6714" r="40854" b="26896"/>
          <a:stretch/>
        </p:blipFill>
        <p:spPr>
          <a:xfrm>
            <a:off x="1730520" y="1042920"/>
            <a:ext cx="441360" cy="338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14" name="TextBox 5"/>
          <p:cNvSpPr/>
          <p:nvPr/>
        </p:nvSpPr>
        <p:spPr>
          <a:xfrm>
            <a:off x="1325520" y="8874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6"/>
          <p:cNvSpPr/>
          <p:nvPr/>
        </p:nvSpPr>
        <p:spPr>
          <a:xfrm>
            <a:off x="2679840" y="890640"/>
            <a:ext cx="431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BM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57"/>
          <p:cNvSpPr/>
          <p:nvPr/>
        </p:nvSpPr>
        <p:spPr>
          <a:xfrm>
            <a:off x="409680" y="579600"/>
            <a:ext cx="212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51"/>
          <p:cNvSpPr/>
          <p:nvPr/>
        </p:nvSpPr>
        <p:spPr>
          <a:xfrm>
            <a:off x="1588320" y="435132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2"/>
          <p:cNvSpPr/>
          <p:nvPr/>
        </p:nvSpPr>
        <p:spPr>
          <a:xfrm>
            <a:off x="2900520" y="2463840"/>
            <a:ext cx="71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5 J/cm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4"/>
          <p:cNvSpPr/>
          <p:nvPr/>
        </p:nvSpPr>
        <p:spPr>
          <a:xfrm>
            <a:off x="1987560" y="246384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 J /cm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5"/>
          <p:cNvSpPr/>
          <p:nvPr/>
        </p:nvSpPr>
        <p:spPr>
          <a:xfrm>
            <a:off x="1030320" y="2463840"/>
            <a:ext cx="652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"/>
          <p:cNvSpPr/>
          <p:nvPr/>
        </p:nvSpPr>
        <p:spPr>
          <a:xfrm>
            <a:off x="3771720" y="246384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B4315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Straight Connector 82"/>
          <p:cNvSpPr/>
          <p:nvPr/>
        </p:nvSpPr>
        <p:spPr>
          <a:xfrm>
            <a:off x="1965240" y="2490840"/>
            <a:ext cx="1541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"/>
          <p:cNvSpPr/>
          <p:nvPr/>
        </p:nvSpPr>
        <p:spPr>
          <a:xfrm>
            <a:off x="2498760" y="2317680"/>
            <a:ext cx="490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B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2"/>
          <p:cNvSpPr/>
          <p:nvPr/>
        </p:nvSpPr>
        <p:spPr>
          <a:xfrm>
            <a:off x="5744160" y="2463840"/>
            <a:ext cx="58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5 J/cm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4"/>
          <p:cNvSpPr/>
          <p:nvPr/>
        </p:nvSpPr>
        <p:spPr>
          <a:xfrm>
            <a:off x="4816440" y="2471760"/>
            <a:ext cx="89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 J /cm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86"/>
          <p:cNvSpPr/>
          <p:nvPr/>
        </p:nvSpPr>
        <p:spPr>
          <a:xfrm>
            <a:off x="4743360" y="2498760"/>
            <a:ext cx="1568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3"/>
          <p:cNvSpPr/>
          <p:nvPr/>
        </p:nvSpPr>
        <p:spPr>
          <a:xfrm>
            <a:off x="5000760" y="2317680"/>
            <a:ext cx="1466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B431542 + PB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15"/>
          <p:cNvSpPr/>
          <p:nvPr/>
        </p:nvSpPr>
        <p:spPr>
          <a:xfrm rot="16200000">
            <a:off x="531720" y="1407600"/>
            <a:ext cx="517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2"/>
          <p:cNvGrpSpPr/>
          <p:nvPr/>
        </p:nvGrpSpPr>
        <p:grpSpPr>
          <a:xfrm>
            <a:off x="1762200" y="4508640"/>
            <a:ext cx="2658960" cy="2205720"/>
            <a:chOff x="1762200" y="4508640"/>
            <a:chExt cx="2658960" cy="2205720"/>
          </a:xfrm>
        </p:grpSpPr>
        <p:grpSp>
          <p:nvGrpSpPr>
            <p:cNvPr id="130" name="Group 2"/>
            <p:cNvGrpSpPr/>
            <p:nvPr/>
          </p:nvGrpSpPr>
          <p:grpSpPr>
            <a:xfrm>
              <a:off x="1762200" y="4508640"/>
              <a:ext cx="2658960" cy="2205720"/>
              <a:chOff x="1762200" y="4508640"/>
              <a:chExt cx="2658960" cy="2205720"/>
            </a:xfrm>
          </p:grpSpPr>
          <p:pic>
            <p:nvPicPr>
              <p:cNvPr id="131" name="Picture 210" descr=""/>
              <p:cNvPicPr/>
              <p:nvPr/>
            </p:nvPicPr>
            <p:blipFill>
              <a:blip r:embed="rId19"/>
              <a:srcRect l="55433" t="11528" r="1798" b="0"/>
              <a:stretch/>
            </p:blipFill>
            <p:spPr>
              <a:xfrm>
                <a:off x="2406960" y="4509720"/>
                <a:ext cx="2014200" cy="187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2" name="Straight Connector 90"/>
              <p:cNvSpPr/>
              <p:nvPr/>
            </p:nvSpPr>
            <p:spPr>
              <a:xfrm>
                <a:off x="3581640" y="5141880"/>
                <a:ext cx="276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Box 47"/>
              <p:cNvSpPr/>
              <p:nvPr/>
            </p:nvSpPr>
            <p:spPr>
              <a:xfrm>
                <a:off x="3594960" y="4944240"/>
                <a:ext cx="3650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Straight Connector 92"/>
              <p:cNvSpPr/>
              <p:nvPr/>
            </p:nvSpPr>
            <p:spPr>
              <a:xfrm>
                <a:off x="3568680" y="4952880"/>
                <a:ext cx="612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TextBox 49"/>
              <p:cNvSpPr/>
              <p:nvPr/>
            </p:nvSpPr>
            <p:spPr>
              <a:xfrm>
                <a:off x="3726000" y="4786560"/>
                <a:ext cx="353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Box 43"/>
              <p:cNvSpPr/>
              <p:nvPr/>
            </p:nvSpPr>
            <p:spPr>
              <a:xfrm>
                <a:off x="3103920" y="4610520"/>
                <a:ext cx="450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 *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Box 1"/>
              <p:cNvSpPr/>
              <p:nvPr/>
            </p:nvSpPr>
            <p:spPr>
              <a:xfrm>
                <a:off x="2114640" y="6254640"/>
                <a:ext cx="229896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BM            -       3 J/cm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15 J/cm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  -        3 J/cm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15 J/cm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br>
                  <a:rPr sz="600"/>
                </a:b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B431542   -           -          -                  +            +            +      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8" name="Picture 210" descr=""/>
              <p:cNvPicPr/>
              <p:nvPr/>
            </p:nvPicPr>
            <p:blipFill>
              <a:blip r:embed="rId20"/>
              <a:srcRect l="0" t="11528" r="84351" b="0"/>
              <a:stretch/>
            </p:blipFill>
            <p:spPr>
              <a:xfrm>
                <a:off x="1762200" y="4508640"/>
                <a:ext cx="736920" cy="18748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39" name="Rectangle 1"/>
            <p:cNvSpPr/>
            <p:nvPr/>
          </p:nvSpPr>
          <p:spPr>
            <a:xfrm>
              <a:off x="2562120" y="5075280"/>
              <a:ext cx="199800" cy="1171440"/>
            </a:xfrm>
            <a:prstGeom prst="rect">
              <a:avLst/>
            </a:prstGeom>
            <a:solidFill>
              <a:srgbClr val="bfbfb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68"/>
            <p:cNvSpPr/>
            <p:nvPr/>
          </p:nvSpPr>
          <p:spPr>
            <a:xfrm>
              <a:off x="3460680" y="5324400"/>
              <a:ext cx="199800" cy="922320"/>
            </a:xfrm>
            <a:prstGeom prst="rect">
              <a:avLst/>
            </a:prstGeom>
            <a:solidFill>
              <a:srgbClr val="bfbfb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TextBox 43"/>
          <p:cNvSpPr/>
          <p:nvPr/>
        </p:nvSpPr>
        <p:spPr>
          <a:xfrm>
            <a:off x="2847960" y="4786200"/>
            <a:ext cx="45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*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TextBox 50"/>
          <p:cNvSpPr/>
          <p:nvPr/>
        </p:nvSpPr>
        <p:spPr>
          <a:xfrm>
            <a:off x="380880" y="83808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50"/>
          <p:cNvSpPr/>
          <p:nvPr/>
        </p:nvSpPr>
        <p:spPr>
          <a:xfrm>
            <a:off x="3935520" y="84600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57"/>
          <p:cNvSpPr/>
          <p:nvPr/>
        </p:nvSpPr>
        <p:spPr>
          <a:xfrm>
            <a:off x="135000" y="590400"/>
            <a:ext cx="212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5" name="Group 11263"/>
          <p:cNvGrpSpPr/>
          <p:nvPr/>
        </p:nvGrpSpPr>
        <p:grpSpPr>
          <a:xfrm>
            <a:off x="374760" y="966960"/>
            <a:ext cx="3462120" cy="3382920"/>
            <a:chOff x="374760" y="966960"/>
            <a:chExt cx="3462120" cy="3382920"/>
          </a:xfrm>
        </p:grpSpPr>
        <p:grpSp>
          <p:nvGrpSpPr>
            <p:cNvPr id="146" name="Group 3"/>
            <p:cNvGrpSpPr/>
            <p:nvPr/>
          </p:nvGrpSpPr>
          <p:grpSpPr>
            <a:xfrm>
              <a:off x="374760" y="966960"/>
              <a:ext cx="3462120" cy="3369240"/>
              <a:chOff x="374760" y="966960"/>
              <a:chExt cx="3462120" cy="3369240"/>
            </a:xfrm>
          </p:grpSpPr>
          <p:pic>
            <p:nvPicPr>
              <p:cNvPr id="147" name="Picture 14" descr=""/>
              <p:cNvPicPr/>
              <p:nvPr/>
            </p:nvPicPr>
            <p:blipFill>
              <a:blip r:embed="rId1"/>
              <a:stretch/>
            </p:blipFill>
            <p:spPr>
              <a:xfrm>
                <a:off x="2867400" y="1926000"/>
                <a:ext cx="969480" cy="7858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48" name="Group 103"/>
              <p:cNvGrpSpPr/>
              <p:nvPr/>
            </p:nvGrpSpPr>
            <p:grpSpPr>
              <a:xfrm>
                <a:off x="374760" y="966960"/>
                <a:ext cx="3462120" cy="3369240"/>
                <a:chOff x="374760" y="966960"/>
                <a:chExt cx="3462120" cy="3369240"/>
              </a:xfrm>
            </p:grpSpPr>
            <p:pic>
              <p:nvPicPr>
                <p:cNvPr id="149" name="Picture 58" descr="C:\Users\Imran\Desktop\Wound repair and regeneration\HOF\unhof1.tif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862200" y="11167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0" name="Picture 85" descr="C:\Users\Imran\Desktop\Wound repair and regeneration\HOF\0.1whof2.tif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862200" y="191340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1" name="TextBox 2"/>
                <p:cNvSpPr/>
                <p:nvPr/>
              </p:nvSpPr>
              <p:spPr>
                <a:xfrm>
                  <a:off x="374760" y="3036240"/>
                  <a:ext cx="601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5 J/cm</a:t>
                  </a:r>
                  <a:r>
                    <a:rPr b="1" lang="en-US" sz="700" spc="-1" strike="noStrike" baseline="30000">
                      <a:solidFill>
                        <a:srgbClr val="000000"/>
                      </a:solidFill>
                      <a:latin typeface="Arial"/>
                      <a:ea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TextBox 87"/>
                <p:cNvSpPr/>
                <p:nvPr/>
              </p:nvSpPr>
              <p:spPr>
                <a:xfrm>
                  <a:off x="408600" y="2226240"/>
                  <a:ext cx="6012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 J/cm</a:t>
                  </a:r>
                  <a:r>
                    <a:rPr b="1" lang="en-US" sz="700" spc="-1" strike="noStrike" baseline="30000">
                      <a:solidFill>
                        <a:srgbClr val="000000"/>
                      </a:solidFill>
                      <a:latin typeface="Arial"/>
                      <a:ea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TextBox 88"/>
                <p:cNvSpPr/>
                <p:nvPr/>
              </p:nvSpPr>
              <p:spPr>
                <a:xfrm>
                  <a:off x="410040" y="1451880"/>
                  <a:ext cx="5306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ntro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54" name="Picture 3" descr="C:\Users\Imran\Desktop\Wound repair and regeneration\HOF\b-0.5whof2.tif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862200" y="273204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5" name="Picture 4" descr="C:\Users\Imran\Desktop\Wound repair and regeneration\HOF\b-1whof1.tif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862200" y="35503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6" name="TextBox 2"/>
                <p:cNvSpPr/>
                <p:nvPr/>
              </p:nvSpPr>
              <p:spPr>
                <a:xfrm>
                  <a:off x="399240" y="3890520"/>
                  <a:ext cx="7038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0 J/cm</a:t>
                  </a:r>
                  <a:r>
                    <a:rPr b="1" lang="en-US" sz="700" spc="-1" strike="noStrike" baseline="30000">
                      <a:solidFill>
                        <a:srgbClr val="000000"/>
                      </a:solidFill>
                      <a:latin typeface="Arial"/>
                      <a:ea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57" name="Picture 5" descr="C:\Users\Imran\Desktop\Wound repair and regeneration\HOF\unhof1-24hrs.tif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1864800" y="11167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8" name="Picture 6" descr="C:\Users\Imran\Desktop\Wound repair and regeneration\HOF\b-0.5whof1.24hrs.tif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1864800" y="273204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9" name="Picture 7" descr="C:\Users\Imran\Desktop\Wound repair and regeneration\HOF\b-1whof4.24hrs.tif"/>
                <p:cNvPicPr/>
                <p:nvPr/>
              </p:nvPicPr>
              <p:blipFill>
                <a:blip r:embed="rId8">
                  <a:lum contrast="72000"/>
                </a:blip>
                <a:stretch/>
              </p:blipFill>
              <p:spPr>
                <a:xfrm>
                  <a:off x="1864800" y="35503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0" name="Picture 8" descr="C:\Users\Imran\Desktop\Wound repair and regeneration\HOF\b-0.1whof3.24hrs.tif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1864800" y="191340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1" name="Picture 10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2867400" y="11167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2" name="Picture 11" descr="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2867400" y="355032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3" name="Picture 13" descr="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2867400" y="2732040"/>
                  <a:ext cx="969480" cy="785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64" name="TextBox 100"/>
                <p:cNvSpPr/>
                <p:nvPr/>
              </p:nvSpPr>
              <p:spPr>
                <a:xfrm>
                  <a:off x="1098720" y="966960"/>
                  <a:ext cx="3909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 hr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TextBox 101"/>
                <p:cNvSpPr/>
                <p:nvPr/>
              </p:nvSpPr>
              <p:spPr>
                <a:xfrm>
                  <a:off x="2109960" y="969480"/>
                  <a:ext cx="439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4 hr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TextBox 102"/>
                <p:cNvSpPr/>
                <p:nvPr/>
              </p:nvSpPr>
              <p:spPr>
                <a:xfrm>
                  <a:off x="3107880" y="969480"/>
                  <a:ext cx="439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48 hrs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67" name="Freeform: Shape 6"/>
            <p:cNvSpPr/>
            <p:nvPr/>
          </p:nvSpPr>
          <p:spPr>
            <a:xfrm>
              <a:off x="1157400" y="1125720"/>
              <a:ext cx="36360" cy="774720"/>
            </a:xfrm>
            <a:custGeom>
              <a:avLst/>
              <a:gdLst/>
              <a:ahLst/>
              <a:rect l="l" t="t" r="r" b="b"/>
              <a:pathLst>
                <a:path w="45293" h="977900">
                  <a:moveTo>
                    <a:pt x="38901" y="0"/>
                  </a:moveTo>
                  <a:cubicBezTo>
                    <a:pt x="39959" y="14287"/>
                    <a:pt x="41018" y="28575"/>
                    <a:pt x="38901" y="69850"/>
                  </a:cubicBezTo>
                  <a:cubicBezTo>
                    <a:pt x="36784" y="111125"/>
                    <a:pt x="25143" y="201083"/>
                    <a:pt x="26201" y="247650"/>
                  </a:cubicBezTo>
                  <a:cubicBezTo>
                    <a:pt x="27259" y="294217"/>
                    <a:pt x="46309" y="313267"/>
                    <a:pt x="45251" y="349250"/>
                  </a:cubicBezTo>
                  <a:cubicBezTo>
                    <a:pt x="44193" y="385233"/>
                    <a:pt x="25143" y="425450"/>
                    <a:pt x="19851" y="463550"/>
                  </a:cubicBezTo>
                  <a:cubicBezTo>
                    <a:pt x="14559" y="501650"/>
                    <a:pt x="16676" y="549275"/>
                    <a:pt x="13501" y="577850"/>
                  </a:cubicBezTo>
                  <a:cubicBezTo>
                    <a:pt x="10326" y="606425"/>
                    <a:pt x="-3432" y="604308"/>
                    <a:pt x="801" y="635000"/>
                  </a:cubicBezTo>
                  <a:cubicBezTo>
                    <a:pt x="5034" y="665692"/>
                    <a:pt x="37843" y="728133"/>
                    <a:pt x="38901" y="762000"/>
                  </a:cubicBezTo>
                  <a:cubicBezTo>
                    <a:pt x="39959" y="795867"/>
                    <a:pt x="12443" y="807508"/>
                    <a:pt x="7151" y="838200"/>
                  </a:cubicBezTo>
                  <a:cubicBezTo>
                    <a:pt x="1859" y="868892"/>
                    <a:pt x="7151" y="946150"/>
                    <a:pt x="7151" y="946150"/>
                  </a:cubicBezTo>
                  <a:lnTo>
                    <a:pt x="7151" y="977900"/>
                  </a:ln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: Shape 7"/>
            <p:cNvSpPr/>
            <p:nvPr/>
          </p:nvSpPr>
          <p:spPr>
            <a:xfrm>
              <a:off x="1423800" y="1116000"/>
              <a:ext cx="37800" cy="788760"/>
            </a:xfrm>
            <a:custGeom>
              <a:avLst/>
              <a:gdLst/>
              <a:ahLst/>
              <a:rect l="l" t="t" r="r" b="b"/>
              <a:pathLst>
                <a:path w="45422" h="996950">
                  <a:moveTo>
                    <a:pt x="6350" y="0"/>
                  </a:moveTo>
                  <a:cubicBezTo>
                    <a:pt x="17462" y="51858"/>
                    <a:pt x="28575" y="103717"/>
                    <a:pt x="31750" y="146050"/>
                  </a:cubicBezTo>
                  <a:cubicBezTo>
                    <a:pt x="34925" y="188383"/>
                    <a:pt x="26458" y="215900"/>
                    <a:pt x="25400" y="254000"/>
                  </a:cubicBezTo>
                  <a:cubicBezTo>
                    <a:pt x="24342" y="292100"/>
                    <a:pt x="22225" y="339725"/>
                    <a:pt x="25400" y="374650"/>
                  </a:cubicBezTo>
                  <a:cubicBezTo>
                    <a:pt x="28575" y="409575"/>
                    <a:pt x="43392" y="434975"/>
                    <a:pt x="44450" y="463550"/>
                  </a:cubicBezTo>
                  <a:cubicBezTo>
                    <a:pt x="45508" y="492125"/>
                    <a:pt x="38100" y="517525"/>
                    <a:pt x="31750" y="546100"/>
                  </a:cubicBezTo>
                  <a:cubicBezTo>
                    <a:pt x="25400" y="574675"/>
                    <a:pt x="10583" y="601133"/>
                    <a:pt x="6350" y="635000"/>
                  </a:cubicBezTo>
                  <a:cubicBezTo>
                    <a:pt x="2117" y="668867"/>
                    <a:pt x="0" y="721783"/>
                    <a:pt x="6350" y="749300"/>
                  </a:cubicBezTo>
                  <a:cubicBezTo>
                    <a:pt x="12700" y="776817"/>
                    <a:pt x="40217" y="779992"/>
                    <a:pt x="44450" y="800100"/>
                  </a:cubicBezTo>
                  <a:cubicBezTo>
                    <a:pt x="48683" y="820208"/>
                    <a:pt x="38100" y="847725"/>
                    <a:pt x="31750" y="869950"/>
                  </a:cubicBezTo>
                  <a:cubicBezTo>
                    <a:pt x="25400" y="892175"/>
                    <a:pt x="9525" y="915458"/>
                    <a:pt x="6350" y="933450"/>
                  </a:cubicBezTo>
                  <a:cubicBezTo>
                    <a:pt x="3175" y="951442"/>
                    <a:pt x="13758" y="967317"/>
                    <a:pt x="12700" y="977900"/>
                  </a:cubicBezTo>
                  <a:cubicBezTo>
                    <a:pt x="11642" y="988483"/>
                    <a:pt x="5821" y="992716"/>
                    <a:pt x="0" y="996950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: Shape 8"/>
            <p:cNvSpPr/>
            <p:nvPr/>
          </p:nvSpPr>
          <p:spPr>
            <a:xfrm>
              <a:off x="2208240" y="1120680"/>
              <a:ext cx="63360" cy="784080"/>
            </a:xfrm>
            <a:custGeom>
              <a:avLst/>
              <a:gdLst/>
              <a:ahLst/>
              <a:rect l="l" t="t" r="r" b="b"/>
              <a:pathLst>
                <a:path w="76434" h="990600">
                  <a:moveTo>
                    <a:pt x="50862" y="0"/>
                  </a:moveTo>
                  <a:cubicBezTo>
                    <a:pt x="53508" y="39158"/>
                    <a:pt x="56154" y="78317"/>
                    <a:pt x="57212" y="114300"/>
                  </a:cubicBezTo>
                  <a:cubicBezTo>
                    <a:pt x="58270" y="150283"/>
                    <a:pt x="54037" y="185208"/>
                    <a:pt x="57212" y="215900"/>
                  </a:cubicBezTo>
                  <a:cubicBezTo>
                    <a:pt x="60387" y="246592"/>
                    <a:pt x="78379" y="271992"/>
                    <a:pt x="76262" y="298450"/>
                  </a:cubicBezTo>
                  <a:cubicBezTo>
                    <a:pt x="74145" y="324908"/>
                    <a:pt x="49804" y="351367"/>
                    <a:pt x="44512" y="374650"/>
                  </a:cubicBezTo>
                  <a:cubicBezTo>
                    <a:pt x="39220" y="397933"/>
                    <a:pt x="48745" y="415925"/>
                    <a:pt x="44512" y="438150"/>
                  </a:cubicBezTo>
                  <a:cubicBezTo>
                    <a:pt x="40279" y="460375"/>
                    <a:pt x="26520" y="480483"/>
                    <a:pt x="19112" y="508000"/>
                  </a:cubicBezTo>
                  <a:cubicBezTo>
                    <a:pt x="11704" y="535517"/>
                    <a:pt x="-996" y="572558"/>
                    <a:pt x="62" y="603250"/>
                  </a:cubicBezTo>
                  <a:cubicBezTo>
                    <a:pt x="1120" y="633942"/>
                    <a:pt x="20170" y="670984"/>
                    <a:pt x="25462" y="692150"/>
                  </a:cubicBezTo>
                  <a:cubicBezTo>
                    <a:pt x="30754" y="713316"/>
                    <a:pt x="30754" y="713317"/>
                    <a:pt x="31812" y="730250"/>
                  </a:cubicBezTo>
                  <a:cubicBezTo>
                    <a:pt x="32870" y="747183"/>
                    <a:pt x="31812" y="793750"/>
                    <a:pt x="31812" y="793750"/>
                  </a:cubicBezTo>
                  <a:cubicBezTo>
                    <a:pt x="31812" y="817033"/>
                    <a:pt x="32870" y="845608"/>
                    <a:pt x="31812" y="869950"/>
                  </a:cubicBezTo>
                  <a:cubicBezTo>
                    <a:pt x="30754" y="894292"/>
                    <a:pt x="26520" y="923925"/>
                    <a:pt x="25462" y="939800"/>
                  </a:cubicBezTo>
                  <a:cubicBezTo>
                    <a:pt x="24404" y="955675"/>
                    <a:pt x="25462" y="965200"/>
                    <a:pt x="25462" y="965200"/>
                  </a:cubicBezTo>
                  <a:cubicBezTo>
                    <a:pt x="27579" y="973667"/>
                    <a:pt x="32870" y="982133"/>
                    <a:pt x="38162" y="990600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: Shape 10"/>
            <p:cNvSpPr/>
            <p:nvPr/>
          </p:nvSpPr>
          <p:spPr>
            <a:xfrm>
              <a:off x="2422440" y="1123920"/>
              <a:ext cx="63360" cy="782640"/>
            </a:xfrm>
            <a:custGeom>
              <a:avLst/>
              <a:gdLst/>
              <a:ahLst/>
              <a:rect l="l" t="t" r="r" b="b"/>
              <a:pathLst>
                <a:path w="75968" h="987936">
                  <a:moveTo>
                    <a:pt x="22399" y="0"/>
                  </a:moveTo>
                  <a:cubicBezTo>
                    <a:pt x="32523" y="30906"/>
                    <a:pt x="42648" y="61813"/>
                    <a:pt x="51174" y="89522"/>
                  </a:cubicBezTo>
                  <a:cubicBezTo>
                    <a:pt x="59700" y="117231"/>
                    <a:pt x="69824" y="142809"/>
                    <a:pt x="73554" y="166255"/>
                  </a:cubicBezTo>
                  <a:cubicBezTo>
                    <a:pt x="77284" y="189701"/>
                    <a:pt x="76218" y="212615"/>
                    <a:pt x="73554" y="230199"/>
                  </a:cubicBezTo>
                  <a:cubicBezTo>
                    <a:pt x="70890" y="247783"/>
                    <a:pt x="63962" y="256309"/>
                    <a:pt x="57568" y="271762"/>
                  </a:cubicBezTo>
                  <a:cubicBezTo>
                    <a:pt x="51174" y="287215"/>
                    <a:pt x="38385" y="302135"/>
                    <a:pt x="35188" y="322917"/>
                  </a:cubicBezTo>
                  <a:cubicBezTo>
                    <a:pt x="31991" y="343699"/>
                    <a:pt x="42648" y="371408"/>
                    <a:pt x="38385" y="396453"/>
                  </a:cubicBezTo>
                  <a:cubicBezTo>
                    <a:pt x="34122" y="421498"/>
                    <a:pt x="12274" y="446010"/>
                    <a:pt x="9610" y="473186"/>
                  </a:cubicBezTo>
                  <a:cubicBezTo>
                    <a:pt x="6946" y="500362"/>
                    <a:pt x="23998" y="533932"/>
                    <a:pt x="22399" y="559510"/>
                  </a:cubicBezTo>
                  <a:cubicBezTo>
                    <a:pt x="20800" y="585088"/>
                    <a:pt x="551" y="601074"/>
                    <a:pt x="18" y="626652"/>
                  </a:cubicBezTo>
                  <a:cubicBezTo>
                    <a:pt x="-515" y="652230"/>
                    <a:pt x="10676" y="686866"/>
                    <a:pt x="19202" y="712976"/>
                  </a:cubicBezTo>
                  <a:cubicBezTo>
                    <a:pt x="27728" y="739086"/>
                    <a:pt x="50641" y="758803"/>
                    <a:pt x="51174" y="783315"/>
                  </a:cubicBezTo>
                  <a:cubicBezTo>
                    <a:pt x="51707" y="807827"/>
                    <a:pt x="29859" y="840865"/>
                    <a:pt x="22399" y="860048"/>
                  </a:cubicBezTo>
                  <a:cubicBezTo>
                    <a:pt x="14939" y="879231"/>
                    <a:pt x="9077" y="882428"/>
                    <a:pt x="6413" y="898414"/>
                  </a:cubicBezTo>
                  <a:cubicBezTo>
                    <a:pt x="3749" y="914400"/>
                    <a:pt x="6413" y="955964"/>
                    <a:pt x="6413" y="955964"/>
                  </a:cubicBezTo>
                  <a:lnTo>
                    <a:pt x="6413" y="987936"/>
                  </a:ln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: Shape 12"/>
            <p:cNvSpPr/>
            <p:nvPr/>
          </p:nvSpPr>
          <p:spPr>
            <a:xfrm>
              <a:off x="3273480" y="1125720"/>
              <a:ext cx="96840" cy="777600"/>
            </a:xfrm>
            <a:custGeom>
              <a:avLst/>
              <a:gdLst/>
              <a:ahLst/>
              <a:rect l="l" t="t" r="r" b="b"/>
              <a:pathLst>
                <a:path w="115341" h="981541">
                  <a:moveTo>
                    <a:pt x="22613" y="0"/>
                  </a:moveTo>
                  <a:cubicBezTo>
                    <a:pt x="32471" y="22380"/>
                    <a:pt x="42329" y="44761"/>
                    <a:pt x="51388" y="67141"/>
                  </a:cubicBezTo>
                  <a:cubicBezTo>
                    <a:pt x="60447" y="89521"/>
                    <a:pt x="77499" y="114567"/>
                    <a:pt x="76966" y="134283"/>
                  </a:cubicBezTo>
                  <a:cubicBezTo>
                    <a:pt x="76433" y="153999"/>
                    <a:pt x="56717" y="172649"/>
                    <a:pt x="48191" y="185438"/>
                  </a:cubicBezTo>
                  <a:cubicBezTo>
                    <a:pt x="39665" y="198227"/>
                    <a:pt x="31139" y="192898"/>
                    <a:pt x="25810" y="211016"/>
                  </a:cubicBezTo>
                  <a:cubicBezTo>
                    <a:pt x="20481" y="229134"/>
                    <a:pt x="12489" y="269631"/>
                    <a:pt x="16219" y="294143"/>
                  </a:cubicBezTo>
                  <a:cubicBezTo>
                    <a:pt x="19949" y="318655"/>
                    <a:pt x="37001" y="336239"/>
                    <a:pt x="48191" y="358087"/>
                  </a:cubicBezTo>
                  <a:cubicBezTo>
                    <a:pt x="59381" y="379935"/>
                    <a:pt x="72170" y="405512"/>
                    <a:pt x="83360" y="425228"/>
                  </a:cubicBezTo>
                  <a:cubicBezTo>
                    <a:pt x="94550" y="444944"/>
                    <a:pt x="115865" y="455068"/>
                    <a:pt x="115332" y="476383"/>
                  </a:cubicBezTo>
                  <a:cubicBezTo>
                    <a:pt x="114799" y="497698"/>
                    <a:pt x="88156" y="531801"/>
                    <a:pt x="80163" y="553116"/>
                  </a:cubicBezTo>
                  <a:cubicBezTo>
                    <a:pt x="72170" y="574431"/>
                    <a:pt x="74301" y="588285"/>
                    <a:pt x="67374" y="604271"/>
                  </a:cubicBezTo>
                  <a:cubicBezTo>
                    <a:pt x="60447" y="620257"/>
                    <a:pt x="46592" y="633046"/>
                    <a:pt x="38599" y="649032"/>
                  </a:cubicBezTo>
                  <a:cubicBezTo>
                    <a:pt x="30606" y="665018"/>
                    <a:pt x="21014" y="679939"/>
                    <a:pt x="19416" y="700188"/>
                  </a:cubicBezTo>
                  <a:cubicBezTo>
                    <a:pt x="17818" y="720437"/>
                    <a:pt x="31140" y="748146"/>
                    <a:pt x="29008" y="770526"/>
                  </a:cubicBezTo>
                  <a:cubicBezTo>
                    <a:pt x="26877" y="792906"/>
                    <a:pt x="11423" y="814754"/>
                    <a:pt x="6627" y="834470"/>
                  </a:cubicBezTo>
                  <a:cubicBezTo>
                    <a:pt x="1831" y="854186"/>
                    <a:pt x="-833" y="873903"/>
                    <a:pt x="233" y="888823"/>
                  </a:cubicBezTo>
                  <a:cubicBezTo>
                    <a:pt x="1299" y="903743"/>
                    <a:pt x="6628" y="912802"/>
                    <a:pt x="13022" y="923992"/>
                  </a:cubicBezTo>
                  <a:cubicBezTo>
                    <a:pt x="19416" y="935182"/>
                    <a:pt x="32205" y="946373"/>
                    <a:pt x="38599" y="955964"/>
                  </a:cubicBezTo>
                  <a:cubicBezTo>
                    <a:pt x="44993" y="965555"/>
                    <a:pt x="48190" y="973548"/>
                    <a:pt x="51388" y="981541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: Shape 13"/>
            <p:cNvSpPr/>
            <p:nvPr/>
          </p:nvSpPr>
          <p:spPr>
            <a:xfrm>
              <a:off x="3429000" y="1117440"/>
              <a:ext cx="80640" cy="782640"/>
            </a:xfrm>
            <a:custGeom>
              <a:avLst/>
              <a:gdLst/>
              <a:ahLst/>
              <a:rect l="l" t="t" r="r" b="b"/>
              <a:pathLst>
                <a:path w="96890" h="987935">
                  <a:moveTo>
                    <a:pt x="22713" y="0"/>
                  </a:moveTo>
                  <a:cubicBezTo>
                    <a:pt x="25910" y="32238"/>
                    <a:pt x="29108" y="64477"/>
                    <a:pt x="32305" y="95916"/>
                  </a:cubicBezTo>
                  <a:cubicBezTo>
                    <a:pt x="35502" y="127355"/>
                    <a:pt x="36035" y="163590"/>
                    <a:pt x="41896" y="188635"/>
                  </a:cubicBezTo>
                  <a:cubicBezTo>
                    <a:pt x="47758" y="213680"/>
                    <a:pt x="68007" y="228067"/>
                    <a:pt x="67474" y="246184"/>
                  </a:cubicBezTo>
                  <a:cubicBezTo>
                    <a:pt x="66941" y="264301"/>
                    <a:pt x="47758" y="279222"/>
                    <a:pt x="38699" y="297339"/>
                  </a:cubicBezTo>
                  <a:cubicBezTo>
                    <a:pt x="29640" y="315457"/>
                    <a:pt x="19515" y="338370"/>
                    <a:pt x="13121" y="354889"/>
                  </a:cubicBezTo>
                  <a:cubicBezTo>
                    <a:pt x="6727" y="371408"/>
                    <a:pt x="-1799" y="377270"/>
                    <a:pt x="333" y="396453"/>
                  </a:cubicBezTo>
                  <a:cubicBezTo>
                    <a:pt x="2464" y="415636"/>
                    <a:pt x="22180" y="453469"/>
                    <a:pt x="25910" y="469988"/>
                  </a:cubicBezTo>
                  <a:cubicBezTo>
                    <a:pt x="29640" y="486507"/>
                    <a:pt x="23779" y="481711"/>
                    <a:pt x="22713" y="495566"/>
                  </a:cubicBezTo>
                  <a:cubicBezTo>
                    <a:pt x="21647" y="509421"/>
                    <a:pt x="15786" y="527538"/>
                    <a:pt x="19516" y="553116"/>
                  </a:cubicBezTo>
                  <a:cubicBezTo>
                    <a:pt x="23246" y="578694"/>
                    <a:pt x="34968" y="625053"/>
                    <a:pt x="45093" y="649032"/>
                  </a:cubicBezTo>
                  <a:cubicBezTo>
                    <a:pt x="55218" y="673011"/>
                    <a:pt x="73336" y="679406"/>
                    <a:pt x="80263" y="696990"/>
                  </a:cubicBezTo>
                  <a:cubicBezTo>
                    <a:pt x="87190" y="714574"/>
                    <a:pt x="84526" y="730027"/>
                    <a:pt x="86657" y="754539"/>
                  </a:cubicBezTo>
                  <a:cubicBezTo>
                    <a:pt x="88788" y="779051"/>
                    <a:pt x="91452" y="820615"/>
                    <a:pt x="93051" y="844061"/>
                  </a:cubicBezTo>
                  <a:cubicBezTo>
                    <a:pt x="94650" y="867507"/>
                    <a:pt x="98380" y="880829"/>
                    <a:pt x="96249" y="895216"/>
                  </a:cubicBezTo>
                  <a:cubicBezTo>
                    <a:pt x="94118" y="909603"/>
                    <a:pt x="82394" y="918130"/>
                    <a:pt x="80263" y="930386"/>
                  </a:cubicBezTo>
                  <a:cubicBezTo>
                    <a:pt x="78132" y="942642"/>
                    <a:pt x="83993" y="959161"/>
                    <a:pt x="83460" y="968752"/>
                  </a:cubicBezTo>
                  <a:cubicBezTo>
                    <a:pt x="82927" y="978343"/>
                    <a:pt x="79996" y="983139"/>
                    <a:pt x="77065" y="987935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: Shape 14"/>
            <p:cNvSpPr/>
            <p:nvPr/>
          </p:nvSpPr>
          <p:spPr>
            <a:xfrm>
              <a:off x="1197000" y="1920960"/>
              <a:ext cx="64800" cy="782640"/>
            </a:xfrm>
            <a:custGeom>
              <a:avLst/>
              <a:gdLst/>
              <a:ahLst/>
              <a:rect l="l" t="t" r="r" b="b"/>
              <a:pathLst>
                <a:path w="76884" h="987936">
                  <a:moveTo>
                    <a:pt x="67154" y="0"/>
                  </a:moveTo>
                  <a:cubicBezTo>
                    <a:pt x="64756" y="20515"/>
                    <a:pt x="62358" y="41031"/>
                    <a:pt x="63957" y="79930"/>
                  </a:cubicBezTo>
                  <a:cubicBezTo>
                    <a:pt x="65556" y="118829"/>
                    <a:pt x="78345" y="202490"/>
                    <a:pt x="76746" y="233396"/>
                  </a:cubicBezTo>
                  <a:cubicBezTo>
                    <a:pt x="75147" y="264302"/>
                    <a:pt x="65022" y="252046"/>
                    <a:pt x="54365" y="265368"/>
                  </a:cubicBezTo>
                  <a:cubicBezTo>
                    <a:pt x="43708" y="278690"/>
                    <a:pt x="15999" y="295742"/>
                    <a:pt x="12802" y="313326"/>
                  </a:cubicBezTo>
                  <a:cubicBezTo>
                    <a:pt x="9605" y="330910"/>
                    <a:pt x="29853" y="351692"/>
                    <a:pt x="35182" y="370875"/>
                  </a:cubicBezTo>
                  <a:cubicBezTo>
                    <a:pt x="40511" y="390058"/>
                    <a:pt x="44774" y="411373"/>
                    <a:pt x="44774" y="428425"/>
                  </a:cubicBezTo>
                  <a:cubicBezTo>
                    <a:pt x="44774" y="445477"/>
                    <a:pt x="38912" y="458799"/>
                    <a:pt x="35182" y="473186"/>
                  </a:cubicBezTo>
                  <a:cubicBezTo>
                    <a:pt x="31452" y="487573"/>
                    <a:pt x="25590" y="497164"/>
                    <a:pt x="22393" y="514749"/>
                  </a:cubicBezTo>
                  <a:cubicBezTo>
                    <a:pt x="19196" y="532334"/>
                    <a:pt x="18130" y="563241"/>
                    <a:pt x="15999" y="578694"/>
                  </a:cubicBezTo>
                  <a:cubicBezTo>
                    <a:pt x="13868" y="594147"/>
                    <a:pt x="11204" y="597344"/>
                    <a:pt x="9605" y="607468"/>
                  </a:cubicBezTo>
                  <a:cubicBezTo>
                    <a:pt x="8006" y="617592"/>
                    <a:pt x="3743" y="625053"/>
                    <a:pt x="6407" y="639440"/>
                  </a:cubicBezTo>
                  <a:cubicBezTo>
                    <a:pt x="9071" y="653827"/>
                    <a:pt x="23460" y="680471"/>
                    <a:pt x="25591" y="693793"/>
                  </a:cubicBezTo>
                  <a:cubicBezTo>
                    <a:pt x="27722" y="707115"/>
                    <a:pt x="23459" y="709246"/>
                    <a:pt x="19196" y="719370"/>
                  </a:cubicBezTo>
                  <a:cubicBezTo>
                    <a:pt x="14933" y="729494"/>
                    <a:pt x="-520" y="731627"/>
                    <a:pt x="13" y="754540"/>
                  </a:cubicBezTo>
                  <a:cubicBezTo>
                    <a:pt x="546" y="777453"/>
                    <a:pt x="17597" y="831805"/>
                    <a:pt x="22393" y="856850"/>
                  </a:cubicBezTo>
                  <a:cubicBezTo>
                    <a:pt x="27189" y="881895"/>
                    <a:pt x="28255" y="890421"/>
                    <a:pt x="28788" y="904808"/>
                  </a:cubicBezTo>
                  <a:cubicBezTo>
                    <a:pt x="29321" y="919195"/>
                    <a:pt x="26657" y="932518"/>
                    <a:pt x="25591" y="943175"/>
                  </a:cubicBezTo>
                  <a:cubicBezTo>
                    <a:pt x="24525" y="953832"/>
                    <a:pt x="22926" y="961292"/>
                    <a:pt x="22393" y="968752"/>
                  </a:cubicBezTo>
                  <a:cubicBezTo>
                    <a:pt x="21860" y="976212"/>
                    <a:pt x="22126" y="982074"/>
                    <a:pt x="22393" y="987936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: Shape 15"/>
            <p:cNvSpPr/>
            <p:nvPr/>
          </p:nvSpPr>
          <p:spPr>
            <a:xfrm>
              <a:off x="1450800" y="1925640"/>
              <a:ext cx="74520" cy="769680"/>
            </a:xfrm>
            <a:custGeom>
              <a:avLst/>
              <a:gdLst/>
              <a:ahLst/>
              <a:rect l="l" t="t" r="r" b="b"/>
              <a:pathLst>
                <a:path w="89391" h="971950">
                  <a:moveTo>
                    <a:pt x="37538" y="0"/>
                  </a:moveTo>
                  <a:cubicBezTo>
                    <a:pt x="39669" y="27709"/>
                    <a:pt x="41801" y="54886"/>
                    <a:pt x="43932" y="83128"/>
                  </a:cubicBezTo>
                  <a:cubicBezTo>
                    <a:pt x="46063" y="111370"/>
                    <a:pt x="47662" y="140677"/>
                    <a:pt x="50326" y="169452"/>
                  </a:cubicBezTo>
                  <a:cubicBezTo>
                    <a:pt x="52990" y="198227"/>
                    <a:pt x="57254" y="230198"/>
                    <a:pt x="59918" y="255776"/>
                  </a:cubicBezTo>
                  <a:cubicBezTo>
                    <a:pt x="62582" y="281354"/>
                    <a:pt x="68976" y="303202"/>
                    <a:pt x="66312" y="322918"/>
                  </a:cubicBezTo>
                  <a:cubicBezTo>
                    <a:pt x="63648" y="342634"/>
                    <a:pt x="44465" y="354890"/>
                    <a:pt x="43932" y="374073"/>
                  </a:cubicBezTo>
                  <a:cubicBezTo>
                    <a:pt x="43399" y="393256"/>
                    <a:pt x="55655" y="418834"/>
                    <a:pt x="63115" y="438017"/>
                  </a:cubicBezTo>
                  <a:cubicBezTo>
                    <a:pt x="70575" y="457200"/>
                    <a:pt x="86029" y="476383"/>
                    <a:pt x="88693" y="489172"/>
                  </a:cubicBezTo>
                  <a:cubicBezTo>
                    <a:pt x="91357" y="501961"/>
                    <a:pt x="86028" y="499297"/>
                    <a:pt x="79101" y="514750"/>
                  </a:cubicBezTo>
                  <a:cubicBezTo>
                    <a:pt x="72174" y="530203"/>
                    <a:pt x="51392" y="558978"/>
                    <a:pt x="47129" y="581891"/>
                  </a:cubicBezTo>
                  <a:cubicBezTo>
                    <a:pt x="42866" y="604804"/>
                    <a:pt x="52991" y="634113"/>
                    <a:pt x="53524" y="652230"/>
                  </a:cubicBezTo>
                  <a:cubicBezTo>
                    <a:pt x="54057" y="670347"/>
                    <a:pt x="53523" y="669814"/>
                    <a:pt x="50326" y="690596"/>
                  </a:cubicBezTo>
                  <a:cubicBezTo>
                    <a:pt x="47129" y="711378"/>
                    <a:pt x="42333" y="757205"/>
                    <a:pt x="34340" y="776921"/>
                  </a:cubicBezTo>
                  <a:cubicBezTo>
                    <a:pt x="26347" y="796637"/>
                    <a:pt x="7697" y="796104"/>
                    <a:pt x="2368" y="808893"/>
                  </a:cubicBezTo>
                  <a:cubicBezTo>
                    <a:pt x="-2961" y="821682"/>
                    <a:pt x="2368" y="853653"/>
                    <a:pt x="2368" y="853653"/>
                  </a:cubicBezTo>
                  <a:cubicBezTo>
                    <a:pt x="2368" y="872836"/>
                    <a:pt x="-296" y="904276"/>
                    <a:pt x="2368" y="923992"/>
                  </a:cubicBezTo>
                  <a:cubicBezTo>
                    <a:pt x="5032" y="943708"/>
                    <a:pt x="11693" y="957829"/>
                    <a:pt x="18354" y="971950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: Shape 16"/>
            <p:cNvSpPr/>
            <p:nvPr/>
          </p:nvSpPr>
          <p:spPr>
            <a:xfrm>
              <a:off x="2241720" y="1936800"/>
              <a:ext cx="69840" cy="761760"/>
            </a:xfrm>
            <a:custGeom>
              <a:avLst/>
              <a:gdLst/>
              <a:ahLst/>
              <a:rect l="l" t="t" r="r" b="b"/>
              <a:pathLst>
                <a:path w="83334" h="963645">
                  <a:moveTo>
                    <a:pt x="54398" y="0"/>
                  </a:moveTo>
                  <a:cubicBezTo>
                    <a:pt x="63457" y="18650"/>
                    <a:pt x="72516" y="37301"/>
                    <a:pt x="73582" y="54353"/>
                  </a:cubicBezTo>
                  <a:cubicBezTo>
                    <a:pt x="74648" y="71405"/>
                    <a:pt x="67720" y="79398"/>
                    <a:pt x="60793" y="102311"/>
                  </a:cubicBezTo>
                  <a:cubicBezTo>
                    <a:pt x="53866" y="125224"/>
                    <a:pt x="42142" y="161992"/>
                    <a:pt x="32018" y="191832"/>
                  </a:cubicBezTo>
                  <a:cubicBezTo>
                    <a:pt x="21894" y="221672"/>
                    <a:pt x="1112" y="257908"/>
                    <a:pt x="46" y="281354"/>
                  </a:cubicBezTo>
                  <a:cubicBezTo>
                    <a:pt x="-1020" y="304800"/>
                    <a:pt x="16565" y="310129"/>
                    <a:pt x="25624" y="332509"/>
                  </a:cubicBezTo>
                  <a:cubicBezTo>
                    <a:pt x="34683" y="354889"/>
                    <a:pt x="52267" y="385263"/>
                    <a:pt x="54398" y="415636"/>
                  </a:cubicBezTo>
                  <a:cubicBezTo>
                    <a:pt x="56529" y="446009"/>
                    <a:pt x="37879" y="486508"/>
                    <a:pt x="38412" y="514750"/>
                  </a:cubicBezTo>
                  <a:cubicBezTo>
                    <a:pt x="38945" y="542992"/>
                    <a:pt x="50669" y="560576"/>
                    <a:pt x="57596" y="585088"/>
                  </a:cubicBezTo>
                  <a:cubicBezTo>
                    <a:pt x="64523" y="609600"/>
                    <a:pt x="79976" y="629316"/>
                    <a:pt x="79976" y="661821"/>
                  </a:cubicBezTo>
                  <a:cubicBezTo>
                    <a:pt x="79976" y="694326"/>
                    <a:pt x="57063" y="747613"/>
                    <a:pt x="57596" y="780118"/>
                  </a:cubicBezTo>
                  <a:cubicBezTo>
                    <a:pt x="58129" y="812623"/>
                    <a:pt x="81575" y="841397"/>
                    <a:pt x="83173" y="856850"/>
                  </a:cubicBezTo>
                  <a:cubicBezTo>
                    <a:pt x="84771" y="872303"/>
                    <a:pt x="74114" y="860047"/>
                    <a:pt x="67187" y="872836"/>
                  </a:cubicBezTo>
                  <a:cubicBezTo>
                    <a:pt x="60260" y="885625"/>
                    <a:pt x="45873" y="918663"/>
                    <a:pt x="41610" y="933583"/>
                  </a:cubicBezTo>
                  <a:cubicBezTo>
                    <a:pt x="37347" y="948503"/>
                    <a:pt x="41077" y="958628"/>
                    <a:pt x="41610" y="962358"/>
                  </a:cubicBezTo>
                  <a:cubicBezTo>
                    <a:pt x="42143" y="966088"/>
                    <a:pt x="43475" y="961026"/>
                    <a:pt x="44807" y="955964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: Shape 17"/>
            <p:cNvSpPr/>
            <p:nvPr/>
          </p:nvSpPr>
          <p:spPr>
            <a:xfrm>
              <a:off x="2419200" y="1936800"/>
              <a:ext cx="37800" cy="750600"/>
            </a:xfrm>
            <a:custGeom>
              <a:avLst/>
              <a:gdLst/>
              <a:ahLst/>
              <a:rect l="l" t="t" r="r" b="b"/>
              <a:pathLst>
                <a:path w="45896" h="949569">
                  <a:moveTo>
                    <a:pt x="13043" y="0"/>
                  </a:moveTo>
                  <a:cubicBezTo>
                    <a:pt x="15174" y="30906"/>
                    <a:pt x="17306" y="61813"/>
                    <a:pt x="22635" y="89522"/>
                  </a:cubicBezTo>
                  <a:cubicBezTo>
                    <a:pt x="27964" y="117231"/>
                    <a:pt x="43417" y="140145"/>
                    <a:pt x="45015" y="166255"/>
                  </a:cubicBezTo>
                  <a:cubicBezTo>
                    <a:pt x="46614" y="192366"/>
                    <a:pt x="38088" y="214746"/>
                    <a:pt x="32226" y="246185"/>
                  </a:cubicBezTo>
                  <a:cubicBezTo>
                    <a:pt x="26365" y="277624"/>
                    <a:pt x="13576" y="326115"/>
                    <a:pt x="9846" y="354890"/>
                  </a:cubicBezTo>
                  <a:cubicBezTo>
                    <a:pt x="6116" y="383665"/>
                    <a:pt x="10379" y="401782"/>
                    <a:pt x="9846" y="418834"/>
                  </a:cubicBezTo>
                  <a:cubicBezTo>
                    <a:pt x="9313" y="435886"/>
                    <a:pt x="8248" y="436951"/>
                    <a:pt x="6649" y="457200"/>
                  </a:cubicBezTo>
                  <a:cubicBezTo>
                    <a:pt x="5050" y="477449"/>
                    <a:pt x="-1344" y="513151"/>
                    <a:pt x="254" y="540327"/>
                  </a:cubicBezTo>
                  <a:cubicBezTo>
                    <a:pt x="1852" y="567503"/>
                    <a:pt x="9845" y="595212"/>
                    <a:pt x="16240" y="620257"/>
                  </a:cubicBezTo>
                  <a:cubicBezTo>
                    <a:pt x="22635" y="645302"/>
                    <a:pt x="37555" y="670880"/>
                    <a:pt x="38621" y="690596"/>
                  </a:cubicBezTo>
                  <a:cubicBezTo>
                    <a:pt x="39687" y="710312"/>
                    <a:pt x="21569" y="717772"/>
                    <a:pt x="22635" y="738554"/>
                  </a:cubicBezTo>
                  <a:cubicBezTo>
                    <a:pt x="23701" y="759336"/>
                    <a:pt x="42351" y="798768"/>
                    <a:pt x="45015" y="815287"/>
                  </a:cubicBezTo>
                  <a:cubicBezTo>
                    <a:pt x="47679" y="831806"/>
                    <a:pt x="43950" y="827543"/>
                    <a:pt x="38621" y="837667"/>
                  </a:cubicBezTo>
                  <a:cubicBezTo>
                    <a:pt x="33292" y="847791"/>
                    <a:pt x="19437" y="857384"/>
                    <a:pt x="13043" y="876034"/>
                  </a:cubicBezTo>
                  <a:cubicBezTo>
                    <a:pt x="6649" y="894684"/>
                    <a:pt x="3451" y="922126"/>
                    <a:pt x="254" y="949569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: Shape 18"/>
            <p:cNvSpPr/>
            <p:nvPr/>
          </p:nvSpPr>
          <p:spPr>
            <a:xfrm>
              <a:off x="3246480" y="2448000"/>
              <a:ext cx="56880" cy="29880"/>
            </a:xfrm>
            <a:custGeom>
              <a:avLst/>
              <a:gdLst/>
              <a:ahLst/>
              <a:rect l="l" t="t" r="r" b="b"/>
              <a:pathLst>
                <a:path w="67345" h="39020">
                  <a:moveTo>
                    <a:pt x="67164" y="35177"/>
                  </a:moveTo>
                  <a:cubicBezTo>
                    <a:pt x="70361" y="29848"/>
                    <a:pt x="30396" y="541"/>
                    <a:pt x="19206" y="8"/>
                  </a:cubicBezTo>
                  <a:cubicBezTo>
                    <a:pt x="8016" y="-525"/>
                    <a:pt x="-510" y="22921"/>
                    <a:pt x="23" y="31980"/>
                  </a:cubicBezTo>
                  <a:cubicBezTo>
                    <a:pt x="556" y="41039"/>
                    <a:pt x="63967" y="40506"/>
                    <a:pt x="67164" y="35177"/>
                  </a:cubicBez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: Shape 19"/>
            <p:cNvSpPr/>
            <p:nvPr/>
          </p:nvSpPr>
          <p:spPr>
            <a:xfrm>
              <a:off x="3265560" y="2619360"/>
              <a:ext cx="109440" cy="61560"/>
            </a:xfrm>
            <a:custGeom>
              <a:avLst/>
              <a:gdLst/>
              <a:ahLst/>
              <a:rect l="l" t="t" r="r" b="b"/>
              <a:pathLst>
                <a:path w="131085" h="76733">
                  <a:moveTo>
                    <a:pt x="105508" y="0"/>
                  </a:moveTo>
                  <a:lnTo>
                    <a:pt x="70339" y="0"/>
                  </a:lnTo>
                  <a:cubicBezTo>
                    <a:pt x="30924" y="3583"/>
                    <a:pt x="46941" y="3197"/>
                    <a:pt x="22381" y="3197"/>
                  </a:cubicBezTo>
                  <a:lnTo>
                    <a:pt x="0" y="15986"/>
                  </a:lnTo>
                  <a:lnTo>
                    <a:pt x="73536" y="41563"/>
                  </a:lnTo>
                  <a:lnTo>
                    <a:pt x="102311" y="67141"/>
                  </a:lnTo>
                  <a:lnTo>
                    <a:pt x="131085" y="76733"/>
                  </a:lnTo>
                  <a:lnTo>
                    <a:pt x="105508" y="0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Freeform: Shape 20"/>
            <p:cNvSpPr/>
            <p:nvPr/>
          </p:nvSpPr>
          <p:spPr>
            <a:xfrm>
              <a:off x="3394080" y="2575080"/>
              <a:ext cx="66600" cy="72720"/>
            </a:xfrm>
            <a:custGeom>
              <a:avLst/>
              <a:gdLst/>
              <a:ahLst/>
              <a:rect l="l" t="t" r="r" b="b"/>
              <a:pathLst>
                <a:path w="79930" h="92719">
                  <a:moveTo>
                    <a:pt x="79930" y="47958"/>
                  </a:moveTo>
                  <a:lnTo>
                    <a:pt x="57550" y="15986"/>
                  </a:lnTo>
                  <a:lnTo>
                    <a:pt x="41564" y="0"/>
                  </a:lnTo>
                  <a:lnTo>
                    <a:pt x="12789" y="0"/>
                  </a:lnTo>
                  <a:lnTo>
                    <a:pt x="9592" y="19183"/>
                  </a:lnTo>
                  <a:lnTo>
                    <a:pt x="3197" y="67141"/>
                  </a:lnTo>
                  <a:lnTo>
                    <a:pt x="0" y="92719"/>
                  </a:lnTo>
                  <a:lnTo>
                    <a:pt x="79930" y="47958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: Shape 21"/>
            <p:cNvSpPr/>
            <p:nvPr/>
          </p:nvSpPr>
          <p:spPr>
            <a:xfrm>
              <a:off x="3278160" y="2490840"/>
              <a:ext cx="115560" cy="80640"/>
            </a:xfrm>
            <a:custGeom>
              <a:avLst/>
              <a:gdLst/>
              <a:ahLst/>
              <a:rect l="l" t="t" r="r" b="b"/>
              <a:pathLst>
                <a:path w="137480" h="102311">
                  <a:moveTo>
                    <a:pt x="137480" y="67142"/>
                  </a:moveTo>
                  <a:lnTo>
                    <a:pt x="89522" y="67142"/>
                  </a:lnTo>
                  <a:lnTo>
                    <a:pt x="67141" y="67142"/>
                  </a:lnTo>
                  <a:lnTo>
                    <a:pt x="41564" y="25578"/>
                  </a:lnTo>
                  <a:lnTo>
                    <a:pt x="9592" y="0"/>
                  </a:lnTo>
                  <a:lnTo>
                    <a:pt x="0" y="47959"/>
                  </a:lnTo>
                  <a:lnTo>
                    <a:pt x="38367" y="83128"/>
                  </a:lnTo>
                  <a:lnTo>
                    <a:pt x="63944" y="102311"/>
                  </a:lnTo>
                  <a:lnTo>
                    <a:pt x="63944" y="102311"/>
                  </a:lnTo>
                  <a:lnTo>
                    <a:pt x="137480" y="67142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: Shape 22"/>
            <p:cNvSpPr/>
            <p:nvPr/>
          </p:nvSpPr>
          <p:spPr>
            <a:xfrm>
              <a:off x="3254400" y="2579760"/>
              <a:ext cx="64800" cy="21960"/>
            </a:xfrm>
            <a:custGeom>
              <a:avLst/>
              <a:gdLst/>
              <a:ahLst/>
              <a:rect l="l" t="t" r="r" b="b"/>
              <a:pathLst>
                <a:path w="76733" h="28774">
                  <a:moveTo>
                    <a:pt x="76733" y="15986"/>
                  </a:moveTo>
                  <a:lnTo>
                    <a:pt x="3198" y="0"/>
                  </a:lnTo>
                  <a:lnTo>
                    <a:pt x="0" y="28774"/>
                  </a:lnTo>
                  <a:lnTo>
                    <a:pt x="76733" y="15986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: Shape 23"/>
            <p:cNvSpPr/>
            <p:nvPr/>
          </p:nvSpPr>
          <p:spPr>
            <a:xfrm>
              <a:off x="3265560" y="2651400"/>
              <a:ext cx="42840" cy="34920"/>
            </a:xfrm>
            <a:custGeom>
              <a:avLst/>
              <a:gdLst/>
              <a:ahLst/>
              <a:rect l="l" t="t" r="r" b="b"/>
              <a:pathLst>
                <a:path w="51155" h="44761">
                  <a:moveTo>
                    <a:pt x="-14381" y="12789"/>
                  </a:moveTo>
                  <a:lnTo>
                    <a:pt x="3197" y="0"/>
                  </a:lnTo>
                  <a:lnTo>
                    <a:pt x="0" y="-20775"/>
                  </a:lnTo>
                  <a:lnTo>
                    <a:pt x="-14381" y="12789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: Shape 24"/>
            <p:cNvSpPr/>
            <p:nvPr/>
          </p:nvSpPr>
          <p:spPr>
            <a:xfrm>
              <a:off x="1236600" y="2737080"/>
              <a:ext cx="45720" cy="777600"/>
            </a:xfrm>
            <a:custGeom>
              <a:avLst/>
              <a:gdLst/>
              <a:ahLst/>
              <a:rect l="l" t="t" r="r" b="b"/>
              <a:pathLst>
                <a:path w="54595" h="981542">
                  <a:moveTo>
                    <a:pt x="48097" y="0"/>
                  </a:moveTo>
                  <a:cubicBezTo>
                    <a:pt x="36107" y="19449"/>
                    <a:pt x="24118" y="38899"/>
                    <a:pt x="22519" y="63944"/>
                  </a:cubicBezTo>
                  <a:cubicBezTo>
                    <a:pt x="20920" y="88989"/>
                    <a:pt x="34242" y="121494"/>
                    <a:pt x="38505" y="150269"/>
                  </a:cubicBezTo>
                  <a:cubicBezTo>
                    <a:pt x="42768" y="179044"/>
                    <a:pt x="51294" y="213147"/>
                    <a:pt x="48097" y="236593"/>
                  </a:cubicBezTo>
                  <a:cubicBezTo>
                    <a:pt x="44900" y="260039"/>
                    <a:pt x="26782" y="268566"/>
                    <a:pt x="19322" y="290946"/>
                  </a:cubicBezTo>
                  <a:cubicBezTo>
                    <a:pt x="11862" y="313326"/>
                    <a:pt x="2270" y="346364"/>
                    <a:pt x="3336" y="370876"/>
                  </a:cubicBezTo>
                  <a:cubicBezTo>
                    <a:pt x="4402" y="395388"/>
                    <a:pt x="24651" y="416702"/>
                    <a:pt x="25717" y="438017"/>
                  </a:cubicBezTo>
                  <a:cubicBezTo>
                    <a:pt x="26783" y="459332"/>
                    <a:pt x="10264" y="475851"/>
                    <a:pt x="9731" y="498764"/>
                  </a:cubicBezTo>
                  <a:cubicBezTo>
                    <a:pt x="9198" y="521677"/>
                    <a:pt x="24118" y="548321"/>
                    <a:pt x="22519" y="575497"/>
                  </a:cubicBezTo>
                  <a:cubicBezTo>
                    <a:pt x="20920" y="602673"/>
                    <a:pt x="-1992" y="630915"/>
                    <a:pt x="139" y="661821"/>
                  </a:cubicBezTo>
                  <a:cubicBezTo>
                    <a:pt x="2270" y="692727"/>
                    <a:pt x="27848" y="725766"/>
                    <a:pt x="35308" y="760935"/>
                  </a:cubicBezTo>
                  <a:cubicBezTo>
                    <a:pt x="42768" y="796104"/>
                    <a:pt x="41703" y="844062"/>
                    <a:pt x="44900" y="872837"/>
                  </a:cubicBezTo>
                  <a:cubicBezTo>
                    <a:pt x="48097" y="901612"/>
                    <a:pt x="55558" y="915467"/>
                    <a:pt x="54492" y="933584"/>
                  </a:cubicBezTo>
                  <a:cubicBezTo>
                    <a:pt x="53426" y="951701"/>
                    <a:pt x="45965" y="966621"/>
                    <a:pt x="38505" y="981542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: Shape 25"/>
            <p:cNvSpPr/>
            <p:nvPr/>
          </p:nvSpPr>
          <p:spPr>
            <a:xfrm>
              <a:off x="1460520" y="2737080"/>
              <a:ext cx="47520" cy="782640"/>
            </a:xfrm>
            <a:custGeom>
              <a:avLst/>
              <a:gdLst/>
              <a:ahLst/>
              <a:rect l="l" t="t" r="r" b="b"/>
              <a:pathLst>
                <a:path w="58153" h="987936">
                  <a:moveTo>
                    <a:pt x="54955" y="0"/>
                  </a:moveTo>
                  <a:cubicBezTo>
                    <a:pt x="42699" y="16519"/>
                    <a:pt x="30444" y="33038"/>
                    <a:pt x="26181" y="54353"/>
                  </a:cubicBezTo>
                  <a:cubicBezTo>
                    <a:pt x="21918" y="75668"/>
                    <a:pt x="29911" y="108172"/>
                    <a:pt x="29378" y="127888"/>
                  </a:cubicBezTo>
                  <a:cubicBezTo>
                    <a:pt x="28845" y="147604"/>
                    <a:pt x="25114" y="152400"/>
                    <a:pt x="22983" y="172649"/>
                  </a:cubicBezTo>
                  <a:cubicBezTo>
                    <a:pt x="20852" y="192898"/>
                    <a:pt x="13925" y="227001"/>
                    <a:pt x="16589" y="249382"/>
                  </a:cubicBezTo>
                  <a:cubicBezTo>
                    <a:pt x="19253" y="271763"/>
                    <a:pt x="35239" y="285617"/>
                    <a:pt x="38969" y="306932"/>
                  </a:cubicBezTo>
                  <a:cubicBezTo>
                    <a:pt x="42699" y="328247"/>
                    <a:pt x="44830" y="345831"/>
                    <a:pt x="38969" y="377270"/>
                  </a:cubicBezTo>
                  <a:cubicBezTo>
                    <a:pt x="33107" y="408709"/>
                    <a:pt x="10194" y="464661"/>
                    <a:pt x="3800" y="495567"/>
                  </a:cubicBezTo>
                  <a:cubicBezTo>
                    <a:pt x="-2594" y="526473"/>
                    <a:pt x="1136" y="537130"/>
                    <a:pt x="603" y="562708"/>
                  </a:cubicBezTo>
                  <a:cubicBezTo>
                    <a:pt x="70" y="588286"/>
                    <a:pt x="70" y="620791"/>
                    <a:pt x="603" y="649033"/>
                  </a:cubicBezTo>
                  <a:cubicBezTo>
                    <a:pt x="1136" y="677275"/>
                    <a:pt x="3267" y="710313"/>
                    <a:pt x="3800" y="732160"/>
                  </a:cubicBezTo>
                  <a:cubicBezTo>
                    <a:pt x="4333" y="754007"/>
                    <a:pt x="2201" y="759869"/>
                    <a:pt x="3800" y="780118"/>
                  </a:cubicBezTo>
                  <a:cubicBezTo>
                    <a:pt x="5399" y="800367"/>
                    <a:pt x="11260" y="828609"/>
                    <a:pt x="13392" y="853654"/>
                  </a:cubicBezTo>
                  <a:cubicBezTo>
                    <a:pt x="15523" y="878699"/>
                    <a:pt x="9129" y="908006"/>
                    <a:pt x="16589" y="930386"/>
                  </a:cubicBezTo>
                  <a:cubicBezTo>
                    <a:pt x="24049" y="952766"/>
                    <a:pt x="41101" y="970351"/>
                    <a:pt x="58153" y="987936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: Shape 26"/>
            <p:cNvSpPr/>
            <p:nvPr/>
          </p:nvSpPr>
          <p:spPr>
            <a:xfrm>
              <a:off x="2222640" y="2733840"/>
              <a:ext cx="52200" cy="780840"/>
            </a:xfrm>
            <a:custGeom>
              <a:avLst/>
              <a:gdLst/>
              <a:ahLst/>
              <a:rect l="l" t="t" r="r" b="b"/>
              <a:pathLst>
                <a:path w="60671" h="984739">
                  <a:moveTo>
                    <a:pt x="38245" y="0"/>
                  </a:moveTo>
                  <a:cubicBezTo>
                    <a:pt x="39577" y="25311"/>
                    <a:pt x="40909" y="50623"/>
                    <a:pt x="41442" y="73536"/>
                  </a:cubicBezTo>
                  <a:cubicBezTo>
                    <a:pt x="41975" y="96449"/>
                    <a:pt x="41975" y="111370"/>
                    <a:pt x="41442" y="137480"/>
                  </a:cubicBezTo>
                  <a:cubicBezTo>
                    <a:pt x="40909" y="163590"/>
                    <a:pt x="37712" y="197694"/>
                    <a:pt x="38245" y="230199"/>
                  </a:cubicBezTo>
                  <a:cubicBezTo>
                    <a:pt x="38778" y="262704"/>
                    <a:pt x="44106" y="302136"/>
                    <a:pt x="44639" y="332509"/>
                  </a:cubicBezTo>
                  <a:cubicBezTo>
                    <a:pt x="45172" y="362882"/>
                    <a:pt x="38778" y="387394"/>
                    <a:pt x="41442" y="412439"/>
                  </a:cubicBezTo>
                  <a:cubicBezTo>
                    <a:pt x="44106" y="437484"/>
                    <a:pt x="61691" y="460930"/>
                    <a:pt x="60625" y="482778"/>
                  </a:cubicBezTo>
                  <a:cubicBezTo>
                    <a:pt x="59559" y="504626"/>
                    <a:pt x="39844" y="519013"/>
                    <a:pt x="35048" y="543525"/>
                  </a:cubicBezTo>
                  <a:cubicBezTo>
                    <a:pt x="30252" y="568037"/>
                    <a:pt x="31318" y="604804"/>
                    <a:pt x="31851" y="629849"/>
                  </a:cubicBezTo>
                  <a:cubicBezTo>
                    <a:pt x="32384" y="654894"/>
                    <a:pt x="37712" y="671413"/>
                    <a:pt x="38245" y="693793"/>
                  </a:cubicBezTo>
                  <a:cubicBezTo>
                    <a:pt x="38778" y="716173"/>
                    <a:pt x="40910" y="741751"/>
                    <a:pt x="35048" y="764132"/>
                  </a:cubicBezTo>
                  <a:cubicBezTo>
                    <a:pt x="29186" y="786513"/>
                    <a:pt x="8405" y="807827"/>
                    <a:pt x="3076" y="828076"/>
                  </a:cubicBezTo>
                  <a:cubicBezTo>
                    <a:pt x="-2253" y="848325"/>
                    <a:pt x="412" y="864843"/>
                    <a:pt x="3076" y="885625"/>
                  </a:cubicBezTo>
                  <a:cubicBezTo>
                    <a:pt x="5740" y="906407"/>
                    <a:pt x="15865" y="936248"/>
                    <a:pt x="19062" y="952767"/>
                  </a:cubicBezTo>
                  <a:cubicBezTo>
                    <a:pt x="22259" y="969286"/>
                    <a:pt x="22259" y="977012"/>
                    <a:pt x="22259" y="984739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: Shape 27"/>
            <p:cNvSpPr/>
            <p:nvPr/>
          </p:nvSpPr>
          <p:spPr>
            <a:xfrm>
              <a:off x="2357280" y="2745000"/>
              <a:ext cx="64800" cy="776160"/>
            </a:xfrm>
            <a:custGeom>
              <a:avLst/>
              <a:gdLst/>
              <a:ahLst/>
              <a:rect l="l" t="t" r="r" b="b"/>
              <a:pathLst>
                <a:path w="77433" h="981541">
                  <a:moveTo>
                    <a:pt x="67745" y="0"/>
                  </a:moveTo>
                  <a:cubicBezTo>
                    <a:pt x="72274" y="22913"/>
                    <a:pt x="76803" y="45827"/>
                    <a:pt x="77336" y="63944"/>
                  </a:cubicBezTo>
                  <a:cubicBezTo>
                    <a:pt x="77869" y="82061"/>
                    <a:pt x="76271" y="94851"/>
                    <a:pt x="70942" y="108705"/>
                  </a:cubicBezTo>
                  <a:cubicBezTo>
                    <a:pt x="65613" y="122559"/>
                    <a:pt x="52291" y="131085"/>
                    <a:pt x="45364" y="147071"/>
                  </a:cubicBezTo>
                  <a:cubicBezTo>
                    <a:pt x="38437" y="163057"/>
                    <a:pt x="30976" y="187569"/>
                    <a:pt x="29378" y="204621"/>
                  </a:cubicBezTo>
                  <a:cubicBezTo>
                    <a:pt x="27780" y="221673"/>
                    <a:pt x="28313" y="226469"/>
                    <a:pt x="35773" y="249382"/>
                  </a:cubicBezTo>
                  <a:cubicBezTo>
                    <a:pt x="43233" y="272295"/>
                    <a:pt x="67745" y="325049"/>
                    <a:pt x="74139" y="342101"/>
                  </a:cubicBezTo>
                  <a:cubicBezTo>
                    <a:pt x="80533" y="359153"/>
                    <a:pt x="74672" y="330910"/>
                    <a:pt x="74139" y="351692"/>
                  </a:cubicBezTo>
                  <a:cubicBezTo>
                    <a:pt x="73606" y="372474"/>
                    <a:pt x="75738" y="437484"/>
                    <a:pt x="70942" y="466792"/>
                  </a:cubicBezTo>
                  <a:cubicBezTo>
                    <a:pt x="66146" y="496100"/>
                    <a:pt x="53357" y="511552"/>
                    <a:pt x="45364" y="527538"/>
                  </a:cubicBezTo>
                  <a:cubicBezTo>
                    <a:pt x="37371" y="543524"/>
                    <a:pt x="28313" y="551518"/>
                    <a:pt x="22984" y="562708"/>
                  </a:cubicBezTo>
                  <a:cubicBezTo>
                    <a:pt x="17655" y="573898"/>
                    <a:pt x="14458" y="577628"/>
                    <a:pt x="13392" y="594680"/>
                  </a:cubicBezTo>
                  <a:cubicBezTo>
                    <a:pt x="12326" y="611732"/>
                    <a:pt x="15524" y="650098"/>
                    <a:pt x="16590" y="665018"/>
                  </a:cubicBezTo>
                  <a:cubicBezTo>
                    <a:pt x="17656" y="679938"/>
                    <a:pt x="15524" y="670347"/>
                    <a:pt x="19787" y="684201"/>
                  </a:cubicBezTo>
                  <a:cubicBezTo>
                    <a:pt x="24050" y="698055"/>
                    <a:pt x="35773" y="727896"/>
                    <a:pt x="42167" y="748145"/>
                  </a:cubicBezTo>
                  <a:cubicBezTo>
                    <a:pt x="48561" y="768394"/>
                    <a:pt x="57087" y="787578"/>
                    <a:pt x="58153" y="805695"/>
                  </a:cubicBezTo>
                  <a:cubicBezTo>
                    <a:pt x="59219" y="823812"/>
                    <a:pt x="51759" y="841930"/>
                    <a:pt x="48562" y="856850"/>
                  </a:cubicBezTo>
                  <a:cubicBezTo>
                    <a:pt x="45365" y="871770"/>
                    <a:pt x="42167" y="884027"/>
                    <a:pt x="38970" y="895217"/>
                  </a:cubicBezTo>
                  <a:cubicBezTo>
                    <a:pt x="35773" y="906407"/>
                    <a:pt x="35240" y="913335"/>
                    <a:pt x="29378" y="923992"/>
                  </a:cubicBezTo>
                  <a:cubicBezTo>
                    <a:pt x="23516" y="934649"/>
                    <a:pt x="8597" y="949570"/>
                    <a:pt x="3801" y="959161"/>
                  </a:cubicBezTo>
                  <a:cubicBezTo>
                    <a:pt x="-995" y="968752"/>
                    <a:pt x="-196" y="975146"/>
                    <a:pt x="604" y="981541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: Shape 28"/>
            <p:cNvSpPr/>
            <p:nvPr/>
          </p:nvSpPr>
          <p:spPr>
            <a:xfrm>
              <a:off x="3332160" y="3329280"/>
              <a:ext cx="42840" cy="66600"/>
            </a:xfrm>
            <a:custGeom>
              <a:avLst/>
              <a:gdLst/>
              <a:ahLst/>
              <a:rect l="l" t="t" r="r" b="b"/>
              <a:pathLst>
                <a:path w="51155" h="83127">
                  <a:moveTo>
                    <a:pt x="28775" y="83127"/>
                  </a:moveTo>
                  <a:lnTo>
                    <a:pt x="51155" y="47958"/>
                  </a:lnTo>
                  <a:lnTo>
                    <a:pt x="25578" y="0"/>
                  </a:lnTo>
                  <a:lnTo>
                    <a:pt x="0" y="9591"/>
                  </a:lnTo>
                  <a:lnTo>
                    <a:pt x="28775" y="83127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: Shape 29"/>
            <p:cNvSpPr/>
            <p:nvPr/>
          </p:nvSpPr>
          <p:spPr>
            <a:xfrm>
              <a:off x="3371760" y="3448440"/>
              <a:ext cx="41040" cy="4680"/>
            </a:xfrm>
            <a:custGeom>
              <a:avLst/>
              <a:gdLst/>
              <a:ahLst/>
              <a:rect l="l" t="t" r="r" b="b"/>
              <a:pathLst>
                <a:path w="47958" h="6395">
                  <a:moveTo>
                    <a:pt x="-17578" y="6395"/>
                  </a:moveTo>
                  <a:lnTo>
                    <a:pt x="0" y="0"/>
                  </a:lnTo>
                  <a:lnTo>
                    <a:pt x="-17578" y="6395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: Shape 32"/>
            <p:cNvSpPr/>
            <p:nvPr/>
          </p:nvSpPr>
          <p:spPr>
            <a:xfrm>
              <a:off x="3232080" y="3364200"/>
              <a:ext cx="9360" cy="18720"/>
            </a:xfrm>
            <a:custGeom>
              <a:avLst/>
              <a:gdLst/>
              <a:ahLst/>
              <a:rect l="l" t="t" r="r" b="b"/>
              <a:pathLst>
                <a:path w="9591" h="22380">
                  <a:moveTo>
                    <a:pt x="9591" y="22380"/>
                  </a:moveTo>
                  <a:lnTo>
                    <a:pt x="0" y="0"/>
                  </a:lnTo>
                  <a:lnTo>
                    <a:pt x="9591" y="22380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: Shape 55"/>
            <p:cNvSpPr/>
            <p:nvPr/>
          </p:nvSpPr>
          <p:spPr>
            <a:xfrm>
              <a:off x="1208160" y="3559320"/>
              <a:ext cx="29880" cy="777600"/>
            </a:xfrm>
            <a:custGeom>
              <a:avLst/>
              <a:gdLst/>
              <a:ahLst/>
              <a:rect l="l" t="t" r="r" b="b"/>
              <a:pathLst>
                <a:path w="35793" h="981542">
                  <a:moveTo>
                    <a:pt x="25651" y="0"/>
                  </a:moveTo>
                  <a:cubicBezTo>
                    <a:pt x="18990" y="30640"/>
                    <a:pt x="12330" y="61280"/>
                    <a:pt x="12863" y="86325"/>
                  </a:cubicBezTo>
                  <a:cubicBezTo>
                    <a:pt x="13396" y="111370"/>
                    <a:pt x="27783" y="117764"/>
                    <a:pt x="28849" y="150269"/>
                  </a:cubicBezTo>
                  <a:cubicBezTo>
                    <a:pt x="29915" y="182774"/>
                    <a:pt x="24053" y="247783"/>
                    <a:pt x="19257" y="281354"/>
                  </a:cubicBezTo>
                  <a:cubicBezTo>
                    <a:pt x="14461" y="314925"/>
                    <a:pt x="1140" y="330378"/>
                    <a:pt x="74" y="351693"/>
                  </a:cubicBezTo>
                  <a:cubicBezTo>
                    <a:pt x="-992" y="373008"/>
                    <a:pt x="9666" y="378869"/>
                    <a:pt x="12863" y="409242"/>
                  </a:cubicBezTo>
                  <a:cubicBezTo>
                    <a:pt x="16060" y="439615"/>
                    <a:pt x="16060" y="502494"/>
                    <a:pt x="19257" y="533933"/>
                  </a:cubicBezTo>
                  <a:cubicBezTo>
                    <a:pt x="22454" y="565372"/>
                    <a:pt x="29382" y="569635"/>
                    <a:pt x="32046" y="597877"/>
                  </a:cubicBezTo>
                  <a:cubicBezTo>
                    <a:pt x="34710" y="626119"/>
                    <a:pt x="36842" y="675676"/>
                    <a:pt x="35243" y="703385"/>
                  </a:cubicBezTo>
                  <a:cubicBezTo>
                    <a:pt x="33644" y="731094"/>
                    <a:pt x="26717" y="742817"/>
                    <a:pt x="22454" y="764132"/>
                  </a:cubicBezTo>
                  <a:cubicBezTo>
                    <a:pt x="18191" y="785447"/>
                    <a:pt x="9665" y="807294"/>
                    <a:pt x="9665" y="831273"/>
                  </a:cubicBezTo>
                  <a:cubicBezTo>
                    <a:pt x="9665" y="855252"/>
                    <a:pt x="20323" y="884560"/>
                    <a:pt x="22454" y="908006"/>
                  </a:cubicBezTo>
                  <a:cubicBezTo>
                    <a:pt x="24585" y="931452"/>
                    <a:pt x="22454" y="971950"/>
                    <a:pt x="22454" y="971950"/>
                  </a:cubicBezTo>
                  <a:lnTo>
                    <a:pt x="22454" y="981542"/>
                  </a:ln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: Shape 56"/>
            <p:cNvSpPr/>
            <p:nvPr/>
          </p:nvSpPr>
          <p:spPr>
            <a:xfrm>
              <a:off x="1414440" y="3562560"/>
              <a:ext cx="52200" cy="787320"/>
            </a:xfrm>
            <a:custGeom>
              <a:avLst/>
              <a:gdLst/>
              <a:ahLst/>
              <a:rect l="l" t="t" r="r" b="b"/>
              <a:pathLst>
                <a:path w="61297" h="994331">
                  <a:moveTo>
                    <a:pt x="0" y="0"/>
                  </a:moveTo>
                  <a:cubicBezTo>
                    <a:pt x="5329" y="37567"/>
                    <a:pt x="10658" y="75134"/>
                    <a:pt x="12789" y="108705"/>
                  </a:cubicBezTo>
                  <a:cubicBezTo>
                    <a:pt x="14920" y="142276"/>
                    <a:pt x="10125" y="171051"/>
                    <a:pt x="12789" y="201424"/>
                  </a:cubicBezTo>
                  <a:cubicBezTo>
                    <a:pt x="15453" y="231797"/>
                    <a:pt x="27709" y="265901"/>
                    <a:pt x="28775" y="290946"/>
                  </a:cubicBezTo>
                  <a:cubicBezTo>
                    <a:pt x="29841" y="315991"/>
                    <a:pt x="23447" y="332510"/>
                    <a:pt x="19184" y="351693"/>
                  </a:cubicBezTo>
                  <a:cubicBezTo>
                    <a:pt x="14921" y="370876"/>
                    <a:pt x="4264" y="378869"/>
                    <a:pt x="3198" y="406045"/>
                  </a:cubicBezTo>
                  <a:cubicBezTo>
                    <a:pt x="2132" y="433221"/>
                    <a:pt x="9059" y="484377"/>
                    <a:pt x="12789" y="514750"/>
                  </a:cubicBezTo>
                  <a:cubicBezTo>
                    <a:pt x="16519" y="545124"/>
                    <a:pt x="23447" y="563241"/>
                    <a:pt x="25578" y="588286"/>
                  </a:cubicBezTo>
                  <a:cubicBezTo>
                    <a:pt x="27710" y="613331"/>
                    <a:pt x="21848" y="646369"/>
                    <a:pt x="25578" y="665019"/>
                  </a:cubicBezTo>
                  <a:cubicBezTo>
                    <a:pt x="29308" y="683669"/>
                    <a:pt x="42097" y="681538"/>
                    <a:pt x="47958" y="700188"/>
                  </a:cubicBezTo>
                  <a:cubicBezTo>
                    <a:pt x="53820" y="718838"/>
                    <a:pt x="59148" y="747613"/>
                    <a:pt x="60747" y="776921"/>
                  </a:cubicBezTo>
                  <a:cubicBezTo>
                    <a:pt x="62346" y="806229"/>
                    <a:pt x="60214" y="845661"/>
                    <a:pt x="57550" y="876034"/>
                  </a:cubicBezTo>
                  <a:cubicBezTo>
                    <a:pt x="54886" y="906407"/>
                    <a:pt x="45294" y="939445"/>
                    <a:pt x="44761" y="959161"/>
                  </a:cubicBezTo>
                  <a:cubicBezTo>
                    <a:pt x="44228" y="978877"/>
                    <a:pt x="49290" y="986604"/>
                    <a:pt x="54353" y="994331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: Shape 57"/>
            <p:cNvSpPr/>
            <p:nvPr/>
          </p:nvSpPr>
          <p:spPr>
            <a:xfrm>
              <a:off x="2222640" y="3562560"/>
              <a:ext cx="44280" cy="782640"/>
            </a:xfrm>
            <a:custGeom>
              <a:avLst/>
              <a:gdLst/>
              <a:ahLst/>
              <a:rect l="l" t="t" r="r" b="b"/>
              <a:pathLst>
                <a:path w="52781" h="987936">
                  <a:moveTo>
                    <a:pt x="19851" y="0"/>
                  </a:moveTo>
                  <a:cubicBezTo>
                    <a:pt x="28376" y="40498"/>
                    <a:pt x="36902" y="80997"/>
                    <a:pt x="42231" y="111903"/>
                  </a:cubicBezTo>
                  <a:cubicBezTo>
                    <a:pt x="47560" y="142809"/>
                    <a:pt x="55553" y="161992"/>
                    <a:pt x="51823" y="185438"/>
                  </a:cubicBezTo>
                  <a:cubicBezTo>
                    <a:pt x="48093" y="208884"/>
                    <a:pt x="21982" y="219008"/>
                    <a:pt x="19851" y="252579"/>
                  </a:cubicBezTo>
                  <a:cubicBezTo>
                    <a:pt x="17720" y="286150"/>
                    <a:pt x="37436" y="349561"/>
                    <a:pt x="39034" y="386862"/>
                  </a:cubicBezTo>
                  <a:cubicBezTo>
                    <a:pt x="40632" y="424163"/>
                    <a:pt x="32639" y="442281"/>
                    <a:pt x="29442" y="476384"/>
                  </a:cubicBezTo>
                  <a:cubicBezTo>
                    <a:pt x="26245" y="510487"/>
                    <a:pt x="24647" y="557380"/>
                    <a:pt x="19851" y="591483"/>
                  </a:cubicBezTo>
                  <a:cubicBezTo>
                    <a:pt x="15055" y="625586"/>
                    <a:pt x="2798" y="655960"/>
                    <a:pt x="667" y="681005"/>
                  </a:cubicBezTo>
                  <a:cubicBezTo>
                    <a:pt x="-1465" y="706050"/>
                    <a:pt x="1733" y="702320"/>
                    <a:pt x="7062" y="741752"/>
                  </a:cubicBezTo>
                  <a:cubicBezTo>
                    <a:pt x="12391" y="781184"/>
                    <a:pt x="29443" y="884560"/>
                    <a:pt x="32640" y="917598"/>
                  </a:cubicBezTo>
                  <a:cubicBezTo>
                    <a:pt x="35837" y="950636"/>
                    <a:pt x="28909" y="928255"/>
                    <a:pt x="26245" y="939978"/>
                  </a:cubicBezTo>
                  <a:cubicBezTo>
                    <a:pt x="23581" y="951701"/>
                    <a:pt x="20117" y="969818"/>
                    <a:pt x="16653" y="987936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: Shape 58"/>
            <p:cNvSpPr/>
            <p:nvPr/>
          </p:nvSpPr>
          <p:spPr>
            <a:xfrm>
              <a:off x="2382840" y="3551400"/>
              <a:ext cx="50760" cy="798480"/>
            </a:xfrm>
            <a:custGeom>
              <a:avLst/>
              <a:gdLst/>
              <a:ahLst/>
              <a:rect l="l" t="t" r="r" b="b"/>
              <a:pathLst>
                <a:path w="59906" h="1007118">
                  <a:moveTo>
                    <a:pt x="10666" y="0"/>
                  </a:moveTo>
                  <a:cubicBezTo>
                    <a:pt x="21590" y="38366"/>
                    <a:pt x="32514" y="76732"/>
                    <a:pt x="39441" y="105507"/>
                  </a:cubicBezTo>
                  <a:cubicBezTo>
                    <a:pt x="46368" y="134282"/>
                    <a:pt x="49033" y="148670"/>
                    <a:pt x="52230" y="172649"/>
                  </a:cubicBezTo>
                  <a:cubicBezTo>
                    <a:pt x="55427" y="196628"/>
                    <a:pt x="62887" y="218475"/>
                    <a:pt x="58624" y="249381"/>
                  </a:cubicBezTo>
                  <a:cubicBezTo>
                    <a:pt x="54361" y="280287"/>
                    <a:pt x="31981" y="327713"/>
                    <a:pt x="26652" y="358086"/>
                  </a:cubicBezTo>
                  <a:cubicBezTo>
                    <a:pt x="21323" y="388460"/>
                    <a:pt x="25586" y="403913"/>
                    <a:pt x="26652" y="431622"/>
                  </a:cubicBezTo>
                  <a:cubicBezTo>
                    <a:pt x="27718" y="459331"/>
                    <a:pt x="32514" y="501961"/>
                    <a:pt x="33047" y="524341"/>
                  </a:cubicBezTo>
                  <a:cubicBezTo>
                    <a:pt x="33580" y="546721"/>
                    <a:pt x="33046" y="548320"/>
                    <a:pt x="29849" y="565905"/>
                  </a:cubicBezTo>
                  <a:cubicBezTo>
                    <a:pt x="26652" y="583490"/>
                    <a:pt x="10666" y="608534"/>
                    <a:pt x="13863" y="629849"/>
                  </a:cubicBezTo>
                  <a:cubicBezTo>
                    <a:pt x="17060" y="651164"/>
                    <a:pt x="42106" y="674077"/>
                    <a:pt x="49033" y="693793"/>
                  </a:cubicBezTo>
                  <a:cubicBezTo>
                    <a:pt x="55960" y="713509"/>
                    <a:pt x="57026" y="731626"/>
                    <a:pt x="55427" y="748145"/>
                  </a:cubicBezTo>
                  <a:cubicBezTo>
                    <a:pt x="53828" y="764664"/>
                    <a:pt x="44770" y="780650"/>
                    <a:pt x="39441" y="792906"/>
                  </a:cubicBezTo>
                  <a:cubicBezTo>
                    <a:pt x="34112" y="805162"/>
                    <a:pt x="29849" y="805695"/>
                    <a:pt x="23455" y="821681"/>
                  </a:cubicBezTo>
                  <a:cubicBezTo>
                    <a:pt x="17061" y="837667"/>
                    <a:pt x="4272" y="868040"/>
                    <a:pt x="1075" y="888822"/>
                  </a:cubicBezTo>
                  <a:cubicBezTo>
                    <a:pt x="-2122" y="909604"/>
                    <a:pt x="2674" y="927722"/>
                    <a:pt x="4272" y="946372"/>
                  </a:cubicBezTo>
                  <a:cubicBezTo>
                    <a:pt x="5870" y="965022"/>
                    <a:pt x="8002" y="991132"/>
                    <a:pt x="10666" y="1000724"/>
                  </a:cubicBezTo>
                  <a:cubicBezTo>
                    <a:pt x="13330" y="1010316"/>
                    <a:pt x="16794" y="1007118"/>
                    <a:pt x="20258" y="1003921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: Shape 59"/>
            <p:cNvSpPr/>
            <p:nvPr/>
          </p:nvSpPr>
          <p:spPr>
            <a:xfrm>
              <a:off x="3197160" y="3567240"/>
              <a:ext cx="188640" cy="102960"/>
            </a:xfrm>
            <a:custGeom>
              <a:avLst/>
              <a:gdLst/>
              <a:ahLst/>
              <a:rect l="l" t="t" r="r" b="b"/>
              <a:pathLst>
                <a:path w="223804" h="131085">
                  <a:moveTo>
                    <a:pt x="223804" y="9591"/>
                  </a:moveTo>
                  <a:lnTo>
                    <a:pt x="134283" y="0"/>
                  </a:lnTo>
                  <a:lnTo>
                    <a:pt x="70339" y="9591"/>
                  </a:lnTo>
                  <a:cubicBezTo>
                    <a:pt x="49725" y="37075"/>
                    <a:pt x="60687" y="30403"/>
                    <a:pt x="44761" y="38366"/>
                  </a:cubicBezTo>
                  <a:lnTo>
                    <a:pt x="28775" y="51155"/>
                  </a:lnTo>
                  <a:lnTo>
                    <a:pt x="0" y="76733"/>
                  </a:lnTo>
                  <a:lnTo>
                    <a:pt x="31972" y="118296"/>
                  </a:lnTo>
                  <a:lnTo>
                    <a:pt x="118297" y="131085"/>
                  </a:lnTo>
                  <a:lnTo>
                    <a:pt x="134283" y="102310"/>
                  </a:lnTo>
                  <a:lnTo>
                    <a:pt x="159860" y="86324"/>
                  </a:lnTo>
                  <a:lnTo>
                    <a:pt x="214213" y="73536"/>
                  </a:lnTo>
                  <a:lnTo>
                    <a:pt x="223804" y="9591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: Shape 60"/>
            <p:cNvSpPr/>
            <p:nvPr/>
          </p:nvSpPr>
          <p:spPr>
            <a:xfrm>
              <a:off x="3232080" y="3657960"/>
              <a:ext cx="147600" cy="164880"/>
            </a:xfrm>
            <a:custGeom>
              <a:avLst/>
              <a:gdLst/>
              <a:ahLst/>
              <a:rect l="l" t="t" r="r" b="b"/>
              <a:pathLst>
                <a:path w="175846" h="207818">
                  <a:moveTo>
                    <a:pt x="166254" y="0"/>
                  </a:moveTo>
                  <a:lnTo>
                    <a:pt x="121493" y="47958"/>
                  </a:lnTo>
                  <a:lnTo>
                    <a:pt x="95916" y="63944"/>
                  </a:lnTo>
                  <a:lnTo>
                    <a:pt x="70338" y="92719"/>
                  </a:lnTo>
                  <a:lnTo>
                    <a:pt x="19183" y="102311"/>
                  </a:lnTo>
                  <a:lnTo>
                    <a:pt x="0" y="179044"/>
                  </a:lnTo>
                  <a:lnTo>
                    <a:pt x="6394" y="207818"/>
                  </a:lnTo>
                  <a:lnTo>
                    <a:pt x="70338" y="185438"/>
                  </a:lnTo>
                  <a:lnTo>
                    <a:pt x="121493" y="175846"/>
                  </a:lnTo>
                  <a:lnTo>
                    <a:pt x="163057" y="140677"/>
                  </a:lnTo>
                  <a:lnTo>
                    <a:pt x="175846" y="102311"/>
                  </a:lnTo>
                  <a:lnTo>
                    <a:pt x="166254" y="0"/>
                  </a:lnTo>
                  <a:close/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: Shape 61"/>
            <p:cNvSpPr/>
            <p:nvPr/>
          </p:nvSpPr>
          <p:spPr>
            <a:xfrm>
              <a:off x="3232080" y="3851640"/>
              <a:ext cx="131760" cy="452160"/>
            </a:xfrm>
            <a:custGeom>
              <a:avLst/>
              <a:gdLst/>
              <a:ahLst/>
              <a:rect l="l" t="t" r="r" b="b"/>
              <a:pathLst>
                <a:path w="156663" h="572299">
                  <a:moveTo>
                    <a:pt x="156663" y="0"/>
                  </a:moveTo>
                  <a:lnTo>
                    <a:pt x="79930" y="47958"/>
                  </a:lnTo>
                  <a:lnTo>
                    <a:pt x="35169" y="57549"/>
                  </a:lnTo>
                  <a:lnTo>
                    <a:pt x="35169" y="99113"/>
                  </a:lnTo>
                  <a:lnTo>
                    <a:pt x="35169" y="134282"/>
                  </a:lnTo>
                  <a:lnTo>
                    <a:pt x="54352" y="166254"/>
                  </a:lnTo>
                  <a:lnTo>
                    <a:pt x="47958" y="239790"/>
                  </a:lnTo>
                  <a:cubicBezTo>
                    <a:pt x="23768" y="260524"/>
                    <a:pt x="29971" y="250185"/>
                    <a:pt x="22380" y="265367"/>
                  </a:cubicBezTo>
                  <a:lnTo>
                    <a:pt x="0" y="290945"/>
                  </a:lnTo>
                  <a:lnTo>
                    <a:pt x="0" y="342100"/>
                  </a:lnTo>
                  <a:lnTo>
                    <a:pt x="6394" y="374072"/>
                  </a:lnTo>
                  <a:lnTo>
                    <a:pt x="28775" y="463594"/>
                  </a:lnTo>
                  <a:lnTo>
                    <a:pt x="35169" y="540327"/>
                  </a:lnTo>
                  <a:lnTo>
                    <a:pt x="44761" y="565904"/>
                  </a:lnTo>
                  <a:lnTo>
                    <a:pt x="99113" y="572299"/>
                  </a:lnTo>
                  <a:lnTo>
                    <a:pt x="134282" y="543524"/>
                  </a:lnTo>
                  <a:lnTo>
                    <a:pt x="147071" y="476383"/>
                  </a:lnTo>
                  <a:lnTo>
                    <a:pt x="92719" y="450805"/>
                  </a:lnTo>
                  <a:lnTo>
                    <a:pt x="67141" y="418833"/>
                  </a:lnTo>
                  <a:lnTo>
                    <a:pt x="54352" y="377270"/>
                  </a:lnTo>
                  <a:lnTo>
                    <a:pt x="105507" y="418833"/>
                  </a:ln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: Shape 62"/>
            <p:cNvSpPr/>
            <p:nvPr/>
          </p:nvSpPr>
          <p:spPr>
            <a:xfrm>
              <a:off x="3311640" y="3846600"/>
              <a:ext cx="63360" cy="349200"/>
            </a:xfrm>
            <a:custGeom>
              <a:avLst/>
              <a:gdLst/>
              <a:ahLst/>
              <a:rect l="l" t="t" r="r" b="b"/>
              <a:pathLst>
                <a:path w="76732" h="441488">
                  <a:moveTo>
                    <a:pt x="0" y="422031"/>
                  </a:moveTo>
                  <a:cubicBezTo>
                    <a:pt x="19982" y="432688"/>
                    <a:pt x="39965" y="443346"/>
                    <a:pt x="51155" y="441214"/>
                  </a:cubicBezTo>
                  <a:cubicBezTo>
                    <a:pt x="62345" y="439082"/>
                    <a:pt x="62878" y="421498"/>
                    <a:pt x="67141" y="409242"/>
                  </a:cubicBezTo>
                  <a:cubicBezTo>
                    <a:pt x="71404" y="396986"/>
                    <a:pt x="76732" y="383665"/>
                    <a:pt x="76732" y="367679"/>
                  </a:cubicBezTo>
                  <a:cubicBezTo>
                    <a:pt x="76732" y="351693"/>
                    <a:pt x="71404" y="338371"/>
                    <a:pt x="67141" y="313326"/>
                  </a:cubicBezTo>
                  <a:cubicBezTo>
                    <a:pt x="62878" y="288281"/>
                    <a:pt x="53286" y="245652"/>
                    <a:pt x="51155" y="217410"/>
                  </a:cubicBezTo>
                  <a:cubicBezTo>
                    <a:pt x="49024" y="189168"/>
                    <a:pt x="52221" y="168919"/>
                    <a:pt x="54352" y="143874"/>
                  </a:cubicBezTo>
                  <a:cubicBezTo>
                    <a:pt x="56484" y="118829"/>
                    <a:pt x="63411" y="87923"/>
                    <a:pt x="63944" y="67141"/>
                  </a:cubicBezTo>
                  <a:cubicBezTo>
                    <a:pt x="64477" y="46359"/>
                    <a:pt x="59148" y="30373"/>
                    <a:pt x="57549" y="19183"/>
                  </a:cubicBezTo>
                  <a:cubicBezTo>
                    <a:pt x="55950" y="7993"/>
                    <a:pt x="55151" y="3996"/>
                    <a:pt x="54352" y="0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TextBox 50"/>
          <p:cNvSpPr/>
          <p:nvPr/>
        </p:nvSpPr>
        <p:spPr>
          <a:xfrm>
            <a:off x="3935520" y="471168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50"/>
          <p:cNvSpPr/>
          <p:nvPr/>
        </p:nvSpPr>
        <p:spPr>
          <a:xfrm>
            <a:off x="487440" y="467352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0" name="Group 11"/>
          <p:cNvGrpSpPr/>
          <p:nvPr/>
        </p:nvGrpSpPr>
        <p:grpSpPr>
          <a:xfrm>
            <a:off x="824040" y="4834080"/>
            <a:ext cx="3112920" cy="2351880"/>
            <a:chOff x="824040" y="4834080"/>
            <a:chExt cx="3112920" cy="2351880"/>
          </a:xfrm>
        </p:grpSpPr>
        <p:pic>
          <p:nvPicPr>
            <p:cNvPr id="201" name="Picture 2" descr=""/>
            <p:cNvPicPr/>
            <p:nvPr/>
          </p:nvPicPr>
          <p:blipFill>
            <a:blip r:embed="rId13"/>
            <a:srcRect l="42242" t="20554" r="44896" b="62685"/>
            <a:stretch/>
          </p:blipFill>
          <p:spPr>
            <a:xfrm>
              <a:off x="824040" y="504252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2" name="Picture 2" descr=""/>
            <p:cNvPicPr/>
            <p:nvPr/>
          </p:nvPicPr>
          <p:blipFill>
            <a:blip r:embed="rId14"/>
            <a:srcRect l="55022" t="20200" r="32112" b="63039"/>
            <a:stretch/>
          </p:blipFill>
          <p:spPr>
            <a:xfrm>
              <a:off x="1865520" y="504252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3" name="Picture 2" descr=""/>
            <p:cNvPicPr/>
            <p:nvPr/>
          </p:nvPicPr>
          <p:blipFill>
            <a:blip r:embed="rId15"/>
            <a:srcRect l="29837" t="36925" r="57297" b="46314"/>
            <a:stretch/>
          </p:blipFill>
          <p:spPr>
            <a:xfrm>
              <a:off x="2907000" y="504252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4" name="Picture 2" descr=""/>
            <p:cNvPicPr/>
            <p:nvPr/>
          </p:nvPicPr>
          <p:blipFill>
            <a:blip r:embed="rId16"/>
            <a:srcRect l="55009" t="36884" r="32126" b="46350"/>
            <a:stretch/>
          </p:blipFill>
          <p:spPr>
            <a:xfrm>
              <a:off x="827640" y="598680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5" name="Picture 2" descr=""/>
            <p:cNvPicPr/>
            <p:nvPr/>
          </p:nvPicPr>
          <p:blipFill>
            <a:blip r:embed="rId17"/>
            <a:srcRect l="42385" t="53677" r="44753" b="29557"/>
            <a:stretch/>
          </p:blipFill>
          <p:spPr>
            <a:xfrm>
              <a:off x="1865520" y="598680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6" name="Picture 2" descr=""/>
            <p:cNvPicPr/>
            <p:nvPr/>
          </p:nvPicPr>
          <p:blipFill>
            <a:blip r:embed="rId18"/>
            <a:srcRect l="54927" t="53170" r="32208" b="30069"/>
            <a:stretch/>
          </p:blipFill>
          <p:spPr>
            <a:xfrm>
              <a:off x="2905200" y="5986800"/>
              <a:ext cx="983160" cy="87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7" name="TextBox 2"/>
            <p:cNvSpPr/>
            <p:nvPr/>
          </p:nvSpPr>
          <p:spPr>
            <a:xfrm>
              <a:off x="2990160" y="4834080"/>
              <a:ext cx="94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 J/cm</a:t>
              </a:r>
              <a:r>
                <a:rPr b="1" lang="en-US" sz="9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Box 87"/>
            <p:cNvSpPr/>
            <p:nvPr/>
          </p:nvSpPr>
          <p:spPr>
            <a:xfrm>
              <a:off x="2007000" y="4834080"/>
              <a:ext cx="94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 J/cm</a:t>
              </a:r>
              <a:r>
                <a:rPr b="1" lang="en-US" sz="9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Box 88"/>
            <p:cNvSpPr/>
            <p:nvPr/>
          </p:nvSpPr>
          <p:spPr>
            <a:xfrm>
              <a:off x="993960" y="4840200"/>
              <a:ext cx="835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Box 2"/>
            <p:cNvSpPr/>
            <p:nvPr/>
          </p:nvSpPr>
          <p:spPr>
            <a:xfrm>
              <a:off x="2941560" y="6817680"/>
              <a:ext cx="946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B4315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15 J/cm</a:t>
              </a:r>
              <a:r>
                <a:rPr b="1" lang="en-US" sz="9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Box 87"/>
            <p:cNvSpPr/>
            <p:nvPr/>
          </p:nvSpPr>
          <p:spPr>
            <a:xfrm>
              <a:off x="1911240" y="6817680"/>
              <a:ext cx="946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B4315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3 J/cm</a:t>
              </a:r>
              <a:r>
                <a:rPr b="1" lang="en-US" sz="9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Box 88"/>
            <p:cNvSpPr/>
            <p:nvPr/>
          </p:nvSpPr>
          <p:spPr>
            <a:xfrm>
              <a:off x="918720" y="6892560"/>
              <a:ext cx="896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B4315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13" name="Picture 184" descr=""/>
          <p:cNvPicPr/>
          <p:nvPr/>
        </p:nvPicPr>
        <p:blipFill>
          <a:blip r:embed="rId19"/>
          <a:srcRect l="0" t="1547" r="43933" b="0"/>
          <a:stretch/>
        </p:blipFill>
        <p:spPr>
          <a:xfrm>
            <a:off x="4268880" y="890640"/>
            <a:ext cx="2324160" cy="1908000"/>
          </a:xfrm>
          <a:prstGeom prst="rect">
            <a:avLst/>
          </a:prstGeom>
          <a:ln w="0">
            <a:noFill/>
          </a:ln>
        </p:spPr>
      </p:pic>
      <p:grpSp>
        <p:nvGrpSpPr>
          <p:cNvPr id="214" name="Group 9"/>
          <p:cNvGrpSpPr/>
          <p:nvPr/>
        </p:nvGrpSpPr>
        <p:grpSpPr>
          <a:xfrm>
            <a:off x="4381560" y="2789280"/>
            <a:ext cx="2442960" cy="1909800"/>
            <a:chOff x="4381560" y="2789280"/>
            <a:chExt cx="2442960" cy="1909800"/>
          </a:xfrm>
        </p:grpSpPr>
        <p:pic>
          <p:nvPicPr>
            <p:cNvPr id="215" name="Picture 185" descr=""/>
            <p:cNvPicPr/>
            <p:nvPr/>
          </p:nvPicPr>
          <p:blipFill>
            <a:blip r:embed="rId20"/>
            <a:srcRect l="0" t="1547" r="81935" b="0"/>
            <a:stretch/>
          </p:blipFill>
          <p:spPr>
            <a:xfrm>
              <a:off x="4381560" y="2790720"/>
              <a:ext cx="749160" cy="190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186" descr=""/>
            <p:cNvPicPr/>
            <p:nvPr/>
          </p:nvPicPr>
          <p:blipFill>
            <a:blip r:embed="rId21"/>
            <a:srcRect l="55145" t="1547" r="-1557" b="0"/>
            <a:stretch/>
          </p:blipFill>
          <p:spPr>
            <a:xfrm>
              <a:off x="4899960" y="2789280"/>
              <a:ext cx="1924560" cy="1908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17" name="Group 4095"/>
          <p:cNvGrpSpPr/>
          <p:nvPr/>
        </p:nvGrpSpPr>
        <p:grpSpPr>
          <a:xfrm>
            <a:off x="4276800" y="4699080"/>
            <a:ext cx="2235240" cy="2517840"/>
            <a:chOff x="4276800" y="4699080"/>
            <a:chExt cx="2235240" cy="2517840"/>
          </a:xfrm>
        </p:grpSpPr>
        <p:pic>
          <p:nvPicPr>
            <p:cNvPr id="218" name="Picture 39" descr=""/>
            <p:cNvPicPr/>
            <p:nvPr/>
          </p:nvPicPr>
          <p:blipFill>
            <a:blip r:embed="rId22"/>
            <a:srcRect l="0" t="0" r="50420" b="53515"/>
            <a:stretch/>
          </p:blipFill>
          <p:spPr>
            <a:xfrm>
              <a:off x="5508720" y="4863240"/>
              <a:ext cx="995760" cy="76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40" descr=""/>
            <p:cNvPicPr/>
            <p:nvPr/>
          </p:nvPicPr>
          <p:blipFill>
            <a:blip r:embed="rId23">
              <a:lum contrast="10000"/>
            </a:blip>
            <a:srcRect l="0" t="50031" r="50009" b="0"/>
            <a:stretch/>
          </p:blipFill>
          <p:spPr>
            <a:xfrm>
              <a:off x="5516280" y="6455160"/>
              <a:ext cx="995760" cy="76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0" name="TextBox 43"/>
            <p:cNvSpPr/>
            <p:nvPr/>
          </p:nvSpPr>
          <p:spPr>
            <a:xfrm>
              <a:off x="4701960" y="4707360"/>
              <a:ext cx="784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Box 44"/>
            <p:cNvSpPr/>
            <p:nvPr/>
          </p:nvSpPr>
          <p:spPr>
            <a:xfrm>
              <a:off x="5734800" y="4699080"/>
              <a:ext cx="486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GF-</a:t>
              </a:r>
              <a:r>
                <a:rPr b="1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Box 85"/>
            <p:cNvSpPr/>
            <p:nvPr/>
          </p:nvSpPr>
          <p:spPr>
            <a:xfrm rot="16200000">
              <a:off x="4186800" y="517608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558ed5"/>
                  </a:solidFill>
                  <a:latin typeface="Arial"/>
                </a:rPr>
                <a:t>DA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Box 49"/>
            <p:cNvSpPr/>
            <p:nvPr/>
          </p:nvSpPr>
          <p:spPr>
            <a:xfrm rot="16200000">
              <a:off x="4146480" y="5943960"/>
              <a:ext cx="46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700" spc="-1" strike="noStrike">
                  <a:solidFill>
                    <a:srgbClr val="00b050"/>
                  </a:solidFill>
                  <a:latin typeface="Arial"/>
                  <a:ea typeface="Arial"/>
                </a:rPr>
                <a:t>α</a:t>
              </a:r>
              <a:r>
                <a:rPr b="1" lang="en-US" sz="700" spc="-1" strike="noStrike">
                  <a:solidFill>
                    <a:srgbClr val="00b050"/>
                  </a:solidFill>
                  <a:latin typeface="Arial"/>
                  <a:ea typeface="Arial"/>
                </a:rPr>
                <a:t>-SM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Box 50"/>
            <p:cNvSpPr/>
            <p:nvPr/>
          </p:nvSpPr>
          <p:spPr>
            <a:xfrm rot="16200000">
              <a:off x="4134960" y="6745320"/>
              <a:ext cx="493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5" name="Picture 66" descr=""/>
            <p:cNvPicPr/>
            <p:nvPr/>
          </p:nvPicPr>
          <p:blipFill>
            <a:blip r:embed="rId24"/>
            <a:srcRect l="0" t="0" r="50009" b="50031"/>
            <a:stretch/>
          </p:blipFill>
          <p:spPr>
            <a:xfrm>
              <a:off x="4459320" y="4863240"/>
              <a:ext cx="995760" cy="76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6" name="Picture 67" descr=""/>
            <p:cNvPicPr/>
            <p:nvPr/>
          </p:nvPicPr>
          <p:blipFill>
            <a:blip r:embed="rId25"/>
            <a:srcRect l="49505" t="0" r="0" b="50031"/>
            <a:stretch/>
          </p:blipFill>
          <p:spPr>
            <a:xfrm>
              <a:off x="4459320" y="5659200"/>
              <a:ext cx="995760" cy="76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7" name="Picture 68" descr=""/>
            <p:cNvPicPr/>
            <p:nvPr/>
          </p:nvPicPr>
          <p:blipFill>
            <a:blip r:embed="rId26"/>
            <a:srcRect l="0" t="50031" r="50009" b="0"/>
            <a:stretch/>
          </p:blipFill>
          <p:spPr>
            <a:xfrm>
              <a:off x="4459320" y="6455160"/>
              <a:ext cx="995760" cy="76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8" name="Picture 79" descr=""/>
            <p:cNvPicPr/>
            <p:nvPr/>
          </p:nvPicPr>
          <p:blipFill>
            <a:blip r:embed="rId27">
              <a:lum contrast="10000"/>
            </a:blip>
            <a:srcRect l="50009" t="0" r="0" b="50031"/>
            <a:stretch/>
          </p:blipFill>
          <p:spPr>
            <a:xfrm>
              <a:off x="5516280" y="5658480"/>
              <a:ext cx="995760" cy="761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9" name="TextBox 50"/>
          <p:cNvSpPr/>
          <p:nvPr/>
        </p:nvSpPr>
        <p:spPr>
          <a:xfrm>
            <a:off x="3968640" y="260208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TextBox 57"/>
          <p:cNvSpPr/>
          <p:nvPr/>
        </p:nvSpPr>
        <p:spPr>
          <a:xfrm>
            <a:off x="152280" y="371520"/>
            <a:ext cx="197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1" name="Picture 3" descr=""/>
          <p:cNvPicPr/>
          <p:nvPr/>
        </p:nvPicPr>
        <p:blipFill>
          <a:blip r:embed="rId1"/>
          <a:stretch/>
        </p:blipFill>
        <p:spPr>
          <a:xfrm>
            <a:off x="447840" y="684360"/>
            <a:ext cx="2563560" cy="1736640"/>
          </a:xfrm>
          <a:prstGeom prst="rect">
            <a:avLst/>
          </a:prstGeom>
          <a:ln w="0">
            <a:noFill/>
          </a:ln>
        </p:spPr>
      </p:pic>
      <p:grpSp>
        <p:nvGrpSpPr>
          <p:cNvPr id="232" name="Group 8"/>
          <p:cNvGrpSpPr/>
          <p:nvPr/>
        </p:nvGrpSpPr>
        <p:grpSpPr>
          <a:xfrm>
            <a:off x="611280" y="6915240"/>
            <a:ext cx="3084480" cy="1880640"/>
            <a:chOff x="611280" y="6915240"/>
            <a:chExt cx="3084480" cy="1880640"/>
          </a:xfrm>
        </p:grpSpPr>
        <p:grpSp>
          <p:nvGrpSpPr>
            <p:cNvPr id="233" name="Group 9"/>
            <p:cNvGrpSpPr/>
            <p:nvPr/>
          </p:nvGrpSpPr>
          <p:grpSpPr>
            <a:xfrm>
              <a:off x="769320" y="7077960"/>
              <a:ext cx="2926440" cy="1621800"/>
              <a:chOff x="769320" y="7077960"/>
              <a:chExt cx="2926440" cy="1621800"/>
            </a:xfrm>
          </p:grpSpPr>
          <p:pic>
            <p:nvPicPr>
              <p:cNvPr id="234" name="Picture 19" descr=""/>
              <p:cNvPicPr/>
              <p:nvPr/>
            </p:nvPicPr>
            <p:blipFill>
              <a:blip r:embed="rId2"/>
              <a:stretch/>
            </p:blipFill>
            <p:spPr>
              <a:xfrm>
                <a:off x="769320" y="81684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5" name="Picture 20" descr=""/>
              <p:cNvPicPr/>
              <p:nvPr/>
            </p:nvPicPr>
            <p:blipFill>
              <a:blip r:embed="rId3"/>
              <a:stretch/>
            </p:blipFill>
            <p:spPr>
              <a:xfrm>
                <a:off x="2242800" y="81684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6" name="Picture 21" descr=""/>
              <p:cNvPicPr/>
              <p:nvPr/>
            </p:nvPicPr>
            <p:blipFill>
              <a:blip r:embed="rId4"/>
              <a:stretch/>
            </p:blipFill>
            <p:spPr>
              <a:xfrm>
                <a:off x="1505880" y="81684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7" name="Picture 22" descr=""/>
              <p:cNvPicPr/>
              <p:nvPr/>
            </p:nvPicPr>
            <p:blipFill>
              <a:blip r:embed="rId5"/>
              <a:stretch/>
            </p:blipFill>
            <p:spPr>
              <a:xfrm>
                <a:off x="2979720" y="81684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8" name="Picture 23" descr=""/>
              <p:cNvPicPr/>
              <p:nvPr/>
            </p:nvPicPr>
            <p:blipFill>
              <a:blip r:embed="rId6"/>
              <a:stretch/>
            </p:blipFill>
            <p:spPr>
              <a:xfrm>
                <a:off x="769320" y="76230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9" name="Picture 24" descr=""/>
              <p:cNvPicPr/>
              <p:nvPr/>
            </p:nvPicPr>
            <p:blipFill>
              <a:blip r:embed="rId7"/>
              <a:stretch/>
            </p:blipFill>
            <p:spPr>
              <a:xfrm>
                <a:off x="1505880" y="76230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0" name="Picture 25" descr=""/>
              <p:cNvPicPr/>
              <p:nvPr/>
            </p:nvPicPr>
            <p:blipFill>
              <a:blip r:embed="rId8"/>
              <a:stretch/>
            </p:blipFill>
            <p:spPr>
              <a:xfrm>
                <a:off x="2979720" y="76230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1" name="Picture 26" descr=""/>
              <p:cNvPicPr/>
              <p:nvPr/>
            </p:nvPicPr>
            <p:blipFill>
              <a:blip r:embed="rId9"/>
              <a:stretch/>
            </p:blipFill>
            <p:spPr>
              <a:xfrm>
                <a:off x="2242800" y="762300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2" name="Picture 27" descr=""/>
              <p:cNvPicPr/>
              <p:nvPr/>
            </p:nvPicPr>
            <p:blipFill>
              <a:blip r:embed="rId10"/>
              <a:stretch/>
            </p:blipFill>
            <p:spPr>
              <a:xfrm>
                <a:off x="769320" y="707796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3" name="Picture 28" descr=""/>
              <p:cNvPicPr/>
              <p:nvPr/>
            </p:nvPicPr>
            <p:blipFill>
              <a:blip r:embed="rId11"/>
              <a:stretch/>
            </p:blipFill>
            <p:spPr>
              <a:xfrm>
                <a:off x="1505880" y="707796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4" name="Picture 29" descr=""/>
              <p:cNvPicPr/>
              <p:nvPr/>
            </p:nvPicPr>
            <p:blipFill>
              <a:blip r:embed="rId12"/>
              <a:stretch/>
            </p:blipFill>
            <p:spPr>
              <a:xfrm>
                <a:off x="2242800" y="707796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5" name="Picture 30" descr=""/>
              <p:cNvPicPr/>
              <p:nvPr/>
            </p:nvPicPr>
            <p:blipFill>
              <a:blip r:embed="rId13"/>
              <a:stretch/>
            </p:blipFill>
            <p:spPr>
              <a:xfrm>
                <a:off x="2979720" y="7077960"/>
                <a:ext cx="716040" cy="53136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46" name="Group 10"/>
            <p:cNvGrpSpPr/>
            <p:nvPr/>
          </p:nvGrpSpPr>
          <p:grpSpPr>
            <a:xfrm>
              <a:off x="837720" y="6915240"/>
              <a:ext cx="2789280" cy="200520"/>
              <a:chOff x="837720" y="6915240"/>
              <a:chExt cx="2789280" cy="200520"/>
            </a:xfrm>
          </p:grpSpPr>
          <p:sp>
            <p:nvSpPr>
              <p:cNvPr id="247" name="TextBox 15"/>
              <p:cNvSpPr/>
              <p:nvPr/>
            </p:nvSpPr>
            <p:spPr>
              <a:xfrm>
                <a:off x="837720" y="6915240"/>
                <a:ext cx="578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b050"/>
                    </a:solidFill>
                    <a:latin typeface="Arial"/>
                    <a:ea typeface="Arial"/>
                  </a:rPr>
                  <a:t>Bead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TextBox 16"/>
              <p:cNvSpPr/>
              <p:nvPr/>
            </p:nvSpPr>
            <p:spPr>
              <a:xfrm>
                <a:off x="1575720" y="6915240"/>
                <a:ext cx="578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WG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TextBox 17"/>
              <p:cNvSpPr/>
              <p:nvPr/>
            </p:nvSpPr>
            <p:spPr>
              <a:xfrm>
                <a:off x="2309040" y="6915240"/>
                <a:ext cx="578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has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TextBox 18"/>
              <p:cNvSpPr/>
              <p:nvPr/>
            </p:nvSpPr>
            <p:spPr>
              <a:xfrm>
                <a:off x="3048120" y="6915240"/>
                <a:ext cx="578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erg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1" name="Group 11"/>
            <p:cNvGrpSpPr/>
            <p:nvPr/>
          </p:nvGrpSpPr>
          <p:grpSpPr>
            <a:xfrm>
              <a:off x="611280" y="7090920"/>
              <a:ext cx="205560" cy="1704960"/>
              <a:chOff x="611280" y="7090920"/>
              <a:chExt cx="205560" cy="1704960"/>
            </a:xfrm>
          </p:grpSpPr>
          <p:sp>
            <p:nvSpPr>
              <p:cNvPr id="252" name="TextBox 12"/>
              <p:cNvSpPr/>
              <p:nvPr/>
            </p:nvSpPr>
            <p:spPr>
              <a:xfrm rot="16200000">
                <a:off x="423720" y="7278120"/>
                <a:ext cx="57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ntrol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TextBox 13"/>
              <p:cNvSpPr/>
              <p:nvPr/>
            </p:nvSpPr>
            <p:spPr>
              <a:xfrm rot="16200000">
                <a:off x="339840" y="7770600"/>
                <a:ext cx="74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GF-</a:t>
                </a:r>
                <a:r>
                  <a:rPr b="1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TextBox 14"/>
              <p:cNvSpPr/>
              <p:nvPr/>
            </p:nvSpPr>
            <p:spPr>
              <a:xfrm rot="16200000">
                <a:off x="344880" y="8323920"/>
                <a:ext cx="74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B43154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aphicFrame>
        <p:nvGraphicFramePr>
          <p:cNvPr id="255" name="Chart 31"/>
          <p:cNvGraphicFramePr/>
          <p:nvPr/>
        </p:nvGraphicFramePr>
        <p:xfrm>
          <a:off x="2933640" y="558720"/>
          <a:ext cx="3378240" cy="2082960"/>
        </p:xfrm>
        <a:graphic>
          <a:graphicData uri="http://schemas.openxmlformats.org/presentationml/2006/ole">
            <p:oleObj progId="Excel.Sheet.12" r:id="rId14" spid="">
              <p:embed/>
              <p:pic>
                <p:nvPicPr>
                  <p:cNvPr id="256" name="Chart 31" descr=""/>
                  <p:cNvPicPr/>
                  <p:nvPr/>
                </p:nvPicPr>
                <p:blipFill>
                  <a:blip r:embed="rId15"/>
                  <a:stretch/>
                </p:blipFill>
                <p:spPr>
                  <a:xfrm>
                    <a:off x="2933640" y="558720"/>
                    <a:ext cx="3378240" cy="208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57" name="TextBox 50"/>
          <p:cNvSpPr/>
          <p:nvPr/>
        </p:nvSpPr>
        <p:spPr>
          <a:xfrm>
            <a:off x="406440" y="62064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Box 50"/>
          <p:cNvSpPr/>
          <p:nvPr/>
        </p:nvSpPr>
        <p:spPr>
          <a:xfrm>
            <a:off x="2817720" y="62064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50"/>
          <p:cNvSpPr/>
          <p:nvPr/>
        </p:nvSpPr>
        <p:spPr>
          <a:xfrm>
            <a:off x="406440" y="246708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50"/>
          <p:cNvSpPr/>
          <p:nvPr/>
        </p:nvSpPr>
        <p:spPr>
          <a:xfrm>
            <a:off x="468360" y="677232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50"/>
          <p:cNvSpPr/>
          <p:nvPr/>
        </p:nvSpPr>
        <p:spPr>
          <a:xfrm>
            <a:off x="3735360" y="679932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50"/>
          <p:cNvSpPr/>
          <p:nvPr/>
        </p:nvSpPr>
        <p:spPr>
          <a:xfrm>
            <a:off x="3606840" y="247320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3" name="Group 39"/>
          <p:cNvGrpSpPr/>
          <p:nvPr/>
        </p:nvGrpSpPr>
        <p:grpSpPr>
          <a:xfrm>
            <a:off x="595440" y="2489040"/>
            <a:ext cx="2960640" cy="1498680"/>
            <a:chOff x="595440" y="2489040"/>
            <a:chExt cx="2960640" cy="1498680"/>
          </a:xfrm>
        </p:grpSpPr>
        <p:sp>
          <p:nvSpPr>
            <p:cNvPr id="264" name="TextBox 40"/>
            <p:cNvSpPr/>
            <p:nvPr/>
          </p:nvSpPr>
          <p:spPr>
            <a:xfrm>
              <a:off x="828360" y="2566440"/>
              <a:ext cx="60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TextBox 41"/>
            <p:cNvSpPr/>
            <p:nvPr/>
          </p:nvSpPr>
          <p:spPr>
            <a:xfrm>
              <a:off x="1407240" y="2534400"/>
              <a:ext cx="733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5 ng/m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TextBox 42"/>
            <p:cNvSpPr/>
            <p:nvPr/>
          </p:nvSpPr>
          <p:spPr>
            <a:xfrm>
              <a:off x="2125800" y="2489040"/>
              <a:ext cx="674280" cy="35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GF-</a:t>
              </a:r>
              <a:r>
                <a:rPr b="1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.5 ng/m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TextBox 43"/>
            <p:cNvSpPr/>
            <p:nvPr/>
          </p:nvSpPr>
          <p:spPr>
            <a:xfrm>
              <a:off x="2797560" y="2535840"/>
              <a:ext cx="758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ng/m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8" name="Picture 44" descr=""/>
            <p:cNvPicPr/>
            <p:nvPr/>
          </p:nvPicPr>
          <p:blipFill>
            <a:blip r:embed="rId16"/>
            <a:stretch/>
          </p:blipFill>
          <p:spPr>
            <a:xfrm>
              <a:off x="777240" y="279864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9" name="Picture 45" descr=""/>
            <p:cNvPicPr/>
            <p:nvPr/>
          </p:nvPicPr>
          <p:blipFill>
            <a:blip r:embed="rId17"/>
            <a:stretch/>
          </p:blipFill>
          <p:spPr>
            <a:xfrm>
              <a:off x="1472040" y="279864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0" name="Picture 46" descr=""/>
            <p:cNvPicPr/>
            <p:nvPr/>
          </p:nvPicPr>
          <p:blipFill>
            <a:blip r:embed="rId18"/>
            <a:stretch/>
          </p:blipFill>
          <p:spPr>
            <a:xfrm>
              <a:off x="2166840" y="279864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1" name="Picture 47" descr=""/>
            <p:cNvPicPr/>
            <p:nvPr/>
          </p:nvPicPr>
          <p:blipFill>
            <a:blip r:embed="rId19"/>
            <a:stretch/>
          </p:blipFill>
          <p:spPr>
            <a:xfrm>
              <a:off x="2862000" y="279864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2" name="Picture 48" descr=""/>
            <p:cNvPicPr/>
            <p:nvPr/>
          </p:nvPicPr>
          <p:blipFill>
            <a:blip r:embed="rId20"/>
            <a:stretch/>
          </p:blipFill>
          <p:spPr>
            <a:xfrm>
              <a:off x="777240" y="340020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3" name="Picture 49" descr=""/>
            <p:cNvPicPr/>
            <p:nvPr/>
          </p:nvPicPr>
          <p:blipFill>
            <a:blip r:embed="rId21"/>
            <a:stretch/>
          </p:blipFill>
          <p:spPr>
            <a:xfrm>
              <a:off x="1472040" y="340020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4" name="Picture 50" descr=""/>
            <p:cNvPicPr/>
            <p:nvPr/>
          </p:nvPicPr>
          <p:blipFill>
            <a:blip r:embed="rId22"/>
            <a:stretch/>
          </p:blipFill>
          <p:spPr>
            <a:xfrm>
              <a:off x="2166840" y="340020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5" name="Picture 51" descr=""/>
            <p:cNvPicPr/>
            <p:nvPr/>
          </p:nvPicPr>
          <p:blipFill>
            <a:blip r:embed="rId23"/>
            <a:stretch/>
          </p:blipFill>
          <p:spPr>
            <a:xfrm>
              <a:off x="2861640" y="3400200"/>
              <a:ext cx="680760" cy="58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6" name="TextBox 52"/>
            <p:cNvSpPr/>
            <p:nvPr/>
          </p:nvSpPr>
          <p:spPr>
            <a:xfrm rot="16200000">
              <a:off x="436320" y="3019680"/>
              <a:ext cx="518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hou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Box 53"/>
            <p:cNvSpPr/>
            <p:nvPr/>
          </p:nvSpPr>
          <p:spPr>
            <a:xfrm rot="16200000">
              <a:off x="404280" y="3596040"/>
              <a:ext cx="582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 hour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8" name="Group 2"/>
          <p:cNvGrpSpPr/>
          <p:nvPr/>
        </p:nvGrpSpPr>
        <p:grpSpPr>
          <a:xfrm>
            <a:off x="4067280" y="7007400"/>
            <a:ext cx="2095560" cy="1729440"/>
            <a:chOff x="4067280" y="7007400"/>
            <a:chExt cx="2095560" cy="1729440"/>
          </a:xfrm>
        </p:grpSpPr>
        <p:sp>
          <p:nvSpPr>
            <p:cNvPr id="279" name="TextBox 3"/>
            <p:cNvSpPr/>
            <p:nvPr/>
          </p:nvSpPr>
          <p:spPr>
            <a:xfrm>
              <a:off x="4178160" y="790452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TextBox 3"/>
            <p:cNvSpPr/>
            <p:nvPr/>
          </p:nvSpPr>
          <p:spPr>
            <a:xfrm>
              <a:off x="4178160" y="760536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Box 3"/>
            <p:cNvSpPr/>
            <p:nvPr/>
          </p:nvSpPr>
          <p:spPr>
            <a:xfrm>
              <a:off x="4178160" y="730620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Box 3"/>
            <p:cNvSpPr/>
            <p:nvPr/>
          </p:nvSpPr>
          <p:spPr>
            <a:xfrm>
              <a:off x="4178160" y="700740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TextBox 5"/>
            <p:cNvSpPr/>
            <p:nvPr/>
          </p:nvSpPr>
          <p:spPr>
            <a:xfrm>
              <a:off x="5090040" y="7887960"/>
              <a:ext cx="228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Straight Connector 52"/>
            <p:cNvSpPr/>
            <p:nvPr/>
          </p:nvSpPr>
          <p:spPr>
            <a:xfrm flipV="1">
              <a:off x="4352760" y="7083000"/>
              <a:ext cx="0" cy="1551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Straight Connector 53"/>
            <p:cNvSpPr/>
            <p:nvPr/>
          </p:nvSpPr>
          <p:spPr>
            <a:xfrm>
              <a:off x="4316400" y="8585640"/>
              <a:ext cx="1846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54"/>
            <p:cNvSpPr/>
            <p:nvPr/>
          </p:nvSpPr>
          <p:spPr>
            <a:xfrm>
              <a:off x="4506840" y="7845480"/>
              <a:ext cx="276120" cy="7380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Straight Connector 66"/>
            <p:cNvSpPr/>
            <p:nvPr/>
          </p:nvSpPr>
          <p:spPr>
            <a:xfrm>
              <a:off x="4329000" y="828864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TextBox 3"/>
            <p:cNvSpPr/>
            <p:nvPr/>
          </p:nvSpPr>
          <p:spPr>
            <a:xfrm>
              <a:off x="4181400" y="850284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TextBox 3"/>
            <p:cNvSpPr/>
            <p:nvPr/>
          </p:nvSpPr>
          <p:spPr>
            <a:xfrm>
              <a:off x="4420080" y="8543160"/>
              <a:ext cx="45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TextBox 3"/>
            <p:cNvSpPr/>
            <p:nvPr/>
          </p:nvSpPr>
          <p:spPr>
            <a:xfrm>
              <a:off x="4987800" y="8546760"/>
              <a:ext cx="439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TGF-</a:t>
              </a:r>
              <a:r>
                <a:rPr b="1" lang="en-US" sz="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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TextBox 3"/>
            <p:cNvSpPr/>
            <p:nvPr/>
          </p:nvSpPr>
          <p:spPr>
            <a:xfrm>
              <a:off x="5655240" y="8551440"/>
              <a:ext cx="285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S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TextBox 3"/>
            <p:cNvSpPr/>
            <p:nvPr/>
          </p:nvSpPr>
          <p:spPr>
            <a:xfrm rot="16200000">
              <a:off x="3584160" y="7768800"/>
              <a:ext cx="1151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an fluorescence intensity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TextBox 5"/>
            <p:cNvSpPr/>
            <p:nvPr/>
          </p:nvSpPr>
          <p:spPr>
            <a:xfrm>
              <a:off x="5667840" y="7046280"/>
              <a:ext cx="228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85"/>
            <p:cNvSpPr/>
            <p:nvPr/>
          </p:nvSpPr>
          <p:spPr>
            <a:xfrm>
              <a:off x="5073840" y="8164800"/>
              <a:ext cx="277560" cy="419040"/>
            </a:xfrm>
            <a:prstGeom prst="rect">
              <a:avLst/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86"/>
            <p:cNvSpPr/>
            <p:nvPr/>
          </p:nvSpPr>
          <p:spPr>
            <a:xfrm>
              <a:off x="5651640" y="7257960"/>
              <a:ext cx="277560" cy="1325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Straight Connector 87"/>
            <p:cNvSpPr/>
            <p:nvPr/>
          </p:nvSpPr>
          <p:spPr>
            <a:xfrm>
              <a:off x="4329000" y="798840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Straight Connector 88"/>
            <p:cNvSpPr/>
            <p:nvPr/>
          </p:nvSpPr>
          <p:spPr>
            <a:xfrm>
              <a:off x="4329000" y="768852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Straight Connector 89"/>
            <p:cNvSpPr/>
            <p:nvPr/>
          </p:nvSpPr>
          <p:spPr>
            <a:xfrm>
              <a:off x="4329000" y="738972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Straight Connector 90"/>
            <p:cNvSpPr/>
            <p:nvPr/>
          </p:nvSpPr>
          <p:spPr>
            <a:xfrm>
              <a:off x="4329000" y="708804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Straight Connector 91"/>
            <p:cNvSpPr/>
            <p:nvPr/>
          </p:nvSpPr>
          <p:spPr>
            <a:xfrm flipV="1">
              <a:off x="4645080" y="7758360"/>
              <a:ext cx="0" cy="172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Straight Connector 92"/>
            <p:cNvSpPr/>
            <p:nvPr/>
          </p:nvSpPr>
          <p:spPr>
            <a:xfrm>
              <a:off x="4616640" y="7756560"/>
              <a:ext cx="53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Straight Connector 93"/>
            <p:cNvSpPr/>
            <p:nvPr/>
          </p:nvSpPr>
          <p:spPr>
            <a:xfrm>
              <a:off x="4614840" y="7934400"/>
              <a:ext cx="53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Straight Connector 94"/>
            <p:cNvSpPr/>
            <p:nvPr/>
          </p:nvSpPr>
          <p:spPr>
            <a:xfrm flipV="1">
              <a:off x="5213520" y="8058240"/>
              <a:ext cx="0" cy="20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Straight Connector 95"/>
            <p:cNvSpPr/>
            <p:nvPr/>
          </p:nvSpPr>
          <p:spPr>
            <a:xfrm>
              <a:off x="5186520" y="8058240"/>
              <a:ext cx="53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Straight Connector 96"/>
            <p:cNvSpPr/>
            <p:nvPr/>
          </p:nvSpPr>
          <p:spPr>
            <a:xfrm>
              <a:off x="5186520" y="8263080"/>
              <a:ext cx="53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Straight Connector 98"/>
            <p:cNvSpPr/>
            <p:nvPr/>
          </p:nvSpPr>
          <p:spPr>
            <a:xfrm flipV="1">
              <a:off x="5791320" y="7216920"/>
              <a:ext cx="0" cy="80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Straight Connector 99"/>
            <p:cNvSpPr/>
            <p:nvPr/>
          </p:nvSpPr>
          <p:spPr>
            <a:xfrm>
              <a:off x="5767560" y="7216920"/>
              <a:ext cx="53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Straight Connector 100"/>
            <p:cNvSpPr/>
            <p:nvPr/>
          </p:nvSpPr>
          <p:spPr>
            <a:xfrm>
              <a:off x="5764320" y="7299360"/>
              <a:ext cx="5364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TextBox 3"/>
            <p:cNvSpPr/>
            <p:nvPr/>
          </p:nvSpPr>
          <p:spPr>
            <a:xfrm>
              <a:off x="4181400" y="8207280"/>
              <a:ext cx="21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0" name="Straight Connector 4"/>
          <p:cNvSpPr/>
          <p:nvPr/>
        </p:nvSpPr>
        <p:spPr>
          <a:xfrm>
            <a:off x="1536840" y="2666880"/>
            <a:ext cx="18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Box 1"/>
          <p:cNvSpPr/>
          <p:nvPr/>
        </p:nvSpPr>
        <p:spPr>
          <a:xfrm>
            <a:off x="2982960" y="2198520"/>
            <a:ext cx="332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BM                 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 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       3 J/cm</a:t>
            </a:r>
            <a:r>
              <a:rPr b="1" lang="en-US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  9 J/cm</a:t>
            </a:r>
            <a:r>
              <a:rPr b="1" lang="en-US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 15 J/cm</a:t>
            </a:r>
            <a:r>
              <a:rPr b="1" lang="en-US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21 J/cm</a:t>
            </a:r>
            <a:r>
              <a:rPr b="1" lang="en-US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 30 J/cm</a:t>
            </a:r>
            <a:r>
              <a:rPr b="1" lang="en-US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Box 50"/>
          <p:cNvSpPr/>
          <p:nvPr/>
        </p:nvSpPr>
        <p:spPr>
          <a:xfrm>
            <a:off x="376200" y="4151160"/>
            <a:ext cx="37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Box 50"/>
          <p:cNvSpPr/>
          <p:nvPr/>
        </p:nvSpPr>
        <p:spPr>
          <a:xfrm>
            <a:off x="3567240" y="417672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4" name="Group 28"/>
          <p:cNvGrpSpPr/>
          <p:nvPr/>
        </p:nvGrpSpPr>
        <p:grpSpPr>
          <a:xfrm>
            <a:off x="3684600" y="4284720"/>
            <a:ext cx="2690640" cy="1980720"/>
            <a:chOff x="3684600" y="4284720"/>
            <a:chExt cx="2690640" cy="1980720"/>
          </a:xfrm>
        </p:grpSpPr>
        <p:graphicFrame>
          <p:nvGraphicFramePr>
            <p:cNvPr id="315" name="Chart 125"/>
            <p:cNvGraphicFramePr/>
            <p:nvPr/>
          </p:nvGraphicFramePr>
          <p:xfrm>
            <a:off x="3684600" y="4284720"/>
            <a:ext cx="2690640" cy="1939320"/>
          </p:xfrm>
          <a:graphic>
            <a:graphicData uri="http://schemas.openxmlformats.org/presentationml/2006/ole">
              <p:oleObj progId="Excel.Sheet.12" r:id="rId24" spid="">
                <p:embed/>
                <p:pic>
                  <p:nvPicPr>
                    <p:cNvPr id="316" name="Chart 125" descr=""/>
                    <p:cNvPicPr/>
                    <p:nvPr/>
                  </p:nvPicPr>
                  <p:blipFill>
                    <a:blip r:embed="rId25"/>
                    <a:stretch/>
                  </p:blipFill>
                  <p:spPr>
                    <a:xfrm>
                      <a:off x="3684600" y="4284720"/>
                      <a:ext cx="2690640" cy="1939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17" name="Straight Connector 104"/>
            <p:cNvSpPr/>
            <p:nvPr/>
          </p:nvSpPr>
          <p:spPr>
            <a:xfrm flipV="1">
              <a:off x="5773680" y="4544640"/>
              <a:ext cx="0" cy="4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Straight Connector 105"/>
            <p:cNvSpPr/>
            <p:nvPr/>
          </p:nvSpPr>
          <p:spPr>
            <a:xfrm flipV="1">
              <a:off x="4593960" y="4727520"/>
              <a:ext cx="0" cy="58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Straight Connector 106"/>
            <p:cNvSpPr/>
            <p:nvPr/>
          </p:nvSpPr>
          <p:spPr>
            <a:xfrm flipV="1">
              <a:off x="5187960" y="471960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Straight Connector 107"/>
            <p:cNvSpPr/>
            <p:nvPr/>
          </p:nvSpPr>
          <p:spPr>
            <a:xfrm flipH="1">
              <a:off x="4596840" y="4724280"/>
              <a:ext cx="59364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Straight Connector 108"/>
            <p:cNvSpPr/>
            <p:nvPr/>
          </p:nvSpPr>
          <p:spPr>
            <a:xfrm flipV="1">
              <a:off x="4593960" y="454500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Straight Connector 109"/>
            <p:cNvSpPr/>
            <p:nvPr/>
          </p:nvSpPr>
          <p:spPr>
            <a:xfrm flipH="1">
              <a:off x="4596840" y="4540320"/>
              <a:ext cx="1181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TextBox 82"/>
            <p:cNvSpPr/>
            <p:nvPr/>
          </p:nvSpPr>
          <p:spPr>
            <a:xfrm>
              <a:off x="4349520" y="5958720"/>
              <a:ext cx="493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TextBox 84"/>
            <p:cNvSpPr/>
            <p:nvPr/>
          </p:nvSpPr>
          <p:spPr>
            <a:xfrm>
              <a:off x="4987800" y="5963760"/>
              <a:ext cx="377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TextBox 85"/>
            <p:cNvSpPr/>
            <p:nvPr/>
          </p:nvSpPr>
          <p:spPr>
            <a:xfrm>
              <a:off x="5412600" y="5958360"/>
              <a:ext cx="657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B431542 + PB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Straight Connector 113"/>
            <p:cNvSpPr/>
            <p:nvPr/>
          </p:nvSpPr>
          <p:spPr>
            <a:xfrm>
              <a:off x="4286160" y="5969160"/>
              <a:ext cx="1725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7" name="Group 113"/>
          <p:cNvGrpSpPr/>
          <p:nvPr/>
        </p:nvGrpSpPr>
        <p:grpSpPr>
          <a:xfrm>
            <a:off x="625320" y="4127400"/>
            <a:ext cx="2611440" cy="2102040"/>
            <a:chOff x="625320" y="4127400"/>
            <a:chExt cx="2611440" cy="2102040"/>
          </a:xfrm>
        </p:grpSpPr>
        <p:pic>
          <p:nvPicPr>
            <p:cNvPr id="328" name="Picture 4" descr=""/>
            <p:cNvPicPr/>
            <p:nvPr/>
          </p:nvPicPr>
          <p:blipFill>
            <a:blip r:embed="rId26"/>
            <a:srcRect l="7029" t="3716" r="0" b="47896"/>
            <a:stretch/>
          </p:blipFill>
          <p:spPr>
            <a:xfrm>
              <a:off x="803520" y="4245480"/>
              <a:ext cx="2433240" cy="198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9" name="Freeform: Shape 116"/>
            <p:cNvSpPr/>
            <p:nvPr/>
          </p:nvSpPr>
          <p:spPr>
            <a:xfrm>
              <a:off x="813960" y="4481280"/>
              <a:ext cx="1185840" cy="55440"/>
            </a:xfrm>
            <a:custGeom>
              <a:avLst/>
              <a:gdLst/>
              <a:ahLst/>
              <a:rect l="l" t="t" r="r" b="b"/>
              <a:pathLst>
                <a:path w="1249680" h="68845">
                  <a:moveTo>
                    <a:pt x="0" y="68845"/>
                  </a:moveTo>
                  <a:cubicBezTo>
                    <a:pt x="61595" y="55510"/>
                    <a:pt x="123190" y="42175"/>
                    <a:pt x="167640" y="38365"/>
                  </a:cubicBezTo>
                  <a:cubicBezTo>
                    <a:pt x="212090" y="34555"/>
                    <a:pt x="227330" y="40905"/>
                    <a:pt x="266700" y="45985"/>
                  </a:cubicBezTo>
                  <a:cubicBezTo>
                    <a:pt x="306070" y="51065"/>
                    <a:pt x="359410" y="68845"/>
                    <a:pt x="403860" y="68845"/>
                  </a:cubicBezTo>
                  <a:cubicBezTo>
                    <a:pt x="448310" y="68845"/>
                    <a:pt x="491490" y="52335"/>
                    <a:pt x="533400" y="45985"/>
                  </a:cubicBezTo>
                  <a:cubicBezTo>
                    <a:pt x="575310" y="39635"/>
                    <a:pt x="613410" y="30745"/>
                    <a:pt x="655320" y="30745"/>
                  </a:cubicBezTo>
                  <a:cubicBezTo>
                    <a:pt x="697230" y="30745"/>
                    <a:pt x="748030" y="45985"/>
                    <a:pt x="784860" y="45985"/>
                  </a:cubicBezTo>
                  <a:cubicBezTo>
                    <a:pt x="821690" y="45985"/>
                    <a:pt x="852170" y="38365"/>
                    <a:pt x="876300" y="30745"/>
                  </a:cubicBezTo>
                  <a:cubicBezTo>
                    <a:pt x="900430" y="23125"/>
                    <a:pt x="902970" y="2805"/>
                    <a:pt x="929640" y="265"/>
                  </a:cubicBezTo>
                  <a:cubicBezTo>
                    <a:pt x="956310" y="-2275"/>
                    <a:pt x="1000760" y="14235"/>
                    <a:pt x="1036320" y="15505"/>
                  </a:cubicBezTo>
                  <a:cubicBezTo>
                    <a:pt x="1071880" y="16775"/>
                    <a:pt x="1107440" y="9155"/>
                    <a:pt x="1143000" y="7885"/>
                  </a:cubicBezTo>
                  <a:cubicBezTo>
                    <a:pt x="1178560" y="6615"/>
                    <a:pt x="1214120" y="7250"/>
                    <a:pt x="1249680" y="7885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: Shape 117"/>
            <p:cNvSpPr/>
            <p:nvPr/>
          </p:nvSpPr>
          <p:spPr>
            <a:xfrm>
              <a:off x="798120" y="5014800"/>
              <a:ext cx="1190520" cy="75960"/>
            </a:xfrm>
            <a:custGeom>
              <a:avLst/>
              <a:gdLst/>
              <a:ahLst/>
              <a:rect l="l" t="t" r="r" b="b"/>
              <a:pathLst>
                <a:path w="1228725" h="77640">
                  <a:moveTo>
                    <a:pt x="0" y="34200"/>
                  </a:moveTo>
                  <a:cubicBezTo>
                    <a:pt x="25400" y="50869"/>
                    <a:pt x="50801" y="67538"/>
                    <a:pt x="71438" y="72300"/>
                  </a:cubicBezTo>
                  <a:cubicBezTo>
                    <a:pt x="92075" y="77062"/>
                    <a:pt x="123825" y="62775"/>
                    <a:pt x="123825" y="62775"/>
                  </a:cubicBezTo>
                  <a:cubicBezTo>
                    <a:pt x="140494" y="59600"/>
                    <a:pt x="154781" y="50869"/>
                    <a:pt x="171450" y="53250"/>
                  </a:cubicBezTo>
                  <a:cubicBezTo>
                    <a:pt x="188119" y="55631"/>
                    <a:pt x="205582" y="81825"/>
                    <a:pt x="223838" y="77063"/>
                  </a:cubicBezTo>
                  <a:cubicBezTo>
                    <a:pt x="242094" y="72301"/>
                    <a:pt x="260351" y="30231"/>
                    <a:pt x="280988" y="24675"/>
                  </a:cubicBezTo>
                  <a:cubicBezTo>
                    <a:pt x="301625" y="19119"/>
                    <a:pt x="334169" y="38962"/>
                    <a:pt x="347663" y="43725"/>
                  </a:cubicBezTo>
                  <a:cubicBezTo>
                    <a:pt x="361157" y="48488"/>
                    <a:pt x="346075" y="51663"/>
                    <a:pt x="361950" y="53250"/>
                  </a:cubicBezTo>
                  <a:cubicBezTo>
                    <a:pt x="377825" y="54838"/>
                    <a:pt x="426244" y="51663"/>
                    <a:pt x="442913" y="53250"/>
                  </a:cubicBezTo>
                  <a:cubicBezTo>
                    <a:pt x="459582" y="54837"/>
                    <a:pt x="450851" y="65156"/>
                    <a:pt x="461963" y="62775"/>
                  </a:cubicBezTo>
                  <a:cubicBezTo>
                    <a:pt x="473076" y="60394"/>
                    <a:pt x="494507" y="44519"/>
                    <a:pt x="509588" y="38963"/>
                  </a:cubicBezTo>
                  <a:cubicBezTo>
                    <a:pt x="524669" y="33407"/>
                    <a:pt x="538956" y="31819"/>
                    <a:pt x="552450" y="29438"/>
                  </a:cubicBezTo>
                  <a:cubicBezTo>
                    <a:pt x="565944" y="27057"/>
                    <a:pt x="573088" y="23881"/>
                    <a:pt x="590550" y="24675"/>
                  </a:cubicBezTo>
                  <a:cubicBezTo>
                    <a:pt x="608012" y="25469"/>
                    <a:pt x="638969" y="30231"/>
                    <a:pt x="657225" y="34200"/>
                  </a:cubicBezTo>
                  <a:cubicBezTo>
                    <a:pt x="675481" y="38169"/>
                    <a:pt x="688976" y="46107"/>
                    <a:pt x="700088" y="48488"/>
                  </a:cubicBezTo>
                  <a:cubicBezTo>
                    <a:pt x="711200" y="50869"/>
                    <a:pt x="715169" y="54044"/>
                    <a:pt x="723900" y="48488"/>
                  </a:cubicBezTo>
                  <a:cubicBezTo>
                    <a:pt x="732631" y="42932"/>
                    <a:pt x="731838" y="21500"/>
                    <a:pt x="752475" y="15150"/>
                  </a:cubicBezTo>
                  <a:cubicBezTo>
                    <a:pt x="773112" y="8800"/>
                    <a:pt x="823119" y="9594"/>
                    <a:pt x="847725" y="10388"/>
                  </a:cubicBezTo>
                  <a:cubicBezTo>
                    <a:pt x="872331" y="11182"/>
                    <a:pt x="881857" y="21500"/>
                    <a:pt x="900113" y="19913"/>
                  </a:cubicBezTo>
                  <a:cubicBezTo>
                    <a:pt x="918369" y="18325"/>
                    <a:pt x="939801" y="-4693"/>
                    <a:pt x="957263" y="863"/>
                  </a:cubicBezTo>
                  <a:cubicBezTo>
                    <a:pt x="974725" y="6419"/>
                    <a:pt x="989807" y="42931"/>
                    <a:pt x="1004888" y="53250"/>
                  </a:cubicBezTo>
                  <a:cubicBezTo>
                    <a:pt x="1019969" y="63569"/>
                    <a:pt x="1021556" y="65950"/>
                    <a:pt x="1047750" y="62775"/>
                  </a:cubicBezTo>
                  <a:cubicBezTo>
                    <a:pt x="1073944" y="59600"/>
                    <a:pt x="1135063" y="39756"/>
                    <a:pt x="1162050" y="34200"/>
                  </a:cubicBezTo>
                  <a:cubicBezTo>
                    <a:pt x="1189037" y="28644"/>
                    <a:pt x="1209675" y="29438"/>
                    <a:pt x="1209675" y="29438"/>
                  </a:cubicBezTo>
                  <a:cubicBezTo>
                    <a:pt x="1220788" y="27057"/>
                    <a:pt x="1228725" y="19913"/>
                    <a:pt x="1228725" y="19913"/>
                  </a:cubicBezTo>
                  <a:lnTo>
                    <a:pt x="1228725" y="19913"/>
                  </a:ln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Freeform: Shape 118"/>
            <p:cNvSpPr/>
            <p:nvPr/>
          </p:nvSpPr>
          <p:spPr>
            <a:xfrm>
              <a:off x="2049480" y="4474800"/>
              <a:ext cx="1185840" cy="55440"/>
            </a:xfrm>
            <a:custGeom>
              <a:avLst/>
              <a:gdLst/>
              <a:ahLst/>
              <a:rect l="l" t="t" r="r" b="b"/>
              <a:pathLst>
                <a:path w="1223962" h="57150">
                  <a:moveTo>
                    <a:pt x="0" y="42862"/>
                  </a:moveTo>
                  <a:cubicBezTo>
                    <a:pt x="32147" y="46831"/>
                    <a:pt x="64294" y="50800"/>
                    <a:pt x="95250" y="47625"/>
                  </a:cubicBezTo>
                  <a:cubicBezTo>
                    <a:pt x="126206" y="44450"/>
                    <a:pt x="185737" y="23812"/>
                    <a:pt x="185737" y="23812"/>
                  </a:cubicBezTo>
                  <a:cubicBezTo>
                    <a:pt x="216693" y="15875"/>
                    <a:pt x="247650" y="0"/>
                    <a:pt x="280987" y="0"/>
                  </a:cubicBezTo>
                  <a:cubicBezTo>
                    <a:pt x="314324" y="0"/>
                    <a:pt x="357187" y="21431"/>
                    <a:pt x="385762" y="23812"/>
                  </a:cubicBezTo>
                  <a:cubicBezTo>
                    <a:pt x="414337" y="26193"/>
                    <a:pt x="421481" y="15874"/>
                    <a:pt x="452437" y="14287"/>
                  </a:cubicBezTo>
                  <a:cubicBezTo>
                    <a:pt x="483393" y="12699"/>
                    <a:pt x="534194" y="11906"/>
                    <a:pt x="571500" y="14287"/>
                  </a:cubicBezTo>
                  <a:cubicBezTo>
                    <a:pt x="608806" y="16668"/>
                    <a:pt x="642938" y="26194"/>
                    <a:pt x="676275" y="28575"/>
                  </a:cubicBezTo>
                  <a:cubicBezTo>
                    <a:pt x="709612" y="30956"/>
                    <a:pt x="771525" y="28575"/>
                    <a:pt x="771525" y="28575"/>
                  </a:cubicBezTo>
                  <a:lnTo>
                    <a:pt x="885825" y="28575"/>
                  </a:lnTo>
                  <a:cubicBezTo>
                    <a:pt x="916781" y="28575"/>
                    <a:pt x="924718" y="25400"/>
                    <a:pt x="957262" y="28575"/>
                  </a:cubicBezTo>
                  <a:cubicBezTo>
                    <a:pt x="989806" y="31750"/>
                    <a:pt x="1049337" y="43656"/>
                    <a:pt x="1081087" y="47625"/>
                  </a:cubicBezTo>
                  <a:cubicBezTo>
                    <a:pt x="1112837" y="51594"/>
                    <a:pt x="1130300" y="51593"/>
                    <a:pt x="1147762" y="52387"/>
                  </a:cubicBezTo>
                  <a:cubicBezTo>
                    <a:pt x="1165224" y="53181"/>
                    <a:pt x="1173162" y="51593"/>
                    <a:pt x="1185862" y="52387"/>
                  </a:cubicBezTo>
                  <a:cubicBezTo>
                    <a:pt x="1198562" y="53181"/>
                    <a:pt x="1211262" y="55165"/>
                    <a:pt x="1223962" y="57150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: Shape 119"/>
            <p:cNvSpPr/>
            <p:nvPr/>
          </p:nvSpPr>
          <p:spPr>
            <a:xfrm>
              <a:off x="2035080" y="5045040"/>
              <a:ext cx="1195200" cy="36360"/>
            </a:xfrm>
            <a:custGeom>
              <a:avLst/>
              <a:gdLst/>
              <a:ahLst/>
              <a:rect l="l" t="t" r="r" b="b"/>
              <a:pathLst>
                <a:path w="1233488" h="38254">
                  <a:moveTo>
                    <a:pt x="0" y="23923"/>
                  </a:moveTo>
                  <a:cubicBezTo>
                    <a:pt x="44847" y="15191"/>
                    <a:pt x="89694" y="6460"/>
                    <a:pt x="123825" y="4873"/>
                  </a:cubicBezTo>
                  <a:cubicBezTo>
                    <a:pt x="157956" y="3286"/>
                    <a:pt x="177007" y="15192"/>
                    <a:pt x="204788" y="14398"/>
                  </a:cubicBezTo>
                  <a:cubicBezTo>
                    <a:pt x="232569" y="13604"/>
                    <a:pt x="246857" y="111"/>
                    <a:pt x="290513" y="111"/>
                  </a:cubicBezTo>
                  <a:cubicBezTo>
                    <a:pt x="334169" y="111"/>
                    <a:pt x="411163" y="14398"/>
                    <a:pt x="466725" y="14398"/>
                  </a:cubicBezTo>
                  <a:cubicBezTo>
                    <a:pt x="522287" y="14398"/>
                    <a:pt x="587376" y="-1476"/>
                    <a:pt x="623888" y="111"/>
                  </a:cubicBezTo>
                  <a:cubicBezTo>
                    <a:pt x="660400" y="1698"/>
                    <a:pt x="665163" y="17573"/>
                    <a:pt x="685800" y="23923"/>
                  </a:cubicBezTo>
                  <a:cubicBezTo>
                    <a:pt x="706437" y="30273"/>
                    <a:pt x="729457" y="37417"/>
                    <a:pt x="747713" y="38211"/>
                  </a:cubicBezTo>
                  <a:cubicBezTo>
                    <a:pt x="765969" y="39005"/>
                    <a:pt x="795338" y="28686"/>
                    <a:pt x="795338" y="28686"/>
                  </a:cubicBezTo>
                  <a:cubicBezTo>
                    <a:pt x="814388" y="24717"/>
                    <a:pt x="842169" y="16779"/>
                    <a:pt x="862013" y="14398"/>
                  </a:cubicBezTo>
                  <a:cubicBezTo>
                    <a:pt x="881857" y="12017"/>
                    <a:pt x="895350" y="12017"/>
                    <a:pt x="914400" y="14398"/>
                  </a:cubicBezTo>
                  <a:cubicBezTo>
                    <a:pt x="933450" y="16779"/>
                    <a:pt x="953294" y="25511"/>
                    <a:pt x="976313" y="28686"/>
                  </a:cubicBezTo>
                  <a:cubicBezTo>
                    <a:pt x="999332" y="31861"/>
                    <a:pt x="1031082" y="33448"/>
                    <a:pt x="1052513" y="33448"/>
                  </a:cubicBezTo>
                  <a:cubicBezTo>
                    <a:pt x="1073944" y="33448"/>
                    <a:pt x="1081088" y="32655"/>
                    <a:pt x="1104900" y="28686"/>
                  </a:cubicBezTo>
                  <a:cubicBezTo>
                    <a:pt x="1128712" y="24717"/>
                    <a:pt x="1173957" y="9636"/>
                    <a:pt x="1195388" y="9636"/>
                  </a:cubicBezTo>
                  <a:cubicBezTo>
                    <a:pt x="1216819" y="9636"/>
                    <a:pt x="1225153" y="19161"/>
                    <a:pt x="1233488" y="28686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: Shape 120"/>
            <p:cNvSpPr/>
            <p:nvPr/>
          </p:nvSpPr>
          <p:spPr>
            <a:xfrm>
              <a:off x="802800" y="5446800"/>
              <a:ext cx="1195200" cy="110880"/>
            </a:xfrm>
            <a:custGeom>
              <a:avLst/>
              <a:gdLst/>
              <a:ahLst/>
              <a:rect l="l" t="t" r="r" b="b"/>
              <a:pathLst>
                <a:path w="1233487" h="114716">
                  <a:moveTo>
                    <a:pt x="0" y="38222"/>
                  </a:moveTo>
                  <a:cubicBezTo>
                    <a:pt x="76993" y="28697"/>
                    <a:pt x="153987" y="19172"/>
                    <a:pt x="204787" y="19172"/>
                  </a:cubicBezTo>
                  <a:cubicBezTo>
                    <a:pt x="255587" y="19172"/>
                    <a:pt x="265906" y="38222"/>
                    <a:pt x="304800" y="38222"/>
                  </a:cubicBezTo>
                  <a:cubicBezTo>
                    <a:pt x="343694" y="38222"/>
                    <a:pt x="404019" y="25522"/>
                    <a:pt x="438150" y="19172"/>
                  </a:cubicBezTo>
                  <a:cubicBezTo>
                    <a:pt x="472281" y="12822"/>
                    <a:pt x="472281" y="-1465"/>
                    <a:pt x="509587" y="122"/>
                  </a:cubicBezTo>
                  <a:cubicBezTo>
                    <a:pt x="546893" y="1709"/>
                    <a:pt x="621506" y="16791"/>
                    <a:pt x="661987" y="28697"/>
                  </a:cubicBezTo>
                  <a:cubicBezTo>
                    <a:pt x="702468" y="40603"/>
                    <a:pt x="722313" y="62828"/>
                    <a:pt x="752475" y="71559"/>
                  </a:cubicBezTo>
                  <a:cubicBezTo>
                    <a:pt x="782637" y="80290"/>
                    <a:pt x="815975" y="78703"/>
                    <a:pt x="842962" y="81084"/>
                  </a:cubicBezTo>
                  <a:cubicBezTo>
                    <a:pt x="869950" y="83465"/>
                    <a:pt x="895350" y="85053"/>
                    <a:pt x="914400" y="85847"/>
                  </a:cubicBezTo>
                  <a:cubicBezTo>
                    <a:pt x="933450" y="86641"/>
                    <a:pt x="936625" y="81085"/>
                    <a:pt x="957262" y="85847"/>
                  </a:cubicBezTo>
                  <a:cubicBezTo>
                    <a:pt x="977899" y="90609"/>
                    <a:pt x="1014412" y="112041"/>
                    <a:pt x="1038225" y="114422"/>
                  </a:cubicBezTo>
                  <a:cubicBezTo>
                    <a:pt x="1062038" y="116803"/>
                    <a:pt x="1081087" y="104103"/>
                    <a:pt x="1100137" y="100134"/>
                  </a:cubicBezTo>
                  <a:cubicBezTo>
                    <a:pt x="1119187" y="96165"/>
                    <a:pt x="1132681" y="90609"/>
                    <a:pt x="1152525" y="90609"/>
                  </a:cubicBezTo>
                  <a:cubicBezTo>
                    <a:pt x="1172369" y="90609"/>
                    <a:pt x="1206500" y="99340"/>
                    <a:pt x="1219200" y="100134"/>
                  </a:cubicBezTo>
                  <a:cubicBezTo>
                    <a:pt x="1231900" y="100928"/>
                    <a:pt x="1228725" y="95372"/>
                    <a:pt x="1228725" y="95372"/>
                  </a:cubicBezTo>
                  <a:cubicBezTo>
                    <a:pt x="1231106" y="92197"/>
                    <a:pt x="1233487" y="82671"/>
                    <a:pt x="1233487" y="81084"/>
                  </a:cubicBezTo>
                  <a:cubicBezTo>
                    <a:pt x="1233487" y="79497"/>
                    <a:pt x="1231106" y="82672"/>
                    <a:pt x="1228725" y="85847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: Shape 121"/>
            <p:cNvSpPr/>
            <p:nvPr/>
          </p:nvSpPr>
          <p:spPr>
            <a:xfrm>
              <a:off x="807840" y="5883480"/>
              <a:ext cx="1190520" cy="128520"/>
            </a:xfrm>
            <a:custGeom>
              <a:avLst/>
              <a:gdLst/>
              <a:ahLst/>
              <a:rect l="l" t="t" r="r" b="b"/>
              <a:pathLst>
                <a:path w="1224590" h="112489">
                  <a:moveTo>
                    <a:pt x="0" y="97249"/>
                  </a:moveTo>
                  <a:cubicBezTo>
                    <a:pt x="24209" y="106377"/>
                    <a:pt x="48419" y="115505"/>
                    <a:pt x="66675" y="111536"/>
                  </a:cubicBezTo>
                  <a:cubicBezTo>
                    <a:pt x="84931" y="107567"/>
                    <a:pt x="85726" y="76611"/>
                    <a:pt x="109538" y="73436"/>
                  </a:cubicBezTo>
                  <a:cubicBezTo>
                    <a:pt x="133351" y="70261"/>
                    <a:pt x="186531" y="88517"/>
                    <a:pt x="209550" y="92486"/>
                  </a:cubicBezTo>
                  <a:cubicBezTo>
                    <a:pt x="232569" y="96455"/>
                    <a:pt x="233363" y="102805"/>
                    <a:pt x="247650" y="97249"/>
                  </a:cubicBezTo>
                  <a:cubicBezTo>
                    <a:pt x="261938" y="91693"/>
                    <a:pt x="284163" y="67086"/>
                    <a:pt x="295275" y="59149"/>
                  </a:cubicBezTo>
                  <a:cubicBezTo>
                    <a:pt x="306388" y="51211"/>
                    <a:pt x="290513" y="59149"/>
                    <a:pt x="314325" y="49624"/>
                  </a:cubicBezTo>
                  <a:cubicBezTo>
                    <a:pt x="338138" y="40099"/>
                    <a:pt x="408781" y="8349"/>
                    <a:pt x="438150" y="1999"/>
                  </a:cubicBezTo>
                  <a:cubicBezTo>
                    <a:pt x="467519" y="-4351"/>
                    <a:pt x="473076" y="5968"/>
                    <a:pt x="490538" y="11524"/>
                  </a:cubicBezTo>
                  <a:cubicBezTo>
                    <a:pt x="508000" y="17080"/>
                    <a:pt x="527050" y="28986"/>
                    <a:pt x="542925" y="35336"/>
                  </a:cubicBezTo>
                  <a:cubicBezTo>
                    <a:pt x="558800" y="41686"/>
                    <a:pt x="564357" y="46449"/>
                    <a:pt x="585788" y="49624"/>
                  </a:cubicBezTo>
                  <a:cubicBezTo>
                    <a:pt x="607219" y="52799"/>
                    <a:pt x="654051" y="55973"/>
                    <a:pt x="671513" y="54386"/>
                  </a:cubicBezTo>
                  <a:cubicBezTo>
                    <a:pt x="688975" y="52799"/>
                    <a:pt x="674688" y="42480"/>
                    <a:pt x="690563" y="40099"/>
                  </a:cubicBezTo>
                  <a:cubicBezTo>
                    <a:pt x="706438" y="37718"/>
                    <a:pt x="747713" y="37718"/>
                    <a:pt x="766763" y="40099"/>
                  </a:cubicBezTo>
                  <a:cubicBezTo>
                    <a:pt x="785813" y="42480"/>
                    <a:pt x="785019" y="48036"/>
                    <a:pt x="804863" y="54386"/>
                  </a:cubicBezTo>
                  <a:cubicBezTo>
                    <a:pt x="824707" y="60736"/>
                    <a:pt x="861219" y="69468"/>
                    <a:pt x="885825" y="78199"/>
                  </a:cubicBezTo>
                  <a:cubicBezTo>
                    <a:pt x="910431" y="86930"/>
                    <a:pt x="935037" y="102805"/>
                    <a:pt x="952500" y="106774"/>
                  </a:cubicBezTo>
                  <a:cubicBezTo>
                    <a:pt x="969963" y="110743"/>
                    <a:pt x="976313" y="102805"/>
                    <a:pt x="990600" y="102011"/>
                  </a:cubicBezTo>
                  <a:cubicBezTo>
                    <a:pt x="1004887" y="101217"/>
                    <a:pt x="1019175" y="108361"/>
                    <a:pt x="1038225" y="102011"/>
                  </a:cubicBezTo>
                  <a:cubicBezTo>
                    <a:pt x="1057275" y="95661"/>
                    <a:pt x="1081881" y="67086"/>
                    <a:pt x="1104900" y="63911"/>
                  </a:cubicBezTo>
                  <a:cubicBezTo>
                    <a:pt x="1127919" y="60736"/>
                    <a:pt x="1157288" y="75817"/>
                    <a:pt x="1176338" y="82961"/>
                  </a:cubicBezTo>
                  <a:cubicBezTo>
                    <a:pt x="1195388" y="90105"/>
                    <a:pt x="1211263" y="102805"/>
                    <a:pt x="1219200" y="106774"/>
                  </a:cubicBezTo>
                  <a:cubicBezTo>
                    <a:pt x="1227138" y="110743"/>
                    <a:pt x="1223963" y="106774"/>
                    <a:pt x="1223963" y="106774"/>
                  </a:cubicBezTo>
                  <a:lnTo>
                    <a:pt x="1223963" y="106774"/>
                  </a:ln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: Shape 122"/>
            <p:cNvSpPr/>
            <p:nvPr/>
          </p:nvSpPr>
          <p:spPr>
            <a:xfrm>
              <a:off x="2035080" y="5516640"/>
              <a:ext cx="1173240" cy="64800"/>
            </a:xfrm>
            <a:custGeom>
              <a:avLst/>
              <a:gdLst/>
              <a:ahLst/>
              <a:rect l="l" t="t" r="r" b="b"/>
              <a:pathLst>
                <a:path w="1209675" h="66675">
                  <a:moveTo>
                    <a:pt x="0" y="28575"/>
                  </a:moveTo>
                  <a:cubicBezTo>
                    <a:pt x="55563" y="21828"/>
                    <a:pt x="111126" y="15082"/>
                    <a:pt x="147638" y="14288"/>
                  </a:cubicBezTo>
                  <a:cubicBezTo>
                    <a:pt x="184151" y="13494"/>
                    <a:pt x="192881" y="23019"/>
                    <a:pt x="219075" y="23813"/>
                  </a:cubicBezTo>
                  <a:cubicBezTo>
                    <a:pt x="245269" y="24607"/>
                    <a:pt x="276225" y="23019"/>
                    <a:pt x="304800" y="19050"/>
                  </a:cubicBezTo>
                  <a:cubicBezTo>
                    <a:pt x="333375" y="15081"/>
                    <a:pt x="361950" y="0"/>
                    <a:pt x="390525" y="0"/>
                  </a:cubicBezTo>
                  <a:cubicBezTo>
                    <a:pt x="419100" y="0"/>
                    <a:pt x="446088" y="11906"/>
                    <a:pt x="476250" y="19050"/>
                  </a:cubicBezTo>
                  <a:cubicBezTo>
                    <a:pt x="506412" y="26194"/>
                    <a:pt x="571500" y="42863"/>
                    <a:pt x="571500" y="42863"/>
                  </a:cubicBezTo>
                  <a:cubicBezTo>
                    <a:pt x="602456" y="50800"/>
                    <a:pt x="627063" y="66675"/>
                    <a:pt x="661988" y="66675"/>
                  </a:cubicBezTo>
                  <a:cubicBezTo>
                    <a:pt x="696913" y="66675"/>
                    <a:pt x="751681" y="46832"/>
                    <a:pt x="781050" y="42863"/>
                  </a:cubicBezTo>
                  <a:cubicBezTo>
                    <a:pt x="810419" y="38894"/>
                    <a:pt x="809625" y="47625"/>
                    <a:pt x="838200" y="42863"/>
                  </a:cubicBezTo>
                  <a:cubicBezTo>
                    <a:pt x="866775" y="38101"/>
                    <a:pt x="920750" y="19050"/>
                    <a:pt x="952500" y="14288"/>
                  </a:cubicBezTo>
                  <a:cubicBezTo>
                    <a:pt x="984250" y="9526"/>
                    <a:pt x="1028700" y="14288"/>
                    <a:pt x="1028700" y="14288"/>
                  </a:cubicBezTo>
                  <a:lnTo>
                    <a:pt x="1095375" y="14288"/>
                  </a:lnTo>
                  <a:lnTo>
                    <a:pt x="1190625" y="14288"/>
                  </a:lnTo>
                  <a:lnTo>
                    <a:pt x="1209675" y="14288"/>
                  </a:ln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: Shape 123"/>
            <p:cNvSpPr/>
            <p:nvPr/>
          </p:nvSpPr>
          <p:spPr>
            <a:xfrm>
              <a:off x="2044440" y="5888160"/>
              <a:ext cx="1190520" cy="82440"/>
            </a:xfrm>
            <a:custGeom>
              <a:avLst/>
              <a:gdLst/>
              <a:ahLst/>
              <a:rect l="l" t="t" r="r" b="b"/>
              <a:pathLst>
                <a:path w="1228725" h="83060">
                  <a:moveTo>
                    <a:pt x="0" y="63211"/>
                  </a:moveTo>
                  <a:cubicBezTo>
                    <a:pt x="25003" y="74720"/>
                    <a:pt x="50007" y="86230"/>
                    <a:pt x="71438" y="82261"/>
                  </a:cubicBezTo>
                  <a:cubicBezTo>
                    <a:pt x="92869" y="78292"/>
                    <a:pt x="105569" y="52892"/>
                    <a:pt x="128588" y="39398"/>
                  </a:cubicBezTo>
                  <a:cubicBezTo>
                    <a:pt x="151607" y="25904"/>
                    <a:pt x="179388" y="6060"/>
                    <a:pt x="209550" y="1298"/>
                  </a:cubicBezTo>
                  <a:cubicBezTo>
                    <a:pt x="239713" y="-3465"/>
                    <a:pt x="280194" y="6061"/>
                    <a:pt x="309563" y="10823"/>
                  </a:cubicBezTo>
                  <a:cubicBezTo>
                    <a:pt x="338932" y="15585"/>
                    <a:pt x="356394" y="25904"/>
                    <a:pt x="385763" y="29873"/>
                  </a:cubicBezTo>
                  <a:cubicBezTo>
                    <a:pt x="415132" y="33842"/>
                    <a:pt x="453231" y="36223"/>
                    <a:pt x="485775" y="34636"/>
                  </a:cubicBezTo>
                  <a:cubicBezTo>
                    <a:pt x="518319" y="33048"/>
                    <a:pt x="558006" y="25110"/>
                    <a:pt x="581025" y="20348"/>
                  </a:cubicBezTo>
                  <a:cubicBezTo>
                    <a:pt x="604044" y="15585"/>
                    <a:pt x="600869" y="7648"/>
                    <a:pt x="623888" y="6061"/>
                  </a:cubicBezTo>
                  <a:cubicBezTo>
                    <a:pt x="646907" y="4474"/>
                    <a:pt x="700882" y="9235"/>
                    <a:pt x="719138" y="10823"/>
                  </a:cubicBezTo>
                  <a:cubicBezTo>
                    <a:pt x="737394" y="12410"/>
                    <a:pt x="707231" y="11617"/>
                    <a:pt x="733425" y="15586"/>
                  </a:cubicBezTo>
                  <a:cubicBezTo>
                    <a:pt x="759619" y="19555"/>
                    <a:pt x="834231" y="29874"/>
                    <a:pt x="876300" y="34636"/>
                  </a:cubicBezTo>
                  <a:cubicBezTo>
                    <a:pt x="918369" y="39398"/>
                    <a:pt x="955676" y="43367"/>
                    <a:pt x="985838" y="44161"/>
                  </a:cubicBezTo>
                  <a:cubicBezTo>
                    <a:pt x="1016000" y="44955"/>
                    <a:pt x="1033462" y="41779"/>
                    <a:pt x="1057275" y="39398"/>
                  </a:cubicBezTo>
                  <a:cubicBezTo>
                    <a:pt x="1081088" y="37017"/>
                    <a:pt x="1107282" y="30667"/>
                    <a:pt x="1128713" y="29873"/>
                  </a:cubicBezTo>
                  <a:cubicBezTo>
                    <a:pt x="1150144" y="29079"/>
                    <a:pt x="1175544" y="33048"/>
                    <a:pt x="1185863" y="34636"/>
                  </a:cubicBezTo>
                  <a:cubicBezTo>
                    <a:pt x="1196182" y="36223"/>
                    <a:pt x="1183481" y="39398"/>
                    <a:pt x="1190625" y="39398"/>
                  </a:cubicBezTo>
                  <a:cubicBezTo>
                    <a:pt x="1197769" y="39398"/>
                    <a:pt x="1213247" y="37017"/>
                    <a:pt x="1228725" y="34636"/>
                  </a:cubicBezTo>
                </a:path>
              </a:pathLst>
            </a:custGeom>
            <a:noFill/>
            <a:ln w="6480">
              <a:solidFill>
                <a:srgbClr val="c00000"/>
              </a:solidFill>
              <a:prstDash val="sysDash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TextBox 66"/>
            <p:cNvSpPr/>
            <p:nvPr/>
          </p:nvSpPr>
          <p:spPr>
            <a:xfrm>
              <a:off x="1112400" y="4127400"/>
              <a:ext cx="54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TextBox 67"/>
            <p:cNvSpPr/>
            <p:nvPr/>
          </p:nvSpPr>
          <p:spPr>
            <a:xfrm>
              <a:off x="2373120" y="4127400"/>
              <a:ext cx="40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TextBox 68"/>
            <p:cNvSpPr/>
            <p:nvPr/>
          </p:nvSpPr>
          <p:spPr>
            <a:xfrm rot="16200000">
              <a:off x="508680" y="4671720"/>
              <a:ext cx="448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hou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TextBox 69"/>
            <p:cNvSpPr/>
            <p:nvPr/>
          </p:nvSpPr>
          <p:spPr>
            <a:xfrm rot="16200000">
              <a:off x="476640" y="5582520"/>
              <a:ext cx="497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 hou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1" name="Straight Connector 8"/>
          <p:cNvSpPr/>
          <p:nvPr/>
        </p:nvSpPr>
        <p:spPr>
          <a:xfrm>
            <a:off x="1333440" y="831960"/>
            <a:ext cx="471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Straight Connector 124"/>
          <p:cNvSpPr/>
          <p:nvPr/>
        </p:nvSpPr>
        <p:spPr>
          <a:xfrm>
            <a:off x="1335240" y="733320"/>
            <a:ext cx="1407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Straight Connector 125"/>
          <p:cNvSpPr/>
          <p:nvPr/>
        </p:nvSpPr>
        <p:spPr>
          <a:xfrm>
            <a:off x="1335240" y="779400"/>
            <a:ext cx="939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Straight Connector 130"/>
          <p:cNvSpPr/>
          <p:nvPr/>
        </p:nvSpPr>
        <p:spPr>
          <a:xfrm>
            <a:off x="1333440" y="830160"/>
            <a:ext cx="0" cy="198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Straight Connector 131"/>
          <p:cNvSpPr/>
          <p:nvPr/>
        </p:nvSpPr>
        <p:spPr>
          <a:xfrm>
            <a:off x="2273400" y="781200"/>
            <a:ext cx="0" cy="104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Straight Connector 135"/>
          <p:cNvSpPr/>
          <p:nvPr/>
        </p:nvSpPr>
        <p:spPr>
          <a:xfrm>
            <a:off x="2738520" y="731880"/>
            <a:ext cx="0" cy="189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7" name="Picture 26" descr=""/>
          <p:cNvPicPr/>
          <p:nvPr/>
        </p:nvPicPr>
        <p:blipFill>
          <a:blip r:embed="rId27"/>
          <a:stretch/>
        </p:blipFill>
        <p:spPr>
          <a:xfrm>
            <a:off x="3867120" y="2722680"/>
            <a:ext cx="2644920" cy="1525320"/>
          </a:xfrm>
          <a:prstGeom prst="rect">
            <a:avLst/>
          </a:prstGeom>
          <a:ln w="0">
            <a:noFill/>
          </a:ln>
        </p:spPr>
      </p:pic>
      <p:sp>
        <p:nvSpPr>
          <p:cNvPr id="348" name="Straight Connector 28"/>
          <p:cNvSpPr/>
          <p:nvPr/>
        </p:nvSpPr>
        <p:spPr>
          <a:xfrm>
            <a:off x="4641840" y="7175520"/>
            <a:ext cx="5698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Straight Connector 148"/>
          <p:cNvSpPr/>
          <p:nvPr/>
        </p:nvSpPr>
        <p:spPr>
          <a:xfrm>
            <a:off x="4645080" y="7045200"/>
            <a:ext cx="11365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Straight Connector 151"/>
          <p:cNvSpPr/>
          <p:nvPr/>
        </p:nvSpPr>
        <p:spPr>
          <a:xfrm flipV="1">
            <a:off x="5208480" y="7171920"/>
            <a:ext cx="7920" cy="700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Straight Connector 154"/>
          <p:cNvSpPr/>
          <p:nvPr/>
        </p:nvSpPr>
        <p:spPr>
          <a:xfrm flipV="1">
            <a:off x="4637160" y="7171920"/>
            <a:ext cx="7920" cy="522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Straight Connector 157"/>
          <p:cNvSpPr/>
          <p:nvPr/>
        </p:nvSpPr>
        <p:spPr>
          <a:xfrm flipV="1">
            <a:off x="4645080" y="7043400"/>
            <a:ext cx="0" cy="95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Straight Connector 159"/>
          <p:cNvSpPr/>
          <p:nvPr/>
        </p:nvSpPr>
        <p:spPr>
          <a:xfrm flipV="1">
            <a:off x="5784840" y="7043400"/>
            <a:ext cx="0" cy="57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Straight Connector 126"/>
          <p:cNvSpPr/>
          <p:nvPr/>
        </p:nvSpPr>
        <p:spPr>
          <a:xfrm>
            <a:off x="1333440" y="731880"/>
            <a:ext cx="0" cy="33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Straight Connector 129"/>
          <p:cNvSpPr/>
          <p:nvPr/>
        </p:nvSpPr>
        <p:spPr>
          <a:xfrm>
            <a:off x="1333440" y="782640"/>
            <a:ext cx="0" cy="33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Straight Connector 127"/>
          <p:cNvSpPr/>
          <p:nvPr/>
        </p:nvSpPr>
        <p:spPr>
          <a:xfrm>
            <a:off x="1801800" y="828720"/>
            <a:ext cx="0" cy="33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Box 1"/>
          <p:cNvSpPr/>
          <p:nvPr/>
        </p:nvSpPr>
        <p:spPr>
          <a:xfrm rot="16200000">
            <a:off x="185400" y="1297080"/>
            <a:ext cx="11224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ell numbers (RFUs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Box 128"/>
          <p:cNvSpPr/>
          <p:nvPr/>
        </p:nvSpPr>
        <p:spPr>
          <a:xfrm rot="16200000">
            <a:off x="2607840" y="1317600"/>
            <a:ext cx="106200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ell numbers (RFUs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TextBox 57"/>
          <p:cNvSpPr/>
          <p:nvPr/>
        </p:nvSpPr>
        <p:spPr>
          <a:xfrm>
            <a:off x="54000" y="76320"/>
            <a:ext cx="212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0" name="Picture 2" descr="http://pcrdataanalysis.sabiosciences.com/pcr/image.php?image=plotoutput/4troq9e5r3vevdru6qbc2u57m3_clustergram.png&amp;number=1435338045"/>
          <p:cNvPicPr/>
          <p:nvPr/>
        </p:nvPicPr>
        <p:blipFill>
          <a:blip r:embed="rId1"/>
          <a:stretch/>
        </p:blipFill>
        <p:spPr>
          <a:xfrm>
            <a:off x="441360" y="353880"/>
            <a:ext cx="5830920" cy="5757840"/>
          </a:xfrm>
          <a:prstGeom prst="rect">
            <a:avLst/>
          </a:prstGeom>
          <a:ln w="0">
            <a:noFill/>
          </a:ln>
        </p:spPr>
      </p:pic>
      <p:sp>
        <p:nvSpPr>
          <p:cNvPr id="361" name="TextBox 11"/>
          <p:cNvSpPr/>
          <p:nvPr/>
        </p:nvSpPr>
        <p:spPr>
          <a:xfrm>
            <a:off x="2608200" y="289080"/>
            <a:ext cx="1244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nflammasom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62" name="Object 13"/>
          <p:cNvGraphicFramePr/>
          <p:nvPr/>
        </p:nvGraphicFramePr>
        <p:xfrm>
          <a:off x="4503600" y="6111720"/>
          <a:ext cx="2024280" cy="227808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363" name="Object 13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503600" y="6111720"/>
                    <a:ext cx="2024280" cy="2278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364" name="Group 1"/>
          <p:cNvGrpSpPr/>
          <p:nvPr/>
        </p:nvGrpSpPr>
        <p:grpSpPr>
          <a:xfrm>
            <a:off x="369720" y="6167520"/>
            <a:ext cx="4273560" cy="2273040"/>
            <a:chOff x="369720" y="6167520"/>
            <a:chExt cx="4273560" cy="2273040"/>
          </a:xfrm>
        </p:grpSpPr>
        <p:graphicFrame>
          <p:nvGraphicFramePr>
            <p:cNvPr id="365" name="Object 11"/>
            <p:cNvGraphicFramePr/>
            <p:nvPr/>
          </p:nvGraphicFramePr>
          <p:xfrm>
            <a:off x="369720" y="6167520"/>
            <a:ext cx="4273560" cy="2153160"/>
          </p:xfrm>
          <a:graphic>
            <a:graphicData uri="http://schemas.openxmlformats.org/presentationml/2006/ole">
              <p:oleObj r:id="rId4" spid="">
                <p:embed/>
                <p:pic>
                  <p:nvPicPr>
                    <p:cNvPr id="366" name="Object 11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369720" y="6167520"/>
                      <a:ext cx="4273560" cy="2153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67" name="Straight Connector 6"/>
            <p:cNvSpPr/>
            <p:nvPr/>
          </p:nvSpPr>
          <p:spPr>
            <a:xfrm>
              <a:off x="1117440" y="8209080"/>
              <a:ext cx="3335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TextBox 4"/>
            <p:cNvSpPr/>
            <p:nvPr/>
          </p:nvSpPr>
          <p:spPr>
            <a:xfrm>
              <a:off x="2277000" y="8194320"/>
              <a:ext cx="1079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 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9" name="Straight Connector 8"/>
          <p:cNvSpPr/>
          <p:nvPr/>
        </p:nvSpPr>
        <p:spPr>
          <a:xfrm>
            <a:off x="5295960" y="8194680"/>
            <a:ext cx="1017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Box 4"/>
          <p:cNvSpPr/>
          <p:nvPr/>
        </p:nvSpPr>
        <p:spPr>
          <a:xfrm>
            <a:off x="5299200" y="8161200"/>
            <a:ext cx="107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M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Box 176"/>
          <p:cNvSpPr/>
          <p:nvPr/>
        </p:nvSpPr>
        <p:spPr>
          <a:xfrm>
            <a:off x="323640" y="60292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Box 176"/>
          <p:cNvSpPr/>
          <p:nvPr/>
        </p:nvSpPr>
        <p:spPr>
          <a:xfrm>
            <a:off x="4335480" y="605484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TextBox 176"/>
          <p:cNvSpPr/>
          <p:nvPr/>
        </p:nvSpPr>
        <p:spPr>
          <a:xfrm>
            <a:off x="189000" y="28116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TextBox 57"/>
          <p:cNvSpPr/>
          <p:nvPr/>
        </p:nvSpPr>
        <p:spPr>
          <a:xfrm>
            <a:off x="0" y="101520"/>
            <a:ext cx="293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inue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5" name="Picture 2" descr="http://pcrdataanalysis.sabiosciences.com/pcr/image.php?image=plotoutput/b7r4v47igl0m5n6g2amj8adhb7_clustergram.png&amp;number=1435708227"/>
          <p:cNvPicPr/>
          <p:nvPr/>
        </p:nvPicPr>
        <p:blipFill>
          <a:blip r:embed="rId1"/>
          <a:stretch/>
        </p:blipFill>
        <p:spPr>
          <a:xfrm>
            <a:off x="669960" y="438120"/>
            <a:ext cx="5665680" cy="5526000"/>
          </a:xfrm>
          <a:prstGeom prst="rect">
            <a:avLst/>
          </a:prstGeom>
          <a:ln w="0">
            <a:noFill/>
          </a:ln>
        </p:spPr>
      </p:pic>
      <p:sp>
        <p:nvSpPr>
          <p:cNvPr id="376" name="TextBox 10"/>
          <p:cNvSpPr/>
          <p:nvPr/>
        </p:nvSpPr>
        <p:spPr>
          <a:xfrm>
            <a:off x="1791720" y="349200"/>
            <a:ext cx="2893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nflammatory Response &amp; Autoimmunit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Box 176"/>
          <p:cNvSpPr/>
          <p:nvPr/>
        </p:nvSpPr>
        <p:spPr>
          <a:xfrm>
            <a:off x="269640" y="37476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78" name="Object 2"/>
          <p:cNvGraphicFramePr/>
          <p:nvPr/>
        </p:nvGraphicFramePr>
        <p:xfrm>
          <a:off x="338040" y="5925960"/>
          <a:ext cx="4265640" cy="243396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379" name="Object 2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38040" y="5925960"/>
                    <a:ext cx="4265640" cy="2433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80" name="Object 3"/>
          <p:cNvGraphicFramePr/>
          <p:nvPr/>
        </p:nvGraphicFramePr>
        <p:xfrm>
          <a:off x="4521240" y="5986440"/>
          <a:ext cx="1960560" cy="23954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381" name="Object 3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4521240" y="5986440"/>
                    <a:ext cx="1960560" cy="239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82" name="Straight Connector 9"/>
          <p:cNvSpPr/>
          <p:nvPr/>
        </p:nvSpPr>
        <p:spPr>
          <a:xfrm>
            <a:off x="1274760" y="8429760"/>
            <a:ext cx="3108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Straight Connector 10"/>
          <p:cNvSpPr/>
          <p:nvPr/>
        </p:nvSpPr>
        <p:spPr>
          <a:xfrm>
            <a:off x="5407200" y="8381880"/>
            <a:ext cx="817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Box 4"/>
          <p:cNvSpPr/>
          <p:nvPr/>
        </p:nvSpPr>
        <p:spPr>
          <a:xfrm>
            <a:off x="2297160" y="841860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M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Box 176"/>
          <p:cNvSpPr/>
          <p:nvPr/>
        </p:nvSpPr>
        <p:spPr>
          <a:xfrm>
            <a:off x="266760" y="5867280"/>
            <a:ext cx="39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Box 176"/>
          <p:cNvSpPr/>
          <p:nvPr/>
        </p:nvSpPr>
        <p:spPr>
          <a:xfrm>
            <a:off x="4329000" y="5904000"/>
            <a:ext cx="34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Box 4"/>
          <p:cNvSpPr/>
          <p:nvPr/>
        </p:nvSpPr>
        <p:spPr>
          <a:xfrm>
            <a:off x="5349960" y="838836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M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8" name="Picture 2" descr="http://www.kegg.jp/tmp/mark_pathway147240146193275/mmu04060.png"/>
          <p:cNvPicPr/>
          <p:nvPr/>
        </p:nvPicPr>
        <p:blipFill>
          <a:blip r:embed="rId1"/>
          <a:stretch/>
        </p:blipFill>
        <p:spPr>
          <a:xfrm>
            <a:off x="297000" y="1143000"/>
            <a:ext cx="6476760" cy="4879800"/>
          </a:xfrm>
          <a:prstGeom prst="rect">
            <a:avLst/>
          </a:prstGeom>
          <a:ln w="0">
            <a:noFill/>
          </a:ln>
        </p:spPr>
      </p:pic>
      <p:sp>
        <p:nvSpPr>
          <p:cNvPr id="389" name="TextBox 57"/>
          <p:cNvSpPr/>
          <p:nvPr/>
        </p:nvSpPr>
        <p:spPr>
          <a:xfrm>
            <a:off x="128520" y="157320"/>
            <a:ext cx="293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inue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Box 176"/>
          <p:cNvSpPr/>
          <p:nvPr/>
        </p:nvSpPr>
        <p:spPr>
          <a:xfrm>
            <a:off x="128520" y="714240"/>
            <a:ext cx="34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TextBox 57"/>
          <p:cNvSpPr/>
          <p:nvPr/>
        </p:nvSpPr>
        <p:spPr>
          <a:xfrm>
            <a:off x="112680" y="123840"/>
            <a:ext cx="293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inue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Box 176"/>
          <p:cNvSpPr/>
          <p:nvPr/>
        </p:nvSpPr>
        <p:spPr>
          <a:xfrm>
            <a:off x="160200" y="433440"/>
            <a:ext cx="34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3" name="Picture 7" descr=""/>
          <p:cNvPicPr/>
          <p:nvPr/>
        </p:nvPicPr>
        <p:blipFill>
          <a:blip r:embed="rId1"/>
          <a:stretch/>
        </p:blipFill>
        <p:spPr>
          <a:xfrm>
            <a:off x="665280" y="324000"/>
            <a:ext cx="5916600" cy="4157640"/>
          </a:xfrm>
          <a:prstGeom prst="rect">
            <a:avLst/>
          </a:prstGeom>
          <a:ln w="0">
            <a:noFill/>
          </a:ln>
        </p:spPr>
      </p:pic>
      <p:sp>
        <p:nvSpPr>
          <p:cNvPr id="394" name="TextBox 176"/>
          <p:cNvSpPr/>
          <p:nvPr/>
        </p:nvSpPr>
        <p:spPr>
          <a:xfrm>
            <a:off x="228600" y="4572000"/>
            <a:ext cx="34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Oval 2"/>
          <p:cNvSpPr/>
          <p:nvPr/>
        </p:nvSpPr>
        <p:spPr>
          <a:xfrm>
            <a:off x="1238400" y="1800360"/>
            <a:ext cx="304560" cy="30456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6" name="Picture 6" descr=""/>
          <p:cNvPicPr/>
          <p:nvPr/>
        </p:nvPicPr>
        <p:blipFill>
          <a:blip r:embed="rId2"/>
          <a:stretch/>
        </p:blipFill>
        <p:spPr>
          <a:xfrm>
            <a:off x="665280" y="4481640"/>
            <a:ext cx="5527440" cy="4476600"/>
          </a:xfrm>
          <a:prstGeom prst="rect">
            <a:avLst/>
          </a:prstGeom>
          <a:ln w="0">
            <a:noFill/>
          </a:ln>
        </p:spPr>
      </p:pic>
      <p:sp>
        <p:nvSpPr>
          <p:cNvPr id="397" name="Oval 12"/>
          <p:cNvSpPr/>
          <p:nvPr/>
        </p:nvSpPr>
        <p:spPr>
          <a:xfrm>
            <a:off x="3352680" y="5791320"/>
            <a:ext cx="381240" cy="30456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TextBox 57"/>
          <p:cNvSpPr/>
          <p:nvPr/>
        </p:nvSpPr>
        <p:spPr>
          <a:xfrm>
            <a:off x="128520" y="225360"/>
            <a:ext cx="200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9" name="Chart 226" descr=""/>
          <p:cNvPicPr/>
          <p:nvPr/>
        </p:nvPicPr>
        <p:blipFill>
          <a:blip r:embed="rId1"/>
          <a:stretch/>
        </p:blipFill>
        <p:spPr>
          <a:xfrm>
            <a:off x="4237200" y="3292560"/>
            <a:ext cx="2627280" cy="1766880"/>
          </a:xfrm>
          <a:prstGeom prst="rect">
            <a:avLst/>
          </a:prstGeom>
          <a:ln w="0">
            <a:noFill/>
          </a:ln>
        </p:spPr>
      </p:pic>
      <p:pic>
        <p:nvPicPr>
          <p:cNvPr id="400" name="Chart 227" descr=""/>
          <p:cNvPicPr/>
          <p:nvPr/>
        </p:nvPicPr>
        <p:blipFill>
          <a:blip r:embed="rId2"/>
          <a:stretch/>
        </p:blipFill>
        <p:spPr>
          <a:xfrm>
            <a:off x="324000" y="3346560"/>
            <a:ext cx="2286000" cy="2023920"/>
          </a:xfrm>
          <a:prstGeom prst="rect">
            <a:avLst/>
          </a:prstGeom>
          <a:ln w="0">
            <a:noFill/>
          </a:ln>
        </p:spPr>
      </p:pic>
      <p:pic>
        <p:nvPicPr>
          <p:cNvPr id="401" name="Chart 228" descr=""/>
          <p:cNvPicPr/>
          <p:nvPr/>
        </p:nvPicPr>
        <p:blipFill>
          <a:blip r:embed="rId3"/>
          <a:stretch/>
        </p:blipFill>
        <p:spPr>
          <a:xfrm>
            <a:off x="2401920" y="3286080"/>
            <a:ext cx="2633760" cy="2067120"/>
          </a:xfrm>
          <a:prstGeom prst="rect">
            <a:avLst/>
          </a:prstGeom>
          <a:ln w="0">
            <a:noFill/>
          </a:ln>
        </p:spPr>
      </p:pic>
      <p:sp>
        <p:nvSpPr>
          <p:cNvPr id="402" name="TextBox 17"/>
          <p:cNvSpPr/>
          <p:nvPr/>
        </p:nvSpPr>
        <p:spPr>
          <a:xfrm>
            <a:off x="298800" y="329076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TextBox 17"/>
          <p:cNvSpPr/>
          <p:nvPr/>
        </p:nvSpPr>
        <p:spPr>
          <a:xfrm>
            <a:off x="2430000" y="32846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TextBox 17"/>
          <p:cNvSpPr/>
          <p:nvPr/>
        </p:nvSpPr>
        <p:spPr>
          <a:xfrm>
            <a:off x="4240440" y="326232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5" name="Group 46"/>
          <p:cNvGrpSpPr/>
          <p:nvPr/>
        </p:nvGrpSpPr>
        <p:grpSpPr>
          <a:xfrm>
            <a:off x="798480" y="5232240"/>
            <a:ext cx="2953080" cy="2019600"/>
            <a:chOff x="798480" y="5232240"/>
            <a:chExt cx="2953080" cy="2019600"/>
          </a:xfrm>
        </p:grpSpPr>
        <p:pic>
          <p:nvPicPr>
            <p:cNvPr id="406" name="Picture 3" descr=""/>
            <p:cNvPicPr/>
            <p:nvPr/>
          </p:nvPicPr>
          <p:blipFill>
            <a:blip r:embed="rId4"/>
            <a:stretch/>
          </p:blipFill>
          <p:spPr>
            <a:xfrm>
              <a:off x="1054440" y="6379200"/>
              <a:ext cx="1196280" cy="872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07" name="Picture 4" descr=""/>
            <p:cNvPicPr/>
            <p:nvPr/>
          </p:nvPicPr>
          <p:blipFill>
            <a:blip r:embed="rId5"/>
            <a:stretch/>
          </p:blipFill>
          <p:spPr>
            <a:xfrm>
              <a:off x="2293920" y="6379200"/>
              <a:ext cx="1195200" cy="872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08" name="TextBox 4"/>
            <p:cNvSpPr/>
            <p:nvPr/>
          </p:nvSpPr>
          <p:spPr>
            <a:xfrm>
              <a:off x="1321200" y="523512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Box 5"/>
            <p:cNvSpPr/>
            <p:nvPr/>
          </p:nvSpPr>
          <p:spPr>
            <a:xfrm>
              <a:off x="2586960" y="523224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B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Box 6"/>
            <p:cNvSpPr/>
            <p:nvPr/>
          </p:nvSpPr>
          <p:spPr>
            <a:xfrm rot="16200000">
              <a:off x="662040" y="6261840"/>
              <a:ext cx="54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4/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TextBox 7"/>
            <p:cNvSpPr/>
            <p:nvPr/>
          </p:nvSpPr>
          <p:spPr>
            <a:xfrm rot="16200000">
              <a:off x="3460320" y="6674040"/>
              <a:ext cx="30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K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TextBox 9"/>
            <p:cNvSpPr/>
            <p:nvPr/>
          </p:nvSpPr>
          <p:spPr>
            <a:xfrm rot="16200000">
              <a:off x="3412440" y="57722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13" name="Picture 5" descr=""/>
            <p:cNvPicPr/>
            <p:nvPr/>
          </p:nvPicPr>
          <p:blipFill>
            <a:blip r:embed="rId6"/>
            <a:stretch/>
          </p:blipFill>
          <p:spPr>
            <a:xfrm>
              <a:off x="1050840" y="5466600"/>
              <a:ext cx="1196280" cy="872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14" name="Picture 6" descr=""/>
            <p:cNvPicPr/>
            <p:nvPr/>
          </p:nvPicPr>
          <p:blipFill>
            <a:blip r:embed="rId7"/>
            <a:stretch/>
          </p:blipFill>
          <p:spPr>
            <a:xfrm rot="10800000">
              <a:off x="2295000" y="5466600"/>
              <a:ext cx="1196280" cy="872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grpSp>
        <p:nvGrpSpPr>
          <p:cNvPr id="415" name="Group 57"/>
          <p:cNvGrpSpPr/>
          <p:nvPr/>
        </p:nvGrpSpPr>
        <p:grpSpPr>
          <a:xfrm>
            <a:off x="3878280" y="5214960"/>
            <a:ext cx="2799000" cy="2095560"/>
            <a:chOff x="3878280" y="5214960"/>
            <a:chExt cx="2799000" cy="2095560"/>
          </a:xfrm>
        </p:grpSpPr>
        <p:sp>
          <p:nvSpPr>
            <p:cNvPr id="416" name="TextBox 8"/>
            <p:cNvSpPr/>
            <p:nvPr/>
          </p:nvSpPr>
          <p:spPr>
            <a:xfrm>
              <a:off x="4386600" y="522288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TextBox 9"/>
            <p:cNvSpPr/>
            <p:nvPr/>
          </p:nvSpPr>
          <p:spPr>
            <a:xfrm>
              <a:off x="5560200" y="521496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B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TextBox 11"/>
            <p:cNvSpPr/>
            <p:nvPr/>
          </p:nvSpPr>
          <p:spPr>
            <a:xfrm rot="16200000">
              <a:off x="6383160" y="6752520"/>
              <a:ext cx="30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K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TextBox 12"/>
            <p:cNvSpPr/>
            <p:nvPr/>
          </p:nvSpPr>
          <p:spPr>
            <a:xfrm rot="16200000">
              <a:off x="3710520" y="628236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C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TextBox 13"/>
            <p:cNvSpPr/>
            <p:nvPr/>
          </p:nvSpPr>
          <p:spPr>
            <a:xfrm rot="16200000">
              <a:off x="6341040" y="574992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21" name="Picture 8" descr=""/>
            <p:cNvPicPr/>
            <p:nvPr/>
          </p:nvPicPr>
          <p:blipFill>
            <a:blip r:embed="rId8"/>
            <a:stretch/>
          </p:blipFill>
          <p:spPr>
            <a:xfrm>
              <a:off x="4142880" y="5459040"/>
              <a:ext cx="1126800" cy="9043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22" name="Picture 9" descr=""/>
            <p:cNvPicPr/>
            <p:nvPr/>
          </p:nvPicPr>
          <p:blipFill>
            <a:blip r:embed="rId9"/>
            <a:stretch/>
          </p:blipFill>
          <p:spPr>
            <a:xfrm rot="10800000">
              <a:off x="5318280" y="5454720"/>
              <a:ext cx="1126800" cy="9043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23" name="Picture 10" descr=""/>
            <p:cNvPicPr/>
            <p:nvPr/>
          </p:nvPicPr>
          <p:blipFill>
            <a:blip r:embed="rId10"/>
            <a:stretch/>
          </p:blipFill>
          <p:spPr>
            <a:xfrm>
              <a:off x="5316840" y="6399360"/>
              <a:ext cx="1125720" cy="9043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24" name="Picture 11" descr=""/>
            <p:cNvPicPr/>
            <p:nvPr/>
          </p:nvPicPr>
          <p:blipFill>
            <a:blip r:embed="rId11"/>
            <a:stretch/>
          </p:blipFill>
          <p:spPr>
            <a:xfrm>
              <a:off x="4142880" y="6405120"/>
              <a:ext cx="1126800" cy="905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sp>
        <p:nvSpPr>
          <p:cNvPr id="425" name="TextBox 17"/>
          <p:cNvSpPr/>
          <p:nvPr/>
        </p:nvSpPr>
        <p:spPr>
          <a:xfrm>
            <a:off x="612360" y="517860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TextBox 17"/>
          <p:cNvSpPr/>
          <p:nvPr/>
        </p:nvSpPr>
        <p:spPr>
          <a:xfrm>
            <a:off x="3779640" y="52322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TextBox 19"/>
          <p:cNvSpPr/>
          <p:nvPr/>
        </p:nvSpPr>
        <p:spPr>
          <a:xfrm>
            <a:off x="280800" y="17636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8" name="Group 8"/>
          <p:cNvGrpSpPr/>
          <p:nvPr/>
        </p:nvGrpSpPr>
        <p:grpSpPr>
          <a:xfrm>
            <a:off x="743040" y="1776960"/>
            <a:ext cx="2306520" cy="1414080"/>
            <a:chOff x="743040" y="1776960"/>
            <a:chExt cx="2306520" cy="1414080"/>
          </a:xfrm>
        </p:grpSpPr>
        <p:sp>
          <p:nvSpPr>
            <p:cNvPr id="429" name="TextBox 99"/>
            <p:cNvSpPr/>
            <p:nvPr/>
          </p:nvSpPr>
          <p:spPr>
            <a:xfrm>
              <a:off x="2589480" y="2860560"/>
              <a:ext cx="397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0" name="Group 6"/>
            <p:cNvGrpSpPr/>
            <p:nvPr/>
          </p:nvGrpSpPr>
          <p:grpSpPr>
            <a:xfrm>
              <a:off x="743040" y="1776960"/>
              <a:ext cx="2306520" cy="1414080"/>
              <a:chOff x="743040" y="1776960"/>
              <a:chExt cx="2306520" cy="1414080"/>
            </a:xfrm>
          </p:grpSpPr>
          <p:sp>
            <p:nvSpPr>
              <p:cNvPr id="431" name="TextBox 98"/>
              <p:cNvSpPr/>
              <p:nvPr/>
            </p:nvSpPr>
            <p:spPr>
              <a:xfrm>
                <a:off x="2589480" y="2678400"/>
                <a:ext cx="460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TextBox 108"/>
              <p:cNvSpPr/>
              <p:nvPr/>
            </p:nvSpPr>
            <p:spPr>
              <a:xfrm rot="18959400">
                <a:off x="778320" y="2054160"/>
                <a:ext cx="922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eterozygou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/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TextBox 111"/>
              <p:cNvSpPr/>
              <p:nvPr/>
            </p:nvSpPr>
            <p:spPr>
              <a:xfrm>
                <a:off x="1719720" y="2331000"/>
                <a:ext cx="405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w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34" name="Straight Arrow Connector 60"/>
              <p:cNvCxnSpPr/>
              <p:nvPr/>
            </p:nvCxnSpPr>
            <p:spPr>
              <a:xfrm flipH="1" flipV="1">
                <a:off x="2504520" y="2771640"/>
                <a:ext cx="16884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</p:cxnSp>
          <p:pic>
            <p:nvPicPr>
              <p:cNvPr id="435" name="Picture 97" descr=""/>
              <p:cNvPicPr/>
              <p:nvPr/>
            </p:nvPicPr>
            <p:blipFill>
              <a:blip r:embed="rId12">
                <a:lum bright="-20000"/>
              </a:blip>
              <a:srcRect l="27603" t="30210" r="39691" b="57969"/>
              <a:stretch/>
            </p:blipFill>
            <p:spPr>
              <a:xfrm>
                <a:off x="743040" y="2504880"/>
                <a:ext cx="1755000" cy="686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36" name="TextBox 108"/>
              <p:cNvSpPr/>
              <p:nvPr/>
            </p:nvSpPr>
            <p:spPr>
              <a:xfrm rot="18959400">
                <a:off x="1321560" y="2104200"/>
                <a:ext cx="711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nock-in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 /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TextBox 108"/>
              <p:cNvSpPr/>
              <p:nvPr/>
            </p:nvSpPr>
            <p:spPr>
              <a:xfrm rot="18959400">
                <a:off x="2044080" y="2109600"/>
                <a:ext cx="724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Wild 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/L1</a:t>
                </a:r>
                <a:r>
                  <a:rPr b="0" lang="el-G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438" name="Picture 1" descr=""/>
          <p:cNvPicPr/>
          <p:nvPr/>
        </p:nvPicPr>
        <p:blipFill>
          <a:blip r:embed="rId13"/>
          <a:stretch/>
        </p:blipFill>
        <p:spPr>
          <a:xfrm>
            <a:off x="1606680" y="549360"/>
            <a:ext cx="3644640" cy="1338120"/>
          </a:xfrm>
          <a:prstGeom prst="rect">
            <a:avLst/>
          </a:prstGeom>
          <a:ln w="0">
            <a:noFill/>
          </a:ln>
        </p:spPr>
      </p:pic>
      <p:sp>
        <p:nvSpPr>
          <p:cNvPr id="439" name="TextBox 19"/>
          <p:cNvSpPr/>
          <p:nvPr/>
        </p:nvSpPr>
        <p:spPr>
          <a:xfrm>
            <a:off x="1283040" y="50472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0" name="Straight Arrow Connector 66"/>
          <p:cNvCxnSpPr/>
          <p:nvPr/>
        </p:nvCxnSpPr>
        <p:spPr>
          <a:xfrm flipH="1" flipV="1">
            <a:off x="2509560" y="2953440"/>
            <a:ext cx="14184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441" name="Group 4"/>
          <p:cNvGrpSpPr/>
          <p:nvPr/>
        </p:nvGrpSpPr>
        <p:grpSpPr>
          <a:xfrm>
            <a:off x="781200" y="7272360"/>
            <a:ext cx="2823840" cy="1773360"/>
            <a:chOff x="781200" y="7272360"/>
            <a:chExt cx="2823840" cy="1773360"/>
          </a:xfrm>
        </p:grpSpPr>
        <p:graphicFrame>
          <p:nvGraphicFramePr>
            <p:cNvPr id="442" name="Object 7"/>
            <p:cNvGraphicFramePr/>
            <p:nvPr/>
          </p:nvGraphicFramePr>
          <p:xfrm>
            <a:off x="915840" y="7275240"/>
            <a:ext cx="2609640" cy="1478160"/>
          </p:xfrm>
          <a:graphic>
            <a:graphicData uri="http://schemas.openxmlformats.org/presentationml/2006/ole">
              <p:oleObj r:id="rId14" spid="">
                <p:embed/>
                <p:pic>
                  <p:nvPicPr>
                    <p:cNvPr id="443" name="Object 7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915840" y="7275240"/>
                      <a:ext cx="2609640" cy="1478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4" name="Rectangle 78"/>
            <p:cNvSpPr/>
            <p:nvPr/>
          </p:nvSpPr>
          <p:spPr>
            <a:xfrm rot="16200000">
              <a:off x="385560" y="7878600"/>
              <a:ext cx="103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4/80 Positiv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TextBox 5"/>
            <p:cNvSpPr/>
            <p:nvPr/>
          </p:nvSpPr>
          <p:spPr>
            <a:xfrm>
              <a:off x="1428840" y="86076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TextBox 76"/>
            <p:cNvSpPr/>
            <p:nvPr/>
          </p:nvSpPr>
          <p:spPr>
            <a:xfrm>
              <a:off x="2011320" y="8604360"/>
              <a:ext cx="67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TextBox 5"/>
            <p:cNvSpPr/>
            <p:nvPr/>
          </p:nvSpPr>
          <p:spPr>
            <a:xfrm>
              <a:off x="2392200" y="8607600"/>
              <a:ext cx="6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TextBox 76"/>
            <p:cNvSpPr/>
            <p:nvPr/>
          </p:nvSpPr>
          <p:spPr>
            <a:xfrm>
              <a:off x="2932200" y="8604360"/>
              <a:ext cx="67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Straight Connector 52"/>
            <p:cNvSpPr/>
            <p:nvPr/>
          </p:nvSpPr>
          <p:spPr>
            <a:xfrm>
              <a:off x="1658880" y="8853840"/>
              <a:ext cx="641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TextBox 2"/>
            <p:cNvSpPr/>
            <p:nvPr/>
          </p:nvSpPr>
          <p:spPr>
            <a:xfrm>
              <a:off x="1755720" y="87994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Straight Connector 54"/>
            <p:cNvSpPr/>
            <p:nvPr/>
          </p:nvSpPr>
          <p:spPr>
            <a:xfrm>
              <a:off x="2638440" y="8853840"/>
              <a:ext cx="641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TextBox 2"/>
            <p:cNvSpPr/>
            <p:nvPr/>
          </p:nvSpPr>
          <p:spPr>
            <a:xfrm>
              <a:off x="2811600" y="8799480"/>
              <a:ext cx="37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TextBox 15"/>
            <p:cNvSpPr/>
            <p:nvPr/>
          </p:nvSpPr>
          <p:spPr>
            <a:xfrm>
              <a:off x="1848240" y="805032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Straight Connector 57"/>
            <p:cNvSpPr/>
            <p:nvPr/>
          </p:nvSpPr>
          <p:spPr>
            <a:xfrm>
              <a:off x="1735200" y="8240760"/>
              <a:ext cx="525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15"/>
            <p:cNvSpPr/>
            <p:nvPr/>
          </p:nvSpPr>
          <p:spPr>
            <a:xfrm>
              <a:off x="2790360" y="727236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Straight Connector 59"/>
            <p:cNvSpPr/>
            <p:nvPr/>
          </p:nvSpPr>
          <p:spPr>
            <a:xfrm>
              <a:off x="2684520" y="7483320"/>
              <a:ext cx="525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Straight Connector 61"/>
            <p:cNvSpPr/>
            <p:nvPr/>
          </p:nvSpPr>
          <p:spPr>
            <a:xfrm>
              <a:off x="1725480" y="7659720"/>
              <a:ext cx="1004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TextBox 84"/>
            <p:cNvSpPr/>
            <p:nvPr/>
          </p:nvSpPr>
          <p:spPr>
            <a:xfrm>
              <a:off x="2085840" y="7495920"/>
              <a:ext cx="37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9" name="Group 3"/>
          <p:cNvGrpSpPr/>
          <p:nvPr/>
        </p:nvGrpSpPr>
        <p:grpSpPr>
          <a:xfrm>
            <a:off x="3879720" y="7391520"/>
            <a:ext cx="2819520" cy="1726920"/>
            <a:chOff x="3879720" y="7391520"/>
            <a:chExt cx="2819520" cy="1726920"/>
          </a:xfrm>
        </p:grpSpPr>
        <p:graphicFrame>
          <p:nvGraphicFramePr>
            <p:cNvPr id="460" name="Object 6"/>
            <p:cNvGraphicFramePr/>
            <p:nvPr/>
          </p:nvGraphicFramePr>
          <p:xfrm>
            <a:off x="4089240" y="7391520"/>
            <a:ext cx="2464200" cy="1424880"/>
          </p:xfrm>
          <a:graphic>
            <a:graphicData uri="http://schemas.openxmlformats.org/presentationml/2006/ole">
              <p:oleObj r:id="rId16" spid="">
                <p:embed/>
                <p:pic>
                  <p:nvPicPr>
                    <p:cNvPr id="461" name="Object 6" descr=""/>
                    <p:cNvPicPr/>
                    <p:nvPr/>
                  </p:nvPicPr>
                  <p:blipFill>
                    <a:blip r:embed="rId17"/>
                    <a:stretch/>
                  </p:blipFill>
                  <p:spPr>
                    <a:xfrm>
                      <a:off x="4089240" y="7391520"/>
                      <a:ext cx="2464200" cy="1424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2" name="Rectangle 78"/>
            <p:cNvSpPr/>
            <p:nvPr/>
          </p:nvSpPr>
          <p:spPr>
            <a:xfrm rot="16200000">
              <a:off x="3449160" y="7960680"/>
              <a:ext cx="110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C-2 Positiv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TextBox 5"/>
            <p:cNvSpPr/>
            <p:nvPr/>
          </p:nvSpPr>
          <p:spPr>
            <a:xfrm>
              <a:off x="4503600" y="8679960"/>
              <a:ext cx="64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TextBox 76"/>
            <p:cNvSpPr/>
            <p:nvPr/>
          </p:nvSpPr>
          <p:spPr>
            <a:xfrm>
              <a:off x="5105160" y="8676720"/>
              <a:ext cx="67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TextBox 5"/>
            <p:cNvSpPr/>
            <p:nvPr/>
          </p:nvSpPr>
          <p:spPr>
            <a:xfrm>
              <a:off x="5457960" y="867996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TextBox 76"/>
            <p:cNvSpPr/>
            <p:nvPr/>
          </p:nvSpPr>
          <p:spPr>
            <a:xfrm>
              <a:off x="6026040" y="8676720"/>
              <a:ext cx="67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Straight Connector 71"/>
            <p:cNvSpPr/>
            <p:nvPr/>
          </p:nvSpPr>
          <p:spPr>
            <a:xfrm>
              <a:off x="4754520" y="8921880"/>
              <a:ext cx="639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TextBox 2"/>
            <p:cNvSpPr/>
            <p:nvPr/>
          </p:nvSpPr>
          <p:spPr>
            <a:xfrm>
              <a:off x="4849560" y="88722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Straight Connector 73"/>
            <p:cNvSpPr/>
            <p:nvPr/>
          </p:nvSpPr>
          <p:spPr>
            <a:xfrm>
              <a:off x="5734080" y="8926560"/>
              <a:ext cx="639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TextBox 2"/>
            <p:cNvSpPr/>
            <p:nvPr/>
          </p:nvSpPr>
          <p:spPr>
            <a:xfrm>
              <a:off x="5905440" y="8872200"/>
              <a:ext cx="37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TextBox 15"/>
            <p:cNvSpPr/>
            <p:nvPr/>
          </p:nvSpPr>
          <p:spPr>
            <a:xfrm>
              <a:off x="4900680" y="804132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Straight Connector 76"/>
            <p:cNvSpPr/>
            <p:nvPr/>
          </p:nvSpPr>
          <p:spPr>
            <a:xfrm>
              <a:off x="4787640" y="8231040"/>
              <a:ext cx="525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TextBox 15"/>
            <p:cNvSpPr/>
            <p:nvPr/>
          </p:nvSpPr>
          <p:spPr>
            <a:xfrm>
              <a:off x="5837400" y="751860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Straight Connector 78"/>
            <p:cNvSpPr/>
            <p:nvPr/>
          </p:nvSpPr>
          <p:spPr>
            <a:xfrm>
              <a:off x="5737320" y="7708680"/>
              <a:ext cx="525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Straight Connector 79"/>
            <p:cNvSpPr/>
            <p:nvPr/>
          </p:nvSpPr>
          <p:spPr>
            <a:xfrm>
              <a:off x="4790880" y="7872480"/>
              <a:ext cx="1004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TextBox 84"/>
            <p:cNvSpPr/>
            <p:nvPr/>
          </p:nvSpPr>
          <p:spPr>
            <a:xfrm>
              <a:off x="5151240" y="7709040"/>
              <a:ext cx="37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77" name="Picture 97" descr=""/>
          <p:cNvPicPr/>
          <p:nvPr/>
        </p:nvPicPr>
        <p:blipFill>
          <a:blip r:embed="rId18">
            <a:lum bright="-20000"/>
          </a:blip>
          <a:srcRect l="-802" t="12266" r="1371" b="42795"/>
          <a:stretch/>
        </p:blipFill>
        <p:spPr>
          <a:xfrm>
            <a:off x="3133800" y="1911240"/>
            <a:ext cx="2879640" cy="1405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04T23:23:55Z</dcterms:created>
  <dc:creator>Khan, Imran (NIH/NIDCR) [F]</dc:creator>
  <dc:description/>
  <dc:language>en-US</dc:language>
  <cp:lastModifiedBy>Praveen Arany</cp:lastModifiedBy>
  <cp:lastPrinted>2021-01-02T20:37:44Z</cp:lastPrinted>
  <dcterms:modified xsi:type="dcterms:W3CDTF">2021-05-31T14:46:06Z</dcterms:modified>
  <cp:revision>1536</cp:revision>
  <dc:subject/>
  <dc:title>PowerPoint Presentation</dc:title>
</cp:coreProperties>
</file>